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  <Override PartName="/ppt/charts/style5.xml" ContentType="application/vnd.ms-office.chartstyle+xml"/>
  <Override PartName="/ppt/charts/colors5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  <Override PartName="/ppt/charts/style7.xml" ContentType="application/vnd.ms-office.chartstyle+xml"/>
  <Override PartName="/ppt/charts/colors7.xml" ContentType="application/vnd.ms-office.chartcolorstyle+xml"/>
  <Override PartName="/ppt/charts/style8.xml" ContentType="application/vnd.ms-office.chartstyle+xml"/>
  <Override PartName="/ppt/charts/colors8.xml" ContentType="application/vnd.ms-office.chartcolorstyle+xml"/>
  <Override PartName="/ppt/charts/style9.xml" ContentType="application/vnd.ms-office.chartstyle+xml"/>
  <Override PartName="/ppt/charts/colors9.xml" ContentType="application/vnd.ms-office.chartcolorstyle+xml"/>
  <Override PartName="/ppt/charts/style10.xml" ContentType="application/vnd.ms-office.chartstyle+xml"/>
  <Override PartName="/ppt/charts/colors10.xml" ContentType="application/vnd.ms-office.chartcolorstyle+xml"/>
  <Override PartName="/ppt/charts/style11.xml" ContentType="application/vnd.ms-office.chartstyle+xml"/>
  <Override PartName="/ppt/charts/colors11.xml" ContentType="application/vnd.ms-office.chartcolorstyle+xml"/>
  <Override PartName="/ppt/charts/style12.xml" ContentType="application/vnd.ms-office.chartstyle+xml"/>
  <Override PartName="/ppt/charts/colors12.xml" ContentType="application/vnd.ms-office.chartcolorstyle+xml"/>
  <Override PartName="/ppt/charts/style13.xml" ContentType="application/vnd.ms-office.chartstyle+xml"/>
  <Override PartName="/ppt/charts/colors13.xml" ContentType="application/vnd.ms-office.chartcolorstyle+xml"/>
  <Override PartName="/ppt/charts/style14.xml" ContentType="application/vnd.ms-office.chartstyle+xml"/>
  <Override PartName="/ppt/charts/colors14.xml" ContentType="application/vnd.ms-office.chartcolorstyle+xml"/>
  <Override PartName="/ppt/charts/style15.xml" ContentType="application/vnd.ms-office.chartstyle+xml"/>
  <Override PartName="/ppt/charts/colors15.xml" ContentType="application/vnd.ms-office.chartcolorstyle+xml"/>
  <Override PartName="/ppt/charts/style16.xml" ContentType="application/vnd.ms-office.chartstyle+xml"/>
  <Override PartName="/ppt/charts/colors16.xml" ContentType="application/vnd.ms-office.chartcolorstyle+xml"/>
  <Override PartName="/ppt/charts/style17.xml" ContentType="application/vnd.ms-office.chartstyle+xml"/>
  <Override PartName="/ppt/charts/colors17.xml" ContentType="application/vnd.ms-office.chartcolorstyle+xml"/>
  <Override PartName="/ppt/charts/style18.xml" ContentType="application/vnd.ms-office.chartstyle+xml"/>
  <Override PartName="/ppt/charts/colors18.xml" ContentType="application/vnd.ms-office.chartcolorstyle+xml"/>
  <Override PartName="/ppt/charts/style19.xml" ContentType="application/vnd.ms-office.chartstyle+xml"/>
  <Override PartName="/ppt/charts/colors19.xml" ContentType="application/vnd.ms-office.chartcolorstyle+xml"/>
  <Override PartName="/ppt/charts/style20.xml" ContentType="application/vnd.ms-office.chartstyle+xml"/>
  <Override PartName="/ppt/charts/colors20.xml" ContentType="application/vnd.ms-office.chartcolorstyle+xml"/>
  <Override PartName="/ppt/charts/style21.xml" ContentType="application/vnd.ms-office.chartstyle+xml"/>
  <Override PartName="/ppt/charts/colors21.xml" ContentType="application/vnd.ms-office.chartcolorstyle+xml"/>
  <Override PartName="/ppt/charts/style22.xml" ContentType="application/vnd.ms-office.chartstyle+xml"/>
  <Override PartName="/ppt/charts/colors22.xml" ContentType="application/vnd.ms-office.chartcolorstyle+xml"/>
  <Override PartName="/ppt/charts/style23.xml" ContentType="application/vnd.ms-office.chartstyle+xml"/>
  <Override PartName="/ppt/charts/colors23.xml" ContentType="application/vnd.ms-office.chartcolorstyle+xml"/>
  <Override PartName="/ppt/charts/style24.xml" ContentType="application/vnd.ms-office.chartstyle+xml"/>
  <Override PartName="/ppt/charts/colors24.xml" ContentType="application/vnd.ms-office.chartcolorstyle+xml"/>
  <Override PartName="/ppt/charts/style25.xml" ContentType="application/vnd.ms-office.chartstyle+xml"/>
  <Override PartName="/ppt/charts/colors25.xml" ContentType="application/vnd.ms-office.chartcolorstyle+xml"/>
  <Override PartName="/ppt/charts/style26.xml" ContentType="application/vnd.ms-office.chartstyle+xml"/>
  <Override PartName="/ppt/charts/colors26.xml" ContentType="application/vnd.ms-office.chartcolorstyle+xml"/>
  <Override PartName="/ppt/charts/style27.xml" ContentType="application/vnd.ms-office.chartstyle+xml"/>
  <Override PartName="/ppt/charts/colors27.xml" ContentType="application/vnd.ms-office.chartcolorstyle+xml"/>
  <Override PartName="/ppt/charts/style28.xml" ContentType="application/vnd.ms-office.chartstyle+xml"/>
  <Override PartName="/ppt/charts/colors28.xml" ContentType="application/vnd.ms-office.chartcolorstyle+xml"/>
  <Override PartName="/ppt/charts/style29.xml" ContentType="application/vnd.ms-office.chartstyle+xml"/>
  <Override PartName="/ppt/charts/colors29.xml" ContentType="application/vnd.ms-office.chartcolorstyle+xml"/>
  <Override PartName="/ppt/charts/style30.xml" ContentType="application/vnd.ms-office.chartstyle+xml"/>
  <Override PartName="/ppt/charts/colors30.xml" ContentType="application/vnd.ms-office.chartcolorstyle+xml"/>
  <Override PartName="/ppt/charts/style31.xml" ContentType="application/vnd.ms-office.chartstyle+xml"/>
  <Override PartName="/ppt/charts/colors31.xml" ContentType="application/vnd.ms-office.chartcolorstyle+xml"/>
  <Override PartName="/ppt/charts/style32.xml" ContentType="application/vnd.ms-office.chartstyle+xml"/>
  <Override PartName="/ppt/charts/colors32.xml" ContentType="application/vnd.ms-office.chartcolorstyle+xml"/>
  <Override PartName="/ppt/charts/style33.xml" ContentType="application/vnd.ms-office.chartstyle+xml"/>
  <Override PartName="/ppt/charts/colors33.xml" ContentType="application/vnd.ms-office.chartcolorstyle+xml"/>
  <Override PartName="/ppt/charts/style34.xml" ContentType="application/vnd.ms-office.chartstyle+xml"/>
  <Override PartName="/ppt/charts/colors34.xml" ContentType="application/vnd.ms-office.chartcolorstyle+xml"/>
  <Override PartName="/ppt/charts/style35.xml" ContentType="application/vnd.ms-office.chartstyle+xml"/>
  <Override PartName="/ppt/charts/colors35.xml" ContentType="application/vnd.ms-office.chartcolorstyle+xml"/>
  <Override PartName="/ppt/charts/style36.xml" ContentType="application/vnd.ms-office.chartstyle+xml"/>
  <Override PartName="/ppt/charts/colors36.xml" ContentType="application/vnd.ms-office.chartcolorstyle+xml"/>
  <Override PartName="/ppt/charts/style37.xml" ContentType="application/vnd.ms-office.chartstyle+xml"/>
  <Override PartName="/ppt/charts/colors37.xml" ContentType="application/vnd.ms-office.chartcolorstyle+xml"/>
  <Override PartName="/ppt/charts/style38.xml" ContentType="application/vnd.ms-office.chartstyle+xml"/>
  <Override PartName="/ppt/charts/colors38.xml" ContentType="application/vnd.ms-office.chartcolorstyle+xml"/>
  <Override PartName="/ppt/charts/style39.xml" ContentType="application/vnd.ms-office.chartstyle+xml"/>
  <Override PartName="/ppt/charts/colors39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69" r:id="rId4"/>
    <p:sldId id="259" r:id="rId5"/>
    <p:sldId id="260" r:id="rId6"/>
    <p:sldId id="261" r:id="rId7"/>
    <p:sldId id="266" r:id="rId8"/>
    <p:sldId id="267" r:id="rId9"/>
    <p:sldId id="262" r:id="rId10"/>
    <p:sldId id="263" r:id="rId11"/>
    <p:sldId id="264" r:id="rId12"/>
    <p:sldId id="265" r:id="rId13"/>
    <p:sldId id="268" r:id="rId1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997" autoAdjust="0"/>
    <p:restoredTop sz="94660"/>
  </p:normalViewPr>
  <p:slideViewPr>
    <p:cSldViewPr snapToGrid="0">
      <p:cViewPr>
        <p:scale>
          <a:sx n="69" d="100"/>
          <a:sy n="69" d="100"/>
        </p:scale>
        <p:origin x="-2562" y="-4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E:\Masterarbeit%20ireact\excel_Tabellen\RSD_Methode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microsoft.com/office/2011/relationships/chartStyle" Target="style10.xml"/><Relationship Id="rId2" Type="http://schemas.microsoft.com/office/2011/relationships/chartColorStyle" Target="colors10.xml"/><Relationship Id="rId1" Type="http://schemas.openxmlformats.org/officeDocument/2006/relationships/oleObject" Target="file:///E:\Masterarbeit%20ireact\excel_Tabellen\RSD_Methode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microsoft.com/office/2011/relationships/chartStyle" Target="style11.xml"/><Relationship Id="rId2" Type="http://schemas.microsoft.com/office/2011/relationships/chartColorStyle" Target="colors11.xml"/><Relationship Id="rId1" Type="http://schemas.openxmlformats.org/officeDocument/2006/relationships/oleObject" Target="file:///E:\Masterarbeit%20ireact\excel_Tabellen\RSD_Methode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microsoft.com/office/2011/relationships/chartStyle" Target="style12.xml"/><Relationship Id="rId2" Type="http://schemas.microsoft.com/office/2011/relationships/chartColorStyle" Target="colors12.xml"/><Relationship Id="rId1" Type="http://schemas.openxmlformats.org/officeDocument/2006/relationships/oleObject" Target="file:///E:\Masterarbeit%20ireact\excel_Tabellen\RSD_Methode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microsoft.com/office/2011/relationships/chartStyle" Target="style13.xml"/><Relationship Id="rId2" Type="http://schemas.microsoft.com/office/2011/relationships/chartColorStyle" Target="colors13.xml"/><Relationship Id="rId1" Type="http://schemas.openxmlformats.org/officeDocument/2006/relationships/oleObject" Target="file:///C:\Users\Caro.DESKTOP-311OP73\Desktop\RNASeq-Daten%20indi-miR-iReAct%20akut%20April%202022-mod220531.xlsm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microsoft.com/office/2011/relationships/chartStyle" Target="style14.xml"/><Relationship Id="rId2" Type="http://schemas.microsoft.com/office/2011/relationships/chartColorStyle" Target="colors14.xml"/><Relationship Id="rId1" Type="http://schemas.openxmlformats.org/officeDocument/2006/relationships/oleObject" Target="file:///E:\Masterarbeit%20ireact\excel_Tabellen\RSD_Methode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microsoft.com/office/2011/relationships/chartStyle" Target="style15.xml"/><Relationship Id="rId2" Type="http://schemas.microsoft.com/office/2011/relationships/chartColorStyle" Target="colors15.xml"/><Relationship Id="rId1" Type="http://schemas.openxmlformats.org/officeDocument/2006/relationships/oleObject" Target="file:///E:\Masterarbeit%20ireact\excel_Tabellen\RSD_Methode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microsoft.com/office/2011/relationships/chartStyle" Target="style16.xml"/><Relationship Id="rId2" Type="http://schemas.microsoft.com/office/2011/relationships/chartColorStyle" Target="colors16.xml"/><Relationship Id="rId1" Type="http://schemas.openxmlformats.org/officeDocument/2006/relationships/oleObject" Target="file:///E:\Masterarbeit%20ireact\excel_Tabellen\RSD_Methode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microsoft.com/office/2011/relationships/chartStyle" Target="style17.xml"/><Relationship Id="rId2" Type="http://schemas.microsoft.com/office/2011/relationships/chartColorStyle" Target="colors17.xml"/><Relationship Id="rId1" Type="http://schemas.openxmlformats.org/officeDocument/2006/relationships/oleObject" Target="file:///E:\Masterarbeit%20ireact\excel_Tabellen\RSD_Methode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microsoft.com/office/2011/relationships/chartStyle" Target="style18.xml"/><Relationship Id="rId2" Type="http://schemas.microsoft.com/office/2011/relationships/chartColorStyle" Target="colors18.xml"/><Relationship Id="rId1" Type="http://schemas.openxmlformats.org/officeDocument/2006/relationships/oleObject" Target="file:///E:\Masterarbeit%20ireact\excel_Tabellen\RSD_Methode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microsoft.com/office/2011/relationships/chartStyle" Target="style19.xml"/><Relationship Id="rId2" Type="http://schemas.microsoft.com/office/2011/relationships/chartColorStyle" Target="colors19.xml"/><Relationship Id="rId1" Type="http://schemas.openxmlformats.org/officeDocument/2006/relationships/oleObject" Target="file:///E:\Masterarbeit%20ireact\excel_Tabellen\lof(fc)_methode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E:\Masterarbeit%20ireact\excel_Tabellen\RSD_Methode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microsoft.com/office/2011/relationships/chartStyle" Target="style20.xml"/><Relationship Id="rId2" Type="http://schemas.microsoft.com/office/2011/relationships/chartColorStyle" Target="colors20.xml"/><Relationship Id="rId1" Type="http://schemas.openxmlformats.org/officeDocument/2006/relationships/oleObject" Target="file:///E:\Masterarbeit%20ireact\excel_Tabellen\lof(fc)_methode.xlsx" TargetMode="External"/></Relationships>
</file>

<file path=ppt/charts/_rels/chart21.xml.rels><?xml version="1.0" encoding="UTF-8" standalone="yes"?>
<Relationships xmlns="http://schemas.openxmlformats.org/package/2006/relationships"><Relationship Id="rId3" Type="http://schemas.microsoft.com/office/2011/relationships/chartStyle" Target="style21.xml"/><Relationship Id="rId2" Type="http://schemas.microsoft.com/office/2011/relationships/chartColorStyle" Target="colors21.xml"/><Relationship Id="rId1" Type="http://schemas.openxmlformats.org/officeDocument/2006/relationships/oleObject" Target="file:///E:\Masterarbeit%20ireact\excel_Tabellen\lof(fc)_methode.xlsx" TargetMode="External"/></Relationships>
</file>

<file path=ppt/charts/_rels/chart22.xml.rels><?xml version="1.0" encoding="UTF-8" standalone="yes"?>
<Relationships xmlns="http://schemas.openxmlformats.org/package/2006/relationships"><Relationship Id="rId3" Type="http://schemas.microsoft.com/office/2011/relationships/chartStyle" Target="style22.xml"/><Relationship Id="rId2" Type="http://schemas.microsoft.com/office/2011/relationships/chartColorStyle" Target="colors22.xml"/><Relationship Id="rId1" Type="http://schemas.openxmlformats.org/officeDocument/2006/relationships/oleObject" Target="file:///E:\Masterarbeit%20ireact\excel_Tabellen\lof(fc)_methode.xlsx" TargetMode="External"/></Relationships>
</file>

<file path=ppt/charts/_rels/chart23.xml.rels><?xml version="1.0" encoding="UTF-8" standalone="yes"?>
<Relationships xmlns="http://schemas.openxmlformats.org/package/2006/relationships"><Relationship Id="rId3" Type="http://schemas.microsoft.com/office/2011/relationships/chartStyle" Target="style23.xml"/><Relationship Id="rId2" Type="http://schemas.microsoft.com/office/2011/relationships/chartColorStyle" Target="colors23.xml"/><Relationship Id="rId1" Type="http://schemas.openxmlformats.org/officeDocument/2006/relationships/oleObject" Target="file:///E:\Masterarbeit%20ireact\excel_Tabellen\lof(fc)_methode.xlsx" TargetMode="External"/></Relationships>
</file>

<file path=ppt/charts/_rels/chart24.xml.rels><?xml version="1.0" encoding="UTF-8" standalone="yes"?>
<Relationships xmlns="http://schemas.openxmlformats.org/package/2006/relationships"><Relationship Id="rId3" Type="http://schemas.microsoft.com/office/2011/relationships/chartStyle" Target="style24.xml"/><Relationship Id="rId2" Type="http://schemas.microsoft.com/office/2011/relationships/chartColorStyle" Target="colors24.xml"/><Relationship Id="rId1" Type="http://schemas.openxmlformats.org/officeDocument/2006/relationships/oleObject" Target="file:///E:\Masterarbeit%20ireact\excel_Tabellen\lof(fc)_methode.xlsx" TargetMode="External"/></Relationships>
</file>

<file path=ppt/charts/_rels/chart25.xml.rels><?xml version="1.0" encoding="UTF-8" standalone="yes"?>
<Relationships xmlns="http://schemas.openxmlformats.org/package/2006/relationships"><Relationship Id="rId3" Type="http://schemas.microsoft.com/office/2011/relationships/chartStyle" Target="style25.xml"/><Relationship Id="rId2" Type="http://schemas.microsoft.com/office/2011/relationships/chartColorStyle" Target="colors25.xml"/><Relationship Id="rId1" Type="http://schemas.openxmlformats.org/officeDocument/2006/relationships/oleObject" Target="file:///E:\Masterarbeit%20ireact\excel_Tabellen\RSD_Methode.xlsx" TargetMode="External"/></Relationships>
</file>

<file path=ppt/charts/_rels/chart26.xml.rels><?xml version="1.0" encoding="UTF-8" standalone="yes"?>
<Relationships xmlns="http://schemas.openxmlformats.org/package/2006/relationships"><Relationship Id="rId3" Type="http://schemas.microsoft.com/office/2011/relationships/chartStyle" Target="style26.xml"/><Relationship Id="rId2" Type="http://schemas.microsoft.com/office/2011/relationships/chartColorStyle" Target="colors26.xml"/><Relationship Id="rId1" Type="http://schemas.openxmlformats.org/officeDocument/2006/relationships/oleObject" Target="file:///E:\Masterarbeit%20ireact\excel_Tabellen\RSD_Methode.xlsx" TargetMode="External"/></Relationships>
</file>

<file path=ppt/charts/_rels/chart27.xml.rels><?xml version="1.0" encoding="UTF-8" standalone="yes"?>
<Relationships xmlns="http://schemas.openxmlformats.org/package/2006/relationships"><Relationship Id="rId3" Type="http://schemas.microsoft.com/office/2011/relationships/chartStyle" Target="style27.xml"/><Relationship Id="rId2" Type="http://schemas.microsoft.com/office/2011/relationships/chartColorStyle" Target="colors27.xml"/><Relationship Id="rId1" Type="http://schemas.openxmlformats.org/officeDocument/2006/relationships/oleObject" Target="file:///E:\Masterarbeit%20ireact\excel_Tabellen\RSD_Methode.xlsx" TargetMode="External"/></Relationships>
</file>

<file path=ppt/charts/_rels/chart28.xml.rels><?xml version="1.0" encoding="UTF-8" standalone="yes"?>
<Relationships xmlns="http://schemas.openxmlformats.org/package/2006/relationships"><Relationship Id="rId3" Type="http://schemas.microsoft.com/office/2011/relationships/chartStyle" Target="style28.xml"/><Relationship Id="rId2" Type="http://schemas.microsoft.com/office/2011/relationships/chartColorStyle" Target="colors28.xml"/><Relationship Id="rId1" Type="http://schemas.openxmlformats.org/officeDocument/2006/relationships/oleObject" Target="file:///E:\Masterarbeit%20ireact\excel_Tabellen\RSD_Methode.xlsx" TargetMode="External"/></Relationships>
</file>

<file path=ppt/charts/_rels/chart29.xml.rels><?xml version="1.0" encoding="UTF-8" standalone="yes"?>
<Relationships xmlns="http://schemas.openxmlformats.org/package/2006/relationships"><Relationship Id="rId3" Type="http://schemas.microsoft.com/office/2011/relationships/chartStyle" Target="style29.xml"/><Relationship Id="rId2" Type="http://schemas.microsoft.com/office/2011/relationships/chartColorStyle" Target="colors29.xml"/><Relationship Id="rId1" Type="http://schemas.openxmlformats.org/officeDocument/2006/relationships/oleObject" Target="file:///E:\Masterarbeit%20ireact\excel_Tabellen\RSD_Methode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E:\Masterarbeit%20ireact\excel_Tabellen\RSD_Methode.xlsx" TargetMode="External"/></Relationships>
</file>

<file path=ppt/charts/_rels/chart30.xml.rels><?xml version="1.0" encoding="UTF-8" standalone="yes"?>
<Relationships xmlns="http://schemas.openxmlformats.org/package/2006/relationships"><Relationship Id="rId3" Type="http://schemas.microsoft.com/office/2011/relationships/chartStyle" Target="style30.xml"/><Relationship Id="rId2" Type="http://schemas.microsoft.com/office/2011/relationships/chartColorStyle" Target="colors30.xml"/><Relationship Id="rId1" Type="http://schemas.openxmlformats.org/officeDocument/2006/relationships/oleObject" Target="file:///E:\Masterarbeit%20ireact\excel_Tabellen\RSD_Methode.xlsx" TargetMode="External"/></Relationships>
</file>

<file path=ppt/charts/_rels/chart31.xml.rels><?xml version="1.0" encoding="UTF-8" standalone="yes"?>
<Relationships xmlns="http://schemas.openxmlformats.org/package/2006/relationships"><Relationship Id="rId3" Type="http://schemas.microsoft.com/office/2011/relationships/chartStyle" Target="style31.xml"/><Relationship Id="rId2" Type="http://schemas.microsoft.com/office/2011/relationships/chartColorStyle" Target="colors31.xml"/><Relationship Id="rId1" Type="http://schemas.openxmlformats.org/officeDocument/2006/relationships/oleObject" Target="file:///E:\Masterarbeit%20ireact\excel_Tabellen\RSD_Methode.xlsx" TargetMode="External"/></Relationships>
</file>

<file path=ppt/charts/_rels/chart32.xml.rels><?xml version="1.0" encoding="UTF-8" standalone="yes"?>
<Relationships xmlns="http://schemas.openxmlformats.org/package/2006/relationships"><Relationship Id="rId3" Type="http://schemas.microsoft.com/office/2011/relationships/chartStyle" Target="style32.xml"/><Relationship Id="rId2" Type="http://schemas.microsoft.com/office/2011/relationships/chartColorStyle" Target="colors32.xml"/><Relationship Id="rId1" Type="http://schemas.openxmlformats.org/officeDocument/2006/relationships/oleObject" Target="file:///E:\Masterarbeit%20ireact\excel_Tabellen\RSD_Methode.xlsx" TargetMode="External"/></Relationships>
</file>

<file path=ppt/charts/_rels/chart33.xml.rels><?xml version="1.0" encoding="UTF-8" standalone="yes"?>
<Relationships xmlns="http://schemas.openxmlformats.org/package/2006/relationships"><Relationship Id="rId3" Type="http://schemas.microsoft.com/office/2011/relationships/chartStyle" Target="style33.xml"/><Relationship Id="rId2" Type="http://schemas.microsoft.com/office/2011/relationships/chartColorStyle" Target="colors33.xml"/><Relationship Id="rId1" Type="http://schemas.openxmlformats.org/officeDocument/2006/relationships/oleObject" Target="file:///E:\Masterarbeit%20ireact\excel_Tabellen\RSD_Methode.xlsx" TargetMode="External"/></Relationships>
</file>

<file path=ppt/charts/_rels/chart34.xml.rels><?xml version="1.0" encoding="UTF-8" standalone="yes"?>
<Relationships xmlns="http://schemas.openxmlformats.org/package/2006/relationships"><Relationship Id="rId3" Type="http://schemas.microsoft.com/office/2011/relationships/chartStyle" Target="style34.xml"/><Relationship Id="rId2" Type="http://schemas.microsoft.com/office/2011/relationships/chartColorStyle" Target="colors34.xml"/><Relationship Id="rId1" Type="http://schemas.openxmlformats.org/officeDocument/2006/relationships/oleObject" Target="file:///C:\Users\Caro.DESKTOP-311OP73\Desktop\RNASeq-Daten%20indi-miR-iReAct%20akut%20April%202022-mod220531.xlsm" TargetMode="External"/></Relationships>
</file>

<file path=ppt/charts/_rels/chart35.xml.rels><?xml version="1.0" encoding="UTF-8" standalone="yes"?>
<Relationships xmlns="http://schemas.openxmlformats.org/package/2006/relationships"><Relationship Id="rId3" Type="http://schemas.microsoft.com/office/2011/relationships/chartStyle" Target="style35.xml"/><Relationship Id="rId2" Type="http://schemas.microsoft.com/office/2011/relationships/chartColorStyle" Target="colors35.xml"/><Relationship Id="rId1" Type="http://schemas.openxmlformats.org/officeDocument/2006/relationships/oleObject" Target="file:///E:\Masterarbeit%20ireact\excel_Tabellen\RSD_Methode.xlsx" TargetMode="External"/></Relationships>
</file>

<file path=ppt/charts/_rels/chart36.xml.rels><?xml version="1.0" encoding="UTF-8" standalone="yes"?>
<Relationships xmlns="http://schemas.openxmlformats.org/package/2006/relationships"><Relationship Id="rId3" Type="http://schemas.microsoft.com/office/2011/relationships/chartStyle" Target="style36.xml"/><Relationship Id="rId2" Type="http://schemas.microsoft.com/office/2011/relationships/chartColorStyle" Target="colors36.xml"/><Relationship Id="rId1" Type="http://schemas.openxmlformats.org/officeDocument/2006/relationships/oleObject" Target="file:///E:\Masterarbeit%20ireact\excel_Tabellen\RSD_Methode.xlsx" TargetMode="External"/></Relationships>
</file>

<file path=ppt/charts/_rels/chart37.xml.rels><?xml version="1.0" encoding="UTF-8" standalone="yes"?>
<Relationships xmlns="http://schemas.openxmlformats.org/package/2006/relationships"><Relationship Id="rId3" Type="http://schemas.microsoft.com/office/2011/relationships/chartStyle" Target="style37.xml"/><Relationship Id="rId2" Type="http://schemas.microsoft.com/office/2011/relationships/chartColorStyle" Target="colors37.xml"/><Relationship Id="rId1" Type="http://schemas.openxmlformats.org/officeDocument/2006/relationships/oleObject" Target="file:///E:\Masterarbeit%20ireact\excel_Tabellen\lof(fc)_methode.xlsx" TargetMode="External"/></Relationships>
</file>

<file path=ppt/charts/_rels/chart38.xml.rels><?xml version="1.0" encoding="UTF-8" standalone="yes"?>
<Relationships xmlns="http://schemas.openxmlformats.org/package/2006/relationships"><Relationship Id="rId3" Type="http://schemas.microsoft.com/office/2011/relationships/chartStyle" Target="style38.xml"/><Relationship Id="rId2" Type="http://schemas.microsoft.com/office/2011/relationships/chartColorStyle" Target="colors38.xml"/><Relationship Id="rId1" Type="http://schemas.openxmlformats.org/officeDocument/2006/relationships/oleObject" Target="file:///E:\Masterarbeit%20ireact\excel_Tabellen\lof(fc)_methode.xlsx" TargetMode="External"/></Relationships>
</file>

<file path=ppt/charts/_rels/chart39.xml.rels><?xml version="1.0" encoding="UTF-8" standalone="yes"?>
<Relationships xmlns="http://schemas.openxmlformats.org/package/2006/relationships"><Relationship Id="rId3" Type="http://schemas.microsoft.com/office/2011/relationships/chartStyle" Target="style39.xml"/><Relationship Id="rId2" Type="http://schemas.microsoft.com/office/2011/relationships/chartColorStyle" Target="colors39.xml"/><Relationship Id="rId1" Type="http://schemas.openxmlformats.org/officeDocument/2006/relationships/oleObject" Target="file:///E:\Masterarbeit%20ireact\excel_Tabellen\lof(fc)_methode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E:\Masterarbeit%20ireact\excel_Tabellen\RSD_Methode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E:\Masterarbeit%20ireact\excel_Tabellen\RSD_Methode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E:\Masterarbeit%20ireact\excel_Tabellen\RSD_Methode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E:\Masterarbeit%20ireact\excel_Tabellen\lof(fc)_methode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E:\Masterarbeit%20ireact\excel_Tabellen\lof(fc)_methode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Style" Target="style9.xml"/><Relationship Id="rId2" Type="http://schemas.microsoft.com/office/2011/relationships/chartColorStyle" Target="colors9.xml"/><Relationship Id="rId1" Type="http://schemas.openxmlformats.org/officeDocument/2006/relationships/oleObject" Target="file:///E:\Masterarbeit%20ireact\excel_Tabellen\lof(fc)_method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1677'!$D$17</c:f>
          <c:strCache>
            <c:ptCount val="1"/>
            <c:pt idx="0">
              <c:v>hsa-piR-1677</c:v>
            </c:pt>
          </c:strCache>
        </c:strRef>
      </c:tx>
      <c:layout>
        <c:manualLayout>
          <c:xMode val="edge"/>
          <c:yMode val="edge"/>
          <c:x val="0.36459375769719915"/>
          <c:y val="3.90408453316473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528308711638481"/>
          <c:y val="0.15748011324919228"/>
          <c:w val="0.82013737326309144"/>
          <c:h val="0.52377597727638359"/>
        </c:manualLayout>
      </c:layout>
      <c:lineChart>
        <c:grouping val="standard"/>
        <c:varyColors val="0"/>
        <c:ser>
          <c:idx val="0"/>
          <c:order val="0"/>
          <c:tx>
            <c:strRef>
              <c:f>'1677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3:$F$3</c:f>
              <c:numCache>
                <c:formatCode>General</c:formatCode>
                <c:ptCount val="3"/>
                <c:pt idx="0">
                  <c:v>1.311828958493076</c:v>
                </c:pt>
                <c:pt idx="1">
                  <c:v>3.0602494256294359</c:v>
                </c:pt>
                <c:pt idx="2">
                  <c:v>3.0515715593530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C82-440A-AC33-FFC65F8E651F}"/>
            </c:ext>
          </c:extLst>
        </c:ser>
        <c:ser>
          <c:idx val="1"/>
          <c:order val="1"/>
          <c:tx>
            <c:strRef>
              <c:f>'1677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4:$F$4</c:f>
              <c:numCache>
                <c:formatCode>General</c:formatCode>
                <c:ptCount val="3"/>
                <c:pt idx="0">
                  <c:v>3.9808653074223241</c:v>
                </c:pt>
                <c:pt idx="1">
                  <c:v>2.5281232645487171</c:v>
                </c:pt>
                <c:pt idx="2">
                  <c:v>1.157568180765847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C82-440A-AC33-FFC65F8E651F}"/>
            </c:ext>
          </c:extLst>
        </c:ser>
        <c:ser>
          <c:idx val="2"/>
          <c:order val="2"/>
          <c:tx>
            <c:strRef>
              <c:f>'1677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5:$F$5</c:f>
              <c:numCache>
                <c:formatCode>General</c:formatCode>
                <c:ptCount val="3"/>
                <c:pt idx="0">
                  <c:v>4.1461002817275148</c:v>
                </c:pt>
                <c:pt idx="1">
                  <c:v>4.2752734571785043</c:v>
                </c:pt>
                <c:pt idx="2">
                  <c:v>3.670890025641167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C82-440A-AC33-FFC65F8E651F}"/>
            </c:ext>
          </c:extLst>
        </c:ser>
        <c:ser>
          <c:idx val="3"/>
          <c:order val="3"/>
          <c:tx>
            <c:strRef>
              <c:f>'1677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6:$F$6</c:f>
              <c:numCache>
                <c:formatCode>General</c:formatCode>
                <c:ptCount val="3"/>
                <c:pt idx="0">
                  <c:v>0</c:v>
                </c:pt>
                <c:pt idx="1">
                  <c:v>2.094482086941952</c:v>
                </c:pt>
                <c:pt idx="2">
                  <c:v>2.463803644704731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C82-440A-AC33-FFC65F8E651F}"/>
            </c:ext>
          </c:extLst>
        </c:ser>
        <c:ser>
          <c:idx val="4"/>
          <c:order val="4"/>
          <c:tx>
            <c:strRef>
              <c:f>'1677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7</c:f>
              <c:numCache>
                <c:formatCode>General</c:formatCode>
                <c:ptCount val="1"/>
                <c:pt idx="0">
                  <c:v>1.4543793908622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DC82-440A-AC33-FFC65F8E651F}"/>
            </c:ext>
          </c:extLst>
        </c:ser>
        <c:ser>
          <c:idx val="5"/>
          <c:order val="5"/>
          <c:tx>
            <c:strRef>
              <c:f>'1677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8:$F$8</c:f>
              <c:numCache>
                <c:formatCode>General</c:formatCode>
                <c:ptCount val="3"/>
                <c:pt idx="0">
                  <c:v>1.8660255832107451</c:v>
                </c:pt>
                <c:pt idx="1">
                  <c:v>3.684557650431278</c:v>
                </c:pt>
                <c:pt idx="2">
                  <c:v>2.860907811823217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DC82-440A-AC33-FFC65F8E651F}"/>
            </c:ext>
          </c:extLst>
        </c:ser>
        <c:ser>
          <c:idx val="6"/>
          <c:order val="6"/>
          <c:tx>
            <c:strRef>
              <c:f>'1677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9:$F$9</c:f>
              <c:numCache>
                <c:formatCode>General</c:formatCode>
                <c:ptCount val="3"/>
                <c:pt idx="0">
                  <c:v>2.7234079637895681</c:v>
                </c:pt>
                <c:pt idx="1">
                  <c:v>0.62797148255903412</c:v>
                </c:pt>
                <c:pt idx="2">
                  <c:v>3.51797111569815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DC82-440A-AC33-FFC65F8E651F}"/>
            </c:ext>
          </c:extLst>
        </c:ser>
        <c:ser>
          <c:idx val="7"/>
          <c:order val="7"/>
          <c:tx>
            <c:strRef>
              <c:f>'1677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10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DC82-440A-AC33-FFC65F8E65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3481472"/>
        <c:axId val="203483776"/>
      </c:lineChart>
      <c:catAx>
        <c:axId val="2034814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867113080861355"/>
              <c:y val="0.7610705389173698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483776"/>
        <c:crosses val="autoZero"/>
        <c:auto val="1"/>
        <c:lblAlgn val="ctr"/>
        <c:lblOffset val="100"/>
        <c:noMultiLvlLbl val="0"/>
      </c:catAx>
      <c:valAx>
        <c:axId val="203483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481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8894811622024699E-2"/>
          <c:y val="0.81490233128155409"/>
          <c:w val="0.95531230803370792"/>
          <c:h val="0.18509766871844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25111'!$D$17</c:f>
          <c:strCache>
            <c:ptCount val="1"/>
            <c:pt idx="0">
              <c:v>hsa-piR-2511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5592706024281486"/>
          <c:y val="0.19741457969078943"/>
          <c:w val="0.79795613359258999"/>
          <c:h val="0.55277479011301023"/>
        </c:manualLayout>
      </c:layout>
      <c:lineChart>
        <c:grouping val="standard"/>
        <c:varyColors val="0"/>
        <c:ser>
          <c:idx val="0"/>
          <c:order val="0"/>
          <c:tx>
            <c:strRef>
              <c:f>'2511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3,'25111'!$F$3)</c:f>
              <c:numCache>
                <c:formatCode>General</c:formatCode>
                <c:ptCount val="2"/>
                <c:pt idx="0">
                  <c:v>1.9677434377396139</c:v>
                </c:pt>
                <c:pt idx="1">
                  <c:v>2.034381039568711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FC3-4C65-9A57-8C98218D063D}"/>
            </c:ext>
          </c:extLst>
        </c:ser>
        <c:ser>
          <c:idx val="1"/>
          <c:order val="1"/>
          <c:tx>
            <c:strRef>
              <c:f>'2511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4,'25111'!$F$4)</c:f>
              <c:numCache>
                <c:formatCode>General</c:formatCode>
                <c:ptCount val="2"/>
                <c:pt idx="0">
                  <c:v>0</c:v>
                </c:pt>
                <c:pt idx="1">
                  <c:v>2.3151363615316942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1-AFC3-4C65-9A57-8C98218D063D}"/>
            </c:ext>
          </c:extLst>
        </c:ser>
        <c:ser>
          <c:idx val="2"/>
          <c:order val="2"/>
          <c:tx>
            <c:strRef>
              <c:f>'2511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5,'25111'!$F$5)</c:f>
              <c:numCache>
                <c:formatCode>General</c:formatCode>
                <c:ptCount val="2"/>
                <c:pt idx="0">
                  <c:v>0.69101671362125239</c:v>
                </c:pt>
                <c:pt idx="1">
                  <c:v>2.7531675192308751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FC3-4C65-9A57-8C98218D063D}"/>
            </c:ext>
          </c:extLst>
        </c:ser>
        <c:ser>
          <c:idx val="3"/>
          <c:order val="3"/>
          <c:tx>
            <c:strRef>
              <c:f>'2511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6,'25111'!$F$6)</c:f>
              <c:numCache>
                <c:formatCode>General</c:formatCode>
                <c:ptCount val="2"/>
                <c:pt idx="0">
                  <c:v>0</c:v>
                </c:pt>
                <c:pt idx="1">
                  <c:v>2.463803644704731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FC3-4C65-9A57-8C98218D063D}"/>
            </c:ext>
          </c:extLst>
        </c:ser>
        <c:ser>
          <c:idx val="5"/>
          <c:order val="4"/>
          <c:tx>
            <c:strRef>
              <c:f>'2511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8,'25111'!$F$8)</c:f>
              <c:numCache>
                <c:formatCode>General</c:formatCode>
                <c:ptCount val="2"/>
                <c:pt idx="0">
                  <c:v>0.62200852773691517</c:v>
                </c:pt>
                <c:pt idx="1">
                  <c:v>0.5721815623646432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FC3-4C65-9A57-8C98218D063D}"/>
            </c:ext>
          </c:extLst>
        </c:ser>
        <c:ser>
          <c:idx val="6"/>
          <c:order val="5"/>
          <c:tx>
            <c:strRef>
              <c:f>'2511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25111'!$D$2,'2511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25111'!$D$9,'25111'!$F$9)</c:f>
              <c:numCache>
                <c:formatCode>General</c:formatCode>
                <c:ptCount val="2"/>
                <c:pt idx="0">
                  <c:v>1.6340447782737411</c:v>
                </c:pt>
                <c:pt idx="1">
                  <c:v>2.638478336773616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AFC3-4C65-9A57-8C98218D06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593088"/>
        <c:axId val="211612032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25111'!$C$7</c15:sqref>
                        </c15:formulaRef>
                      </c:ext>
                    </c:extLst>
                    <c:strCache>
                      <c:ptCount val="1"/>
                      <c:pt idx="0">
                        <c:v>normalized_IR0015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('25111'!$D$2,'25111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25111'!$D$7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2.1815690862934201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AFC3-4C65-9A57-8C98218D063D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5111'!$C$10</c15:sqref>
                        </c15:formulaRef>
                      </c:ext>
                    </c:extLst>
                    <c:strCache>
                      <c:ptCount val="1"/>
                      <c:pt idx="0">
                        <c:v>normalized_IR0046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25111'!$D$2,'25111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25111'!$D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0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AFC3-4C65-9A57-8C98218D063D}"/>
                  </c:ext>
                </c:extLst>
              </c15:ser>
            </c15:filteredLineSeries>
          </c:ext>
        </c:extLst>
      </c:lineChart>
      <c:catAx>
        <c:axId val="2115930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888308201233557"/>
              <c:y val="0.7696213113667759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612032"/>
        <c:crosses val="autoZero"/>
        <c:auto val="1"/>
        <c:lblAlgn val="ctr"/>
        <c:lblOffset val="100"/>
        <c:noMultiLvlLbl val="0"/>
      </c:catAx>
      <c:valAx>
        <c:axId val="211612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593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9642457890511266E-3"/>
          <c:y val="0.82464458116904649"/>
          <c:w val="0.98007132451465762"/>
          <c:h val="0.175355418830953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25111'!$D$17</c:f>
          <c:strCache>
            <c:ptCount val="1"/>
            <c:pt idx="0">
              <c:v>hsa-piR-2511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6727974602263257"/>
          <c:y val="0.17655032032063622"/>
          <c:w val="0.78451810444443137"/>
          <c:h val="0.46072258865360138"/>
        </c:manualLayout>
      </c:layout>
      <c:lineChart>
        <c:grouping val="standard"/>
        <c:varyColors val="0"/>
        <c:ser>
          <c:idx val="0"/>
          <c:order val="0"/>
          <c:tx>
            <c:strRef>
              <c:f>'2511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3:$F$3</c:f>
              <c:numCache>
                <c:formatCode>General</c:formatCode>
                <c:ptCount val="3"/>
                <c:pt idx="0">
                  <c:v>1.9677434377396139</c:v>
                </c:pt>
                <c:pt idx="1">
                  <c:v>2.2951870692220768</c:v>
                </c:pt>
                <c:pt idx="2">
                  <c:v>2.034381039568711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6FE-4B9D-BCCB-003822CB1A27}"/>
            </c:ext>
          </c:extLst>
        </c:ser>
        <c:ser>
          <c:idx val="1"/>
          <c:order val="1"/>
          <c:tx>
            <c:strRef>
              <c:f>'2511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4:$F$4</c:f>
              <c:numCache>
                <c:formatCode>General</c:formatCode>
                <c:ptCount val="3"/>
                <c:pt idx="0">
                  <c:v>0</c:v>
                </c:pt>
                <c:pt idx="1">
                  <c:v>0.84270775484957239</c:v>
                </c:pt>
                <c:pt idx="2">
                  <c:v>2.31513636153169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6FE-4B9D-BCCB-003822CB1A27}"/>
            </c:ext>
          </c:extLst>
        </c:ser>
        <c:ser>
          <c:idx val="2"/>
          <c:order val="2"/>
          <c:tx>
            <c:strRef>
              <c:f>'2511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5:$F$5</c:f>
              <c:numCache>
                <c:formatCode>General</c:formatCode>
                <c:ptCount val="3"/>
                <c:pt idx="0">
                  <c:v>0.69101671362125239</c:v>
                </c:pt>
                <c:pt idx="1">
                  <c:v>2.1376367285892521</c:v>
                </c:pt>
                <c:pt idx="2">
                  <c:v>2.753167519230875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6FE-4B9D-BCCB-003822CB1A27}"/>
            </c:ext>
          </c:extLst>
        </c:ser>
        <c:ser>
          <c:idx val="3"/>
          <c:order val="3"/>
          <c:tx>
            <c:strRef>
              <c:f>'2511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6:$F$6</c:f>
              <c:numCache>
                <c:formatCode>General</c:formatCode>
                <c:ptCount val="3"/>
                <c:pt idx="0">
                  <c:v>0</c:v>
                </c:pt>
                <c:pt idx="1">
                  <c:v>1.047241043470976</c:v>
                </c:pt>
                <c:pt idx="2">
                  <c:v>2.463803644704731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6FE-4B9D-BCCB-003822CB1A27}"/>
            </c:ext>
          </c:extLst>
        </c:ser>
        <c:ser>
          <c:idx val="4"/>
          <c:order val="4"/>
          <c:tx>
            <c:strRef>
              <c:f>'2511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7</c:f>
              <c:numCache>
                <c:formatCode>General</c:formatCode>
                <c:ptCount val="1"/>
                <c:pt idx="0">
                  <c:v>2.18156908629342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F6FE-4B9D-BCCB-003822CB1A27}"/>
            </c:ext>
          </c:extLst>
        </c:ser>
        <c:ser>
          <c:idx val="5"/>
          <c:order val="5"/>
          <c:tx>
            <c:strRef>
              <c:f>'2511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8:$F$8</c:f>
              <c:numCache>
                <c:formatCode>General</c:formatCode>
                <c:ptCount val="3"/>
                <c:pt idx="0">
                  <c:v>0.62200852773691517</c:v>
                </c:pt>
                <c:pt idx="1">
                  <c:v>1.228185883477092</c:v>
                </c:pt>
                <c:pt idx="2">
                  <c:v>0.572181562364643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F6FE-4B9D-BCCB-003822CB1A27}"/>
            </c:ext>
          </c:extLst>
        </c:ser>
        <c:ser>
          <c:idx val="6"/>
          <c:order val="6"/>
          <c:tx>
            <c:strRef>
              <c:f>'2511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9:$F$9</c:f>
              <c:numCache>
                <c:formatCode>General</c:formatCode>
                <c:ptCount val="3"/>
                <c:pt idx="0">
                  <c:v>1.6340447782737411</c:v>
                </c:pt>
                <c:pt idx="1">
                  <c:v>0</c:v>
                </c:pt>
                <c:pt idx="2">
                  <c:v>2.638478336773616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F6FE-4B9D-BCCB-003822CB1A27}"/>
            </c:ext>
          </c:extLst>
        </c:ser>
        <c:ser>
          <c:idx val="7"/>
          <c:order val="7"/>
          <c:tx>
            <c:strRef>
              <c:f>'2511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10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F6FE-4B9D-BCCB-003822CB1A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666432"/>
        <c:axId val="211681280"/>
      </c:lineChart>
      <c:catAx>
        <c:axId val="2116664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681280"/>
        <c:crosses val="autoZero"/>
        <c:auto val="1"/>
        <c:lblAlgn val="ctr"/>
        <c:lblOffset val="100"/>
        <c:noMultiLvlLbl val="0"/>
      </c:catAx>
      <c:valAx>
        <c:axId val="2116812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666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3186717623412973E-2"/>
          <c:y val="0.79403942061256882"/>
          <c:w val="0.92545250139830493"/>
          <c:h val="0.2013470089358310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</a:t>
            </a:r>
            <a:r>
              <a:rPr lang="en-US" sz="1100" baseline="0" dirty="0"/>
              <a:t> </a:t>
            </a:r>
            <a:r>
              <a:rPr lang="en-US" sz="1100" dirty="0"/>
              <a:t>normalized</a:t>
            </a:r>
          </a:p>
        </c:rich>
      </c:tx>
      <c:layout>
        <c:manualLayout>
          <c:xMode val="edge"/>
          <c:yMode val="edge"/>
          <c:x val="0.30738147484470041"/>
          <c:y val="5.407280763047198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5111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5111'!$D$14:$F$14</c:f>
                <c:numCache>
                  <c:formatCode>General</c:formatCode>
                  <c:ptCount val="3"/>
                  <c:pt idx="0">
                    <c:v>0.91580786418872495</c:v>
                  </c:pt>
                  <c:pt idx="1">
                    <c:v>0.85438354387957127</c:v>
                  </c:pt>
                  <c:pt idx="2">
                    <c:v>0.8035581169514735</c:v>
                  </c:pt>
                </c:numCache>
              </c:numRef>
            </c:plus>
            <c:minus>
              <c:numRef>
                <c:f>'25111'!$D$14:$F$14</c:f>
                <c:numCache>
                  <c:formatCode>General</c:formatCode>
                  <c:ptCount val="3"/>
                  <c:pt idx="0">
                    <c:v>0.91580786418872495</c:v>
                  </c:pt>
                  <c:pt idx="1">
                    <c:v>0.85438354387957127</c:v>
                  </c:pt>
                  <c:pt idx="2">
                    <c:v>0.80355811695147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511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25111'!$D$12:$F$12</c:f>
              <c:numCache>
                <c:formatCode>General</c:formatCode>
                <c:ptCount val="3"/>
                <c:pt idx="0">
                  <c:v>0.88704781795811771</c:v>
                </c:pt>
                <c:pt idx="1">
                  <c:v>1.2584930799348282</c:v>
                </c:pt>
                <c:pt idx="2">
                  <c:v>2.1295247440290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4B5-467A-BFC7-75BDA5E9A9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416000"/>
        <c:axId val="212417536"/>
      </c:barChart>
      <c:catAx>
        <c:axId val="212416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417536"/>
        <c:crosses val="autoZero"/>
        <c:auto val="1"/>
        <c:lblAlgn val="ctr"/>
        <c:lblOffset val="100"/>
        <c:noMultiLvlLbl val="0"/>
      </c:catAx>
      <c:valAx>
        <c:axId val="212417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416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835'!$D$17</c:f>
          <c:strCache>
            <c:ptCount val="1"/>
            <c:pt idx="0">
              <c:v>hsa-piR-32835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6339891820091834"/>
          <c:y val="0.14329896336748865"/>
          <c:w val="0.77982898123136069"/>
          <c:h val="0.56089631209947888"/>
        </c:manualLayout>
      </c:layout>
      <c:lineChart>
        <c:grouping val="standard"/>
        <c:varyColors val="0"/>
        <c:ser>
          <c:idx val="0"/>
          <c:order val="0"/>
          <c:tx>
            <c:strRef>
              <c:f>'hsa-piR-32835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3,'hsa-piR-32835'!$F$3)</c:f>
              <c:numCache>
                <c:formatCode>General</c:formatCode>
                <c:ptCount val="2"/>
                <c:pt idx="0">
                  <c:v>97.075342928487601</c:v>
                </c:pt>
                <c:pt idx="1">
                  <c:v>76.289288983826665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312-4AD2-B378-A2D924270DF6}"/>
            </c:ext>
          </c:extLst>
        </c:ser>
        <c:ser>
          <c:idx val="1"/>
          <c:order val="1"/>
          <c:tx>
            <c:strRef>
              <c:f>'hsa-piR-32835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4,'hsa-piR-32835'!$F$4)</c:f>
              <c:numCache>
                <c:formatCode>General</c:formatCode>
                <c:ptCount val="2"/>
                <c:pt idx="0">
                  <c:v>38.481697971749121</c:v>
                </c:pt>
                <c:pt idx="1">
                  <c:v>109.9689771727555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312-4AD2-B378-A2D924270DF6}"/>
            </c:ext>
          </c:extLst>
        </c:ser>
        <c:ser>
          <c:idx val="2"/>
          <c:order val="2"/>
          <c:tx>
            <c:strRef>
              <c:f>'hsa-piR-32835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5,'hsa-piR-32835'!$F$5)</c:f>
              <c:numCache>
                <c:formatCode>General</c:formatCode>
                <c:ptCount val="2"/>
                <c:pt idx="0">
                  <c:v>65.64658779401897</c:v>
                </c:pt>
                <c:pt idx="1">
                  <c:v>67.91146547436159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312-4AD2-B378-A2D924270DF6}"/>
            </c:ext>
          </c:extLst>
        </c:ser>
        <c:ser>
          <c:idx val="3"/>
          <c:order val="3"/>
          <c:tx>
            <c:strRef>
              <c:f>'hsa-piR-32835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6,'hsa-piR-32835'!$F$6)</c:f>
              <c:numCache>
                <c:formatCode>General</c:formatCode>
                <c:ptCount val="2"/>
                <c:pt idx="0">
                  <c:v>41.296290560700392</c:v>
                </c:pt>
                <c:pt idx="1">
                  <c:v>55.4355820058564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C312-4AD2-B378-A2D924270DF6}"/>
            </c:ext>
          </c:extLst>
        </c:ser>
        <c:ser>
          <c:idx val="4"/>
          <c:order val="4"/>
          <c:tx>
            <c:strRef>
              <c:f>'hsa-piR-32835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835'!$D$7</c:f>
              <c:numCache>
                <c:formatCode>General</c:formatCode>
                <c:ptCount val="1"/>
                <c:pt idx="0">
                  <c:v>55.26641685276663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C312-4AD2-B378-A2D924270DF6}"/>
            </c:ext>
          </c:extLst>
        </c:ser>
        <c:ser>
          <c:idx val="5"/>
          <c:order val="5"/>
          <c:tx>
            <c:strRef>
              <c:f>'hsa-piR-32835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8,'hsa-piR-32835'!$F$8)</c:f>
              <c:numCache>
                <c:formatCode>General</c:formatCode>
                <c:ptCount val="2"/>
                <c:pt idx="0">
                  <c:v>69.664955106534507</c:v>
                </c:pt>
                <c:pt idx="1">
                  <c:v>77.2445109192268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C312-4AD2-B378-A2D924270DF6}"/>
            </c:ext>
          </c:extLst>
        </c:ser>
        <c:ser>
          <c:idx val="6"/>
          <c:order val="6"/>
          <c:tx>
            <c:strRef>
              <c:f>'hsa-piR-32835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35'!$D$9,'hsa-piR-32835'!$F$9)</c:f>
              <c:numCache>
                <c:formatCode>General</c:formatCode>
                <c:ptCount val="2"/>
                <c:pt idx="0">
                  <c:v>43.029845827875171</c:v>
                </c:pt>
                <c:pt idx="1">
                  <c:v>74.17055768930275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C312-4AD2-B378-A2D924270DF6}"/>
            </c:ext>
          </c:extLst>
        </c:ser>
        <c:ser>
          <c:idx val="7"/>
          <c:order val="7"/>
          <c:tx>
            <c:strRef>
              <c:f>'hsa-piR-32835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2835'!$D$2,'hsa-piR-32835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835'!$D$10</c:f>
              <c:numCache>
                <c:formatCode>General</c:formatCode>
                <c:ptCount val="1"/>
                <c:pt idx="0">
                  <c:v>31.910039217438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C312-4AD2-B378-A2D924270D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386176"/>
        <c:axId val="212388096"/>
      </c:lineChart>
      <c:catAx>
        <c:axId val="212386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380392231992893"/>
              <c:y val="0.711850670991544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388096"/>
        <c:crosses val="autoZero"/>
        <c:auto val="1"/>
        <c:lblAlgn val="ctr"/>
        <c:lblOffset val="100"/>
        <c:noMultiLvlLbl val="0"/>
      </c:catAx>
      <c:valAx>
        <c:axId val="2123880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3861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6012989252255876E-2"/>
          <c:y val="0.78916926030206069"/>
          <c:w val="0.96824977169824578"/>
          <c:h val="0.198053302036995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835'!$D$17</c:f>
          <c:strCache>
            <c:ptCount val="1"/>
            <c:pt idx="0">
              <c:v>hsa-piR-32835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2223288357799494"/>
          <c:y val="0.1659898636303129"/>
          <c:w val="0.83170346483071544"/>
          <c:h val="0.50982927705511782"/>
        </c:manualLayout>
      </c:layout>
      <c:lineChart>
        <c:grouping val="standard"/>
        <c:varyColors val="0"/>
        <c:ser>
          <c:idx val="0"/>
          <c:order val="0"/>
          <c:tx>
            <c:strRef>
              <c:f>'hsa-piR-32835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3:$F$3</c:f>
              <c:numCache>
                <c:formatCode>General</c:formatCode>
                <c:ptCount val="3"/>
                <c:pt idx="0">
                  <c:v>97.075342928487601</c:v>
                </c:pt>
                <c:pt idx="1">
                  <c:v>160.6630948455454</c:v>
                </c:pt>
                <c:pt idx="2">
                  <c:v>76.2892889838266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3C1-46DD-A9E2-E42DEDB80BAC}"/>
            </c:ext>
          </c:extLst>
        </c:ser>
        <c:ser>
          <c:idx val="1"/>
          <c:order val="1"/>
          <c:tx>
            <c:strRef>
              <c:f>'hsa-piR-32835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4:$F$4</c:f>
              <c:numCache>
                <c:formatCode>General</c:formatCode>
                <c:ptCount val="3"/>
                <c:pt idx="0">
                  <c:v>38.481697971749121</c:v>
                </c:pt>
                <c:pt idx="1">
                  <c:v>66.573912633116223</c:v>
                </c:pt>
                <c:pt idx="2">
                  <c:v>109.96897717275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3C1-46DD-A9E2-E42DEDB80BAC}"/>
            </c:ext>
          </c:extLst>
        </c:ser>
        <c:ser>
          <c:idx val="2"/>
          <c:order val="2"/>
          <c:tx>
            <c:strRef>
              <c:f>'hsa-piR-32835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5:$F$5</c:f>
              <c:numCache>
                <c:formatCode>General</c:formatCode>
                <c:ptCount val="3"/>
                <c:pt idx="0">
                  <c:v>65.64658779401897</c:v>
                </c:pt>
                <c:pt idx="1">
                  <c:v>60.566373976695488</c:v>
                </c:pt>
                <c:pt idx="2">
                  <c:v>67.91146547436159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3C1-46DD-A9E2-E42DEDB80BAC}"/>
            </c:ext>
          </c:extLst>
        </c:ser>
        <c:ser>
          <c:idx val="3"/>
          <c:order val="3"/>
          <c:tx>
            <c:strRef>
              <c:f>'hsa-piR-32835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6:$F$6</c:f>
              <c:numCache>
                <c:formatCode>General</c:formatCode>
                <c:ptCount val="3"/>
                <c:pt idx="0">
                  <c:v>41.296290560700392</c:v>
                </c:pt>
                <c:pt idx="1">
                  <c:v>20.944820869419519</c:v>
                </c:pt>
                <c:pt idx="2">
                  <c:v>55.435582005856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C3C1-46DD-A9E2-E42DEDB80BAC}"/>
            </c:ext>
          </c:extLst>
        </c:ser>
        <c:ser>
          <c:idx val="4"/>
          <c:order val="4"/>
          <c:tx>
            <c:strRef>
              <c:f>'hsa-piR-32835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7</c:f>
              <c:numCache>
                <c:formatCode>General</c:formatCode>
                <c:ptCount val="1"/>
                <c:pt idx="0">
                  <c:v>55.26641685276663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C3C1-46DD-A9E2-E42DEDB80BAC}"/>
            </c:ext>
          </c:extLst>
        </c:ser>
        <c:ser>
          <c:idx val="5"/>
          <c:order val="5"/>
          <c:tx>
            <c:strRef>
              <c:f>'hsa-piR-32835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8:$F$8</c:f>
              <c:numCache>
                <c:formatCode>General</c:formatCode>
                <c:ptCount val="3"/>
                <c:pt idx="0">
                  <c:v>69.664955106534507</c:v>
                </c:pt>
                <c:pt idx="1">
                  <c:v>83.516640076442286</c:v>
                </c:pt>
                <c:pt idx="2">
                  <c:v>77.2445109192268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C3C1-46DD-A9E2-E42DEDB80BAC}"/>
            </c:ext>
          </c:extLst>
        </c:ser>
        <c:ser>
          <c:idx val="6"/>
          <c:order val="6"/>
          <c:tx>
            <c:strRef>
              <c:f>'hsa-piR-32835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9:$F$9</c:f>
              <c:numCache>
                <c:formatCode>General</c:formatCode>
                <c:ptCount val="3"/>
                <c:pt idx="0">
                  <c:v>43.029845827875171</c:v>
                </c:pt>
                <c:pt idx="1">
                  <c:v>33.910460058187837</c:v>
                </c:pt>
                <c:pt idx="2">
                  <c:v>74.17055768930275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C3C1-46DD-A9E2-E42DEDB80BAC}"/>
            </c:ext>
          </c:extLst>
        </c:ser>
        <c:ser>
          <c:idx val="7"/>
          <c:order val="7"/>
          <c:tx>
            <c:strRef>
              <c:f>'hsa-piR-32835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10</c:f>
              <c:numCache>
                <c:formatCode>General</c:formatCode>
                <c:ptCount val="1"/>
                <c:pt idx="0">
                  <c:v>31.910039217438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C3C1-46DD-A9E2-E42DEDB80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545536"/>
        <c:axId val="212547840"/>
      </c:lineChart>
      <c:catAx>
        <c:axId val="2125455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487892216990454"/>
              <c:y val="0.7508073066973948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547840"/>
        <c:crosses val="autoZero"/>
        <c:auto val="1"/>
        <c:lblAlgn val="ctr"/>
        <c:lblOffset val="100"/>
        <c:noMultiLvlLbl val="0"/>
      </c:catAx>
      <c:valAx>
        <c:axId val="212547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545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3782824885582787E-3"/>
          <c:y val="0.79352890294176737"/>
          <c:w val="0.99724310529023064"/>
          <c:h val="0.1999437724954989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2835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2835'!$D$14:$F$14</c:f>
                <c:numCache>
                  <c:formatCode>General</c:formatCode>
                  <c:ptCount val="3"/>
                  <c:pt idx="0">
                    <c:v>21.498140201797135</c:v>
                  </c:pt>
                  <c:pt idx="1">
                    <c:v>49.407969937090783</c:v>
                  </c:pt>
                  <c:pt idx="2">
                    <c:v>18.127270819243666</c:v>
                  </c:pt>
                </c:numCache>
              </c:numRef>
            </c:plus>
            <c:minus>
              <c:numRef>
                <c:f>'hsa-piR-32835'!$D$14:$F$14</c:f>
                <c:numCache>
                  <c:formatCode>General</c:formatCode>
                  <c:ptCount val="3"/>
                  <c:pt idx="0">
                    <c:v>21.498140201797135</c:v>
                  </c:pt>
                  <c:pt idx="1">
                    <c:v>49.407969937090783</c:v>
                  </c:pt>
                  <c:pt idx="2">
                    <c:v>18.127270819243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2835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35'!$D$12:$F$12</c:f>
              <c:numCache>
                <c:formatCode>General</c:formatCode>
                <c:ptCount val="3"/>
                <c:pt idx="0">
                  <c:v>55.296397032446336</c:v>
                </c:pt>
                <c:pt idx="1">
                  <c:v>71.029217076567789</c:v>
                </c:pt>
                <c:pt idx="2">
                  <c:v>76.8367303742216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107-4D71-A907-BF3FC852DD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590592"/>
        <c:axId val="212592128"/>
      </c:barChart>
      <c:catAx>
        <c:axId val="212590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592128"/>
        <c:crosses val="autoZero"/>
        <c:auto val="1"/>
        <c:lblAlgn val="ctr"/>
        <c:lblOffset val="100"/>
        <c:noMultiLvlLbl val="0"/>
      </c:catAx>
      <c:valAx>
        <c:axId val="2125921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590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32874'!$D$17</c:f>
          <c:strCache>
            <c:ptCount val="1"/>
            <c:pt idx="0">
              <c:v>hsa-piR-32874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6492599317653414"/>
          <c:y val="0.18695311632663247"/>
          <c:w val="0.79005047663062855"/>
          <c:h val="0.48568617445480955"/>
        </c:manualLayout>
      </c:layout>
      <c:lineChart>
        <c:grouping val="standard"/>
        <c:varyColors val="0"/>
        <c:ser>
          <c:idx val="0"/>
          <c:order val="0"/>
          <c:tx>
            <c:strRef>
              <c:f>'32874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3:$F$3</c:f>
              <c:numCache>
                <c:formatCode>General</c:formatCode>
                <c:ptCount val="3"/>
                <c:pt idx="0">
                  <c:v>62.311875528421112</c:v>
                </c:pt>
                <c:pt idx="1">
                  <c:v>91.807482768883077</c:v>
                </c:pt>
                <c:pt idx="2">
                  <c:v>110.8737666564947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BF0-4A2E-85AD-AF0C6935C913}"/>
            </c:ext>
          </c:extLst>
        </c:ser>
        <c:ser>
          <c:idx val="1"/>
          <c:order val="1"/>
          <c:tx>
            <c:strRef>
              <c:f>'32874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4:$F$4</c:f>
              <c:numCache>
                <c:formatCode>General</c:formatCode>
                <c:ptCount val="3"/>
                <c:pt idx="0">
                  <c:v>61.039934713808961</c:v>
                </c:pt>
                <c:pt idx="1">
                  <c:v>71.630159162213658</c:v>
                </c:pt>
                <c:pt idx="2">
                  <c:v>81.02977265360928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BF0-4A2E-85AD-AF0C6935C913}"/>
            </c:ext>
          </c:extLst>
        </c:ser>
        <c:ser>
          <c:idx val="2"/>
          <c:order val="2"/>
          <c:tx>
            <c:strRef>
              <c:f>'32874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5:$F$5</c:f>
              <c:numCache>
                <c:formatCode>General</c:formatCode>
                <c:ptCount val="3"/>
                <c:pt idx="0">
                  <c:v>127.83809201993169</c:v>
                </c:pt>
                <c:pt idx="1">
                  <c:v>135.3836594773193</c:v>
                </c:pt>
                <c:pt idx="2">
                  <c:v>148.67104603846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2BF0-4A2E-85AD-AF0C6935C913}"/>
            </c:ext>
          </c:extLst>
        </c:ser>
        <c:ser>
          <c:idx val="3"/>
          <c:order val="3"/>
          <c:tx>
            <c:strRef>
              <c:f>'32874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6:$F$6</c:f>
              <c:numCache>
                <c:formatCode>General</c:formatCode>
                <c:ptCount val="3"/>
                <c:pt idx="0">
                  <c:v>98.078690081663396</c:v>
                </c:pt>
                <c:pt idx="1">
                  <c:v>60.739980521316589</c:v>
                </c:pt>
                <c:pt idx="2">
                  <c:v>73.91410934114195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2BF0-4A2E-85AD-AF0C6935C913}"/>
            </c:ext>
          </c:extLst>
        </c:ser>
        <c:ser>
          <c:idx val="4"/>
          <c:order val="4"/>
          <c:tx>
            <c:strRef>
              <c:f>'32874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7</c:f>
              <c:numCache>
                <c:formatCode>General</c:formatCode>
                <c:ptCount val="1"/>
                <c:pt idx="0">
                  <c:v>53.8120374619043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2BF0-4A2E-85AD-AF0C6935C913}"/>
            </c:ext>
          </c:extLst>
        </c:ser>
        <c:ser>
          <c:idx val="5"/>
          <c:order val="5"/>
          <c:tx>
            <c:strRef>
              <c:f>'32874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8:$F$8</c:f>
              <c:numCache>
                <c:formatCode>General</c:formatCode>
                <c:ptCount val="3"/>
                <c:pt idx="0">
                  <c:v>52.870724857637803</c:v>
                </c:pt>
                <c:pt idx="1">
                  <c:v>82.288454192965204</c:v>
                </c:pt>
                <c:pt idx="2">
                  <c:v>85.2550527923318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2BF0-4A2E-85AD-AF0C6935C913}"/>
            </c:ext>
          </c:extLst>
        </c:ser>
        <c:ser>
          <c:idx val="6"/>
          <c:order val="6"/>
          <c:tx>
            <c:strRef>
              <c:f>'32874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9:$F$9</c:f>
              <c:numCache>
                <c:formatCode>General</c:formatCode>
                <c:ptCount val="3"/>
                <c:pt idx="0">
                  <c:v>32.136213972716902</c:v>
                </c:pt>
                <c:pt idx="1">
                  <c:v>39.562203401219143</c:v>
                </c:pt>
                <c:pt idx="2">
                  <c:v>51.89007395654778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2BF0-4A2E-85AD-AF0C6935C913}"/>
            </c:ext>
          </c:extLst>
        </c:ser>
        <c:ser>
          <c:idx val="7"/>
          <c:order val="7"/>
          <c:tx>
            <c:strRef>
              <c:f>'32874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10</c:f>
              <c:numCache>
                <c:formatCode>General</c:formatCode>
                <c:ptCount val="1"/>
                <c:pt idx="0">
                  <c:v>118.067145104521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2BF0-4A2E-85AD-AF0C6935C9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030784"/>
        <c:axId val="212926848"/>
      </c:lineChart>
      <c:catAx>
        <c:axId val="2130307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8011616521991918"/>
              <c:y val="0.738111534477543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926848"/>
        <c:crosses val="autoZero"/>
        <c:auto val="1"/>
        <c:lblAlgn val="ctr"/>
        <c:lblOffset val="100"/>
        <c:noMultiLvlLbl val="0"/>
      </c:catAx>
      <c:valAx>
        <c:axId val="212926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030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1583255500960095E-2"/>
          <c:y val="0.79424900668457232"/>
          <c:w val="0.94864739259938213"/>
          <c:h val="0.199434108124459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32874'!$D$17</c:f>
          <c:strCache>
            <c:ptCount val="1"/>
            <c:pt idx="0">
              <c:v>hsa-piR-32874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395441442465408"/>
          <c:y val="0.21116144989627469"/>
          <c:w val="0.81627026041901418"/>
          <c:h val="0.55612730335586558"/>
        </c:manualLayout>
      </c:layout>
      <c:lineChart>
        <c:grouping val="standard"/>
        <c:varyColors val="0"/>
        <c:ser>
          <c:idx val="0"/>
          <c:order val="0"/>
          <c:tx>
            <c:strRef>
              <c:f>'32874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3,'32874'!$F$3)</c:f>
              <c:numCache>
                <c:formatCode>General</c:formatCode>
                <c:ptCount val="2"/>
                <c:pt idx="0">
                  <c:v>62.311875528421112</c:v>
                </c:pt>
                <c:pt idx="1">
                  <c:v>110.8737666564947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B82-4D71-8287-C6853A40B1B8}"/>
            </c:ext>
          </c:extLst>
        </c:ser>
        <c:ser>
          <c:idx val="1"/>
          <c:order val="1"/>
          <c:tx>
            <c:strRef>
              <c:f>'32874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4,'32874'!$F$4)</c:f>
              <c:numCache>
                <c:formatCode>General</c:formatCode>
                <c:ptCount val="2"/>
                <c:pt idx="0">
                  <c:v>61.039934713808961</c:v>
                </c:pt>
                <c:pt idx="1">
                  <c:v>81.029772653609285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1-FB82-4D71-8287-C6853A40B1B8}"/>
            </c:ext>
          </c:extLst>
        </c:ser>
        <c:ser>
          <c:idx val="2"/>
          <c:order val="2"/>
          <c:tx>
            <c:strRef>
              <c:f>'32874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5,'32874'!$F$5)</c:f>
              <c:numCache>
                <c:formatCode>General</c:formatCode>
                <c:ptCount val="2"/>
                <c:pt idx="0">
                  <c:v>127.83809201993169</c:v>
                </c:pt>
                <c:pt idx="1">
                  <c:v>148.671046038467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B82-4D71-8287-C6853A40B1B8}"/>
            </c:ext>
          </c:extLst>
        </c:ser>
        <c:ser>
          <c:idx val="3"/>
          <c:order val="3"/>
          <c:tx>
            <c:strRef>
              <c:f>'32874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6,'32874'!$F$6)</c:f>
              <c:numCache>
                <c:formatCode>General</c:formatCode>
                <c:ptCount val="2"/>
                <c:pt idx="0">
                  <c:v>98.078690081663396</c:v>
                </c:pt>
                <c:pt idx="1">
                  <c:v>73.91410934114195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B82-4D71-8287-C6853A40B1B8}"/>
            </c:ext>
          </c:extLst>
        </c:ser>
        <c:ser>
          <c:idx val="5"/>
          <c:order val="4"/>
          <c:tx>
            <c:strRef>
              <c:f>'32874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8,'32874'!$F$8)</c:f>
              <c:numCache>
                <c:formatCode>General</c:formatCode>
                <c:ptCount val="2"/>
                <c:pt idx="0">
                  <c:v>52.870724857637803</c:v>
                </c:pt>
                <c:pt idx="1">
                  <c:v>85.25505279233185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FB82-4D71-8287-C6853A40B1B8}"/>
            </c:ext>
          </c:extLst>
        </c:ser>
        <c:ser>
          <c:idx val="6"/>
          <c:order val="5"/>
          <c:tx>
            <c:strRef>
              <c:f>'32874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32874'!$D$2,'328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32874'!$D$9,'32874'!$F$9)</c:f>
              <c:numCache>
                <c:formatCode>General</c:formatCode>
                <c:ptCount val="2"/>
                <c:pt idx="0">
                  <c:v>32.136213972716902</c:v>
                </c:pt>
                <c:pt idx="1">
                  <c:v>51.890073956547781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FB82-4D71-8287-C6853A40B1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958208"/>
        <c:axId val="212977152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32874'!$C$7</c15:sqref>
                        </c15:formulaRef>
                      </c:ext>
                    </c:extLst>
                    <c:strCache>
                      <c:ptCount val="1"/>
                      <c:pt idx="0">
                        <c:v>normalized_IR0015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('32874'!$D$2,'32874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32874'!$D$7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53.812037461904353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FB82-4D71-8287-C6853A40B1B8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32874'!$C$10</c15:sqref>
                        </c15:formulaRef>
                      </c:ext>
                    </c:extLst>
                    <c:strCache>
                      <c:ptCount val="1"/>
                      <c:pt idx="0">
                        <c:v>normalized_IR0046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32874'!$D$2,'32874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32874'!$D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18.067145104521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FB82-4D71-8287-C6853A40B1B8}"/>
                  </c:ext>
                </c:extLst>
              </c15:ser>
            </c15:filteredLineSeries>
          </c:ext>
        </c:extLst>
      </c:lineChart>
      <c:catAx>
        <c:axId val="2129582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6947962575748964"/>
              <c:y val="0.7811741674993372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977152"/>
        <c:crosses val="autoZero"/>
        <c:auto val="1"/>
        <c:lblAlgn val="ctr"/>
        <c:lblOffset val="100"/>
        <c:noMultiLvlLbl val="0"/>
      </c:catAx>
      <c:valAx>
        <c:axId val="212977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958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4849259804334627E-2"/>
          <c:y val="0.84129505684624328"/>
          <c:w val="0.92442054532069484"/>
          <c:h val="0.1587049431537566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</a:t>
            </a:r>
            <a:r>
              <a:rPr lang="en-US" sz="1100" baseline="0" dirty="0"/>
              <a:t> </a:t>
            </a:r>
            <a:r>
              <a:rPr lang="en-US" sz="1100" dirty="0"/>
              <a:t>normalized</a:t>
            </a:r>
          </a:p>
        </c:rich>
      </c:tx>
      <c:layout>
        <c:manualLayout>
          <c:xMode val="edge"/>
          <c:yMode val="edge"/>
          <c:x val="0.30368008402827446"/>
          <c:y val="2.323884573701668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32874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32874'!$D$14:$F$14</c:f>
                <c:numCache>
                  <c:formatCode>General</c:formatCode>
                  <c:ptCount val="3"/>
                  <c:pt idx="0">
                    <c:v>34.447360425164561</c:v>
                  </c:pt>
                  <c:pt idx="1">
                    <c:v>32.520421665657217</c:v>
                  </c:pt>
                  <c:pt idx="2">
                    <c:v>33.673580112928832</c:v>
                  </c:pt>
                </c:numCache>
              </c:numRef>
            </c:plus>
            <c:minus>
              <c:numRef>
                <c:f>'32874'!$D$14:$F$14</c:f>
                <c:numCache>
                  <c:formatCode>General</c:formatCode>
                  <c:ptCount val="3"/>
                  <c:pt idx="0">
                    <c:v>34.447360425164561</c:v>
                  </c:pt>
                  <c:pt idx="1">
                    <c:v>32.520421665657217</c:v>
                  </c:pt>
                  <c:pt idx="2">
                    <c:v>33.6735801129288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328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32874'!$D$12:$F$12</c:f>
              <c:numCache>
                <c:formatCode>General</c:formatCode>
                <c:ptCount val="3"/>
                <c:pt idx="0">
                  <c:v>75.769339217575691</c:v>
                </c:pt>
                <c:pt idx="1">
                  <c:v>80.235323253986166</c:v>
                </c:pt>
                <c:pt idx="2">
                  <c:v>91.938970239765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D91-4E54-925D-5D946F85D3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737024"/>
        <c:axId val="212747008"/>
      </c:barChart>
      <c:catAx>
        <c:axId val="21273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747008"/>
        <c:crosses val="autoZero"/>
        <c:auto val="1"/>
        <c:lblAlgn val="ctr"/>
        <c:lblOffset val="100"/>
        <c:noMultiLvlLbl val="0"/>
      </c:catAx>
      <c:valAx>
        <c:axId val="212747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2737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886'!$D$17</c:f>
          <c:strCache>
            <c:ptCount val="1"/>
            <c:pt idx="0">
              <c:v>hsa-piR-3288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1391951473938394"/>
          <c:y val="0.21947932041772944"/>
          <c:w val="0.85246197241571398"/>
          <c:h val="0.46130559279073979"/>
        </c:manualLayout>
      </c:layout>
      <c:lineChart>
        <c:grouping val="standard"/>
        <c:varyColors val="0"/>
        <c:ser>
          <c:idx val="0"/>
          <c:order val="0"/>
          <c:tx>
            <c:strRef>
              <c:f>'hsa-piR-3288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3:$F$3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30C-4268-9F85-0738E98B1610}"/>
            </c:ext>
          </c:extLst>
        </c:ser>
        <c:ser>
          <c:idx val="1"/>
          <c:order val="1"/>
          <c:tx>
            <c:strRef>
              <c:f>'hsa-piR-3288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4:$F$4</c:f>
              <c:numCache>
                <c:formatCode>General</c:formatCode>
                <c:ptCount val="3"/>
                <c:pt idx="0">
                  <c:v>0</c:v>
                </c:pt>
                <c:pt idx="1">
                  <c:v>0.84270775484957239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30C-4268-9F85-0738E98B1610}"/>
            </c:ext>
          </c:extLst>
        </c:ser>
        <c:ser>
          <c:idx val="2"/>
          <c:order val="2"/>
          <c:tx>
            <c:strRef>
              <c:f>'hsa-piR-3288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5:$F$5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30C-4268-9F85-0738E98B1610}"/>
            </c:ext>
          </c:extLst>
        </c:ser>
        <c:ser>
          <c:idx val="3"/>
          <c:order val="3"/>
          <c:tx>
            <c:strRef>
              <c:f>'hsa-piR-3288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6:$F$6</c:f>
              <c:numCache>
                <c:formatCode>General</c:formatCode>
                <c:ptCount val="3"/>
                <c:pt idx="0">
                  <c:v>0</c:v>
                </c:pt>
                <c:pt idx="1">
                  <c:v>2.094482086941952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30C-4268-9F85-0738E98B1610}"/>
            </c:ext>
          </c:extLst>
        </c:ser>
        <c:ser>
          <c:idx val="4"/>
          <c:order val="4"/>
          <c:tx>
            <c:strRef>
              <c:f>'hsa-piR-32886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430C-4268-9F85-0738E98B1610}"/>
            </c:ext>
          </c:extLst>
        </c:ser>
        <c:ser>
          <c:idx val="5"/>
          <c:order val="5"/>
          <c:tx>
            <c:strRef>
              <c:f>'hsa-piR-32886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8:$F$8</c:f>
              <c:numCache>
                <c:formatCode>General</c:formatCode>
                <c:ptCount val="3"/>
                <c:pt idx="0">
                  <c:v>0.62200852773691517</c:v>
                </c:pt>
                <c:pt idx="1">
                  <c:v>3.684557650431278</c:v>
                </c:pt>
                <c:pt idx="2">
                  <c:v>0.572181562364643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430C-4268-9F85-0738E98B1610}"/>
            </c:ext>
          </c:extLst>
        </c:ser>
        <c:ser>
          <c:idx val="6"/>
          <c:order val="6"/>
          <c:tx>
            <c:strRef>
              <c:f>'hsa-piR-3288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9:$F$9</c:f>
              <c:numCache>
                <c:formatCode>General</c:formatCode>
                <c:ptCount val="3"/>
                <c:pt idx="0">
                  <c:v>0</c:v>
                </c:pt>
                <c:pt idx="1">
                  <c:v>1.255942965118068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430C-4268-9F85-0738E98B1610}"/>
            </c:ext>
          </c:extLst>
        </c:ser>
        <c:ser>
          <c:idx val="7"/>
          <c:order val="7"/>
          <c:tx>
            <c:strRef>
              <c:f>'hsa-piR-32886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10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430C-4268-9F85-0738E98B16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998208"/>
        <c:axId val="211877888"/>
      </c:lineChart>
      <c:catAx>
        <c:axId val="2119982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175049069969697"/>
              <c:y val="0.7362650766104876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877888"/>
        <c:crosses val="autoZero"/>
        <c:auto val="1"/>
        <c:lblAlgn val="ctr"/>
        <c:lblOffset val="100"/>
        <c:noMultiLvlLbl val="0"/>
      </c:catAx>
      <c:valAx>
        <c:axId val="2118778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998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3209609568578382E-3"/>
          <c:y val="0.77974819307119225"/>
          <c:w val="0.97901519789583769"/>
          <c:h val="0.220251806928807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1677'!$D$17</c:f>
          <c:strCache>
            <c:ptCount val="1"/>
            <c:pt idx="0">
              <c:v>hsa-piR-1677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2233851067868387"/>
          <c:y val="0.13669554455445546"/>
          <c:w val="0.80547384818792911"/>
          <c:h val="0.61633269341219377"/>
        </c:manualLayout>
      </c:layout>
      <c:lineChart>
        <c:grouping val="standard"/>
        <c:varyColors val="0"/>
        <c:ser>
          <c:idx val="0"/>
          <c:order val="0"/>
          <c:tx>
            <c:strRef>
              <c:f>'1677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3,'1677'!$F$3)</c:f>
              <c:numCache>
                <c:formatCode>General</c:formatCode>
                <c:ptCount val="2"/>
                <c:pt idx="0">
                  <c:v>1.311828958493076</c:v>
                </c:pt>
                <c:pt idx="1">
                  <c:v>3.051571559353067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2A5-4F9C-971C-762160CBDB76}"/>
            </c:ext>
          </c:extLst>
        </c:ser>
        <c:ser>
          <c:idx val="1"/>
          <c:order val="1"/>
          <c:tx>
            <c:strRef>
              <c:f>'1677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4,'1677'!$F$4)</c:f>
              <c:numCache>
                <c:formatCode>General</c:formatCode>
                <c:ptCount val="2"/>
                <c:pt idx="0">
                  <c:v>3.9808653074223241</c:v>
                </c:pt>
                <c:pt idx="1">
                  <c:v>1.1575681807658471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1-12A5-4F9C-971C-762160CBDB76}"/>
            </c:ext>
          </c:extLst>
        </c:ser>
        <c:ser>
          <c:idx val="2"/>
          <c:order val="2"/>
          <c:tx>
            <c:strRef>
              <c:f>'1677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5,'1677'!$F$5)</c:f>
              <c:numCache>
                <c:formatCode>General</c:formatCode>
                <c:ptCount val="2"/>
                <c:pt idx="0">
                  <c:v>4.1461002817275148</c:v>
                </c:pt>
                <c:pt idx="1">
                  <c:v>3.670890025641167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2A5-4F9C-971C-762160CBDB76}"/>
            </c:ext>
          </c:extLst>
        </c:ser>
        <c:ser>
          <c:idx val="3"/>
          <c:order val="3"/>
          <c:tx>
            <c:strRef>
              <c:f>'1677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6,'1677'!$F$6)</c:f>
              <c:numCache>
                <c:formatCode>General</c:formatCode>
                <c:ptCount val="2"/>
                <c:pt idx="0">
                  <c:v>0</c:v>
                </c:pt>
                <c:pt idx="1">
                  <c:v>2.463803644704731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2A5-4F9C-971C-762160CBDB76}"/>
            </c:ext>
          </c:extLst>
        </c:ser>
        <c:ser>
          <c:idx val="5"/>
          <c:order val="4"/>
          <c:tx>
            <c:strRef>
              <c:f>'1677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8,'1677'!$F$8)</c:f>
              <c:numCache>
                <c:formatCode>General</c:formatCode>
                <c:ptCount val="2"/>
                <c:pt idx="0">
                  <c:v>1.8660255832107451</c:v>
                </c:pt>
                <c:pt idx="1">
                  <c:v>2.860907811823217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12A5-4F9C-971C-762160CBDB76}"/>
            </c:ext>
          </c:extLst>
        </c:ser>
        <c:ser>
          <c:idx val="6"/>
          <c:order val="5"/>
          <c:tx>
            <c:strRef>
              <c:f>'1677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1677'!$D$2,'167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1677'!$D$9,'1677'!$F$9)</c:f>
              <c:numCache>
                <c:formatCode>General</c:formatCode>
                <c:ptCount val="2"/>
                <c:pt idx="0">
                  <c:v>2.7234079637895681</c:v>
                </c:pt>
                <c:pt idx="1">
                  <c:v>3.517971115698154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12A5-4F9C-971C-762160CBDB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3560448"/>
        <c:axId val="203563008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1677'!$C$7</c15:sqref>
                        </c15:formulaRef>
                      </c:ext>
                    </c:extLst>
                    <c:strCache>
                      <c:ptCount val="1"/>
                      <c:pt idx="0">
                        <c:v>normalized_IR0015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('1677'!$D$2,'1677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1677'!$D$7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.45437939086228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12A5-4F9C-971C-762160CBDB76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1677'!$C$10</c15:sqref>
                        </c15:formulaRef>
                      </c:ext>
                    </c:extLst>
                    <c:strCache>
                      <c:ptCount val="1"/>
                      <c:pt idx="0">
                        <c:v>normalized_IR0046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1677'!$D$2,'1677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1677'!$D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0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12A5-4F9C-971C-762160CBDB76}"/>
                  </c:ext>
                </c:extLst>
              </c15:ser>
            </c15:filteredLineSeries>
          </c:ext>
        </c:extLst>
      </c:lineChart>
      <c:catAx>
        <c:axId val="2035604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3703470981339304"/>
              <c:y val="0.7848768548875065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563008"/>
        <c:crosses val="autoZero"/>
        <c:auto val="1"/>
        <c:lblAlgn val="ctr"/>
        <c:lblOffset val="100"/>
        <c:noMultiLvlLbl val="0"/>
      </c:catAx>
      <c:valAx>
        <c:axId val="203563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>
            <c:manualLayout>
              <c:xMode val="edge"/>
              <c:yMode val="edge"/>
              <c:x val="2.9615266296201759E-2"/>
              <c:y val="0.2733913207429232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560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8771313186849149E-2"/>
          <c:y val="0.86722840368623266"/>
          <c:w val="0.95757126007935589"/>
          <c:h val="0.121670066087612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9.5670517126135848E-2"/>
          <c:y val="0.12484061397629376"/>
          <c:w val="0.89629356789646797"/>
          <c:h val="0.792081614561364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sa-piR-32886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2886'!$D$14:$F$14</c:f>
                <c:numCache>
                  <c:formatCode>General</c:formatCode>
                  <c:ptCount val="3"/>
                  <c:pt idx="0">
                    <c:v>0.21991322395931673</c:v>
                  </c:pt>
                  <c:pt idx="1">
                    <c:v>1.4076482676179427</c:v>
                  </c:pt>
                  <c:pt idx="2">
                    <c:v>0.23359214467030784</c:v>
                  </c:pt>
                </c:numCache>
              </c:numRef>
            </c:plus>
            <c:minus>
              <c:numRef>
                <c:f>'hsa-piR-32886'!$D$14:$F$14</c:f>
                <c:numCache>
                  <c:formatCode>General</c:formatCode>
                  <c:ptCount val="3"/>
                  <c:pt idx="0">
                    <c:v>0.21991322395931673</c:v>
                  </c:pt>
                  <c:pt idx="1">
                    <c:v>1.4076482676179427</c:v>
                  </c:pt>
                  <c:pt idx="2">
                    <c:v>0.233592144670307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288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886'!$D$12:$F$12</c:f>
              <c:numCache>
                <c:formatCode>General</c:formatCode>
                <c:ptCount val="3"/>
                <c:pt idx="0">
                  <c:v>7.7751065967114397E-2</c:v>
                </c:pt>
                <c:pt idx="1">
                  <c:v>1.3129484095568118</c:v>
                </c:pt>
                <c:pt idx="2">
                  <c:v>9.536359372744053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810-4BF4-8365-FF466E8D34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904000"/>
        <c:axId val="211905536"/>
      </c:barChart>
      <c:catAx>
        <c:axId val="211904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905536"/>
        <c:crosses val="autoZero"/>
        <c:auto val="1"/>
        <c:lblAlgn val="ctr"/>
        <c:lblOffset val="100"/>
        <c:noMultiLvlLbl val="0"/>
      </c:catAx>
      <c:valAx>
        <c:axId val="211905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904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886'!$D$17</c:f>
          <c:strCache>
            <c:ptCount val="1"/>
            <c:pt idx="0">
              <c:v>hsa-piR-3288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8329744139307097"/>
          <c:y val="0.24959953793858081"/>
          <c:w val="0.77065231472523299"/>
          <c:h val="0.41139786826480562"/>
        </c:manualLayout>
      </c:layout>
      <c:lineChart>
        <c:grouping val="standard"/>
        <c:varyColors val="0"/>
        <c:ser>
          <c:idx val="0"/>
          <c:order val="0"/>
          <c:tx>
            <c:strRef>
              <c:f>'hsa-piR-3288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3,'hsa-piR-32886'!$F$3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CFC-4112-895A-8620000BF5F0}"/>
            </c:ext>
          </c:extLst>
        </c:ser>
        <c:ser>
          <c:idx val="1"/>
          <c:order val="1"/>
          <c:tx>
            <c:strRef>
              <c:f>'hsa-piR-3288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4,'hsa-piR-32886'!$F$4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CFC-4112-895A-8620000BF5F0}"/>
            </c:ext>
          </c:extLst>
        </c:ser>
        <c:ser>
          <c:idx val="2"/>
          <c:order val="2"/>
          <c:tx>
            <c:strRef>
              <c:f>'hsa-piR-3288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5,'hsa-piR-32886'!$F$5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CFC-4112-895A-8620000BF5F0}"/>
            </c:ext>
          </c:extLst>
        </c:ser>
        <c:ser>
          <c:idx val="3"/>
          <c:order val="3"/>
          <c:tx>
            <c:strRef>
              <c:f>'hsa-piR-3288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6,'hsa-piR-32886'!$F$6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CFC-4112-895A-8620000BF5F0}"/>
            </c:ext>
          </c:extLst>
        </c:ser>
        <c:ser>
          <c:idx val="4"/>
          <c:order val="4"/>
          <c:tx>
            <c:strRef>
              <c:f>'hsa-piR-32886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886'!$D$7</c:f>
              <c:numCache>
                <c:formatCode>General</c:formatCode>
                <c:ptCount val="1"/>
                <c:pt idx="0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9CFC-4112-895A-8620000BF5F0}"/>
            </c:ext>
          </c:extLst>
        </c:ser>
        <c:ser>
          <c:idx val="5"/>
          <c:order val="5"/>
          <c:tx>
            <c:strRef>
              <c:f>'hsa-piR-32886'!$C$8</c:f>
              <c:strCache>
                <c:ptCount val="1"/>
                <c:pt idx="0">
                  <c:v>normalized_IR0030</c:v>
                </c:pt>
              </c:strCache>
              <c:extLst xmlns:c15="http://schemas.microsoft.com/office/drawing/2012/chart" xmlns:c16r2="http://schemas.microsoft.com/office/drawing/2015/06/chart"/>
            </c:strRef>
          </c:tx>
          <c:spPr>
            <a:ln w="158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8,'hsa-piR-32886'!$F$8)</c:f>
              <c:numCache>
                <c:formatCode>General</c:formatCode>
                <c:ptCount val="2"/>
                <c:pt idx="0">
                  <c:v>0.62200852773691517</c:v>
                </c:pt>
                <c:pt idx="1">
                  <c:v>0.57218156236464324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5-9CFC-4112-895A-8620000BF5F0}"/>
            </c:ext>
          </c:extLst>
        </c:ser>
        <c:ser>
          <c:idx val="6"/>
          <c:order val="6"/>
          <c:tx>
            <c:strRef>
              <c:f>'hsa-piR-3288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58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886'!$D$9,'hsa-piR-32886'!$F$9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9CFC-4112-895A-8620000BF5F0}"/>
            </c:ext>
          </c:extLst>
        </c:ser>
        <c:ser>
          <c:idx val="7"/>
          <c:order val="7"/>
          <c:tx>
            <c:strRef>
              <c:f>'hsa-piR-32886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2886'!$D$2,'hsa-piR-3288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886'!$D$10</c:f>
              <c:numCache>
                <c:formatCode>General</c:formatCode>
                <c:ptCount val="1"/>
                <c:pt idx="0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9CFC-4112-895A-8620000BF5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610496"/>
        <c:axId val="213612800"/>
        <c:extLst xmlns:c16r2="http://schemas.microsoft.com/office/drawing/2015/06/chart"/>
      </c:lineChart>
      <c:catAx>
        <c:axId val="2136104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7571714931519637"/>
              <c:y val="0.6959794827773494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612800"/>
        <c:crosses val="autoZero"/>
        <c:auto val="1"/>
        <c:lblAlgn val="ctr"/>
        <c:lblOffset val="100"/>
        <c:noMultiLvlLbl val="0"/>
      </c:catAx>
      <c:valAx>
        <c:axId val="2136128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610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0828281376549575E-2"/>
          <c:y val="0.80732038819517848"/>
          <c:w val="0.94252982305432775"/>
          <c:h val="0.192679611804821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941'!$D$17</c:f>
          <c:strCache>
            <c:ptCount val="1"/>
            <c:pt idx="0">
              <c:v>hsa-piR-3294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925327464706055"/>
          <c:y val="0.17661030457027788"/>
          <c:w val="0.81581209928332965"/>
          <c:h val="0.51005483441183797"/>
        </c:manualLayout>
      </c:layout>
      <c:lineChart>
        <c:grouping val="standard"/>
        <c:varyColors val="0"/>
        <c:ser>
          <c:idx val="0"/>
          <c:order val="0"/>
          <c:tx>
            <c:strRef>
              <c:f>'hsa-piR-3294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3:$F$3</c:f>
              <c:numCache>
                <c:formatCode>General</c:formatCode>
                <c:ptCount val="3"/>
                <c:pt idx="0">
                  <c:v>0.6559144792465379</c:v>
                </c:pt>
                <c:pt idx="1">
                  <c:v>0</c:v>
                </c:pt>
                <c:pt idx="2">
                  <c:v>1.01719051978435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167-4836-A257-1846A74A9FAB}"/>
            </c:ext>
          </c:extLst>
        </c:ser>
        <c:ser>
          <c:idx val="1"/>
          <c:order val="1"/>
          <c:tx>
            <c:strRef>
              <c:f>'hsa-piR-3294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4:$F$4</c:f>
              <c:numCache>
                <c:formatCode>General</c:formatCode>
                <c:ptCount val="3"/>
                <c:pt idx="0">
                  <c:v>0</c:v>
                </c:pt>
                <c:pt idx="1">
                  <c:v>2.5281232645487171</c:v>
                </c:pt>
                <c:pt idx="2">
                  <c:v>1.157568180765847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5167-4836-A257-1846A74A9FAB}"/>
            </c:ext>
          </c:extLst>
        </c:ser>
        <c:ser>
          <c:idx val="2"/>
          <c:order val="2"/>
          <c:tx>
            <c:strRef>
              <c:f>'hsa-piR-3294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5:$F$5</c:f>
              <c:numCache>
                <c:formatCode>General</c:formatCode>
                <c:ptCount val="3"/>
                <c:pt idx="0">
                  <c:v>0.69101671362125239</c:v>
                </c:pt>
                <c:pt idx="1">
                  <c:v>0</c:v>
                </c:pt>
                <c:pt idx="2">
                  <c:v>0.9177225064102916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167-4836-A257-1846A74A9FAB}"/>
            </c:ext>
          </c:extLst>
        </c:ser>
        <c:ser>
          <c:idx val="3"/>
          <c:order val="3"/>
          <c:tx>
            <c:strRef>
              <c:f>'hsa-piR-3294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6:$F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2.463803644704731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5167-4836-A257-1846A74A9FAB}"/>
            </c:ext>
          </c:extLst>
        </c:ser>
        <c:ser>
          <c:idx val="4"/>
          <c:order val="4"/>
          <c:tx>
            <c:strRef>
              <c:f>'hsa-piR-3294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5167-4836-A257-1846A74A9FAB}"/>
            </c:ext>
          </c:extLst>
        </c:ser>
        <c:ser>
          <c:idx val="5"/>
          <c:order val="5"/>
          <c:tx>
            <c:strRef>
              <c:f>'hsa-piR-3294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8:$F$8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1.14436312472928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5167-4836-A257-1846A74A9FAB}"/>
            </c:ext>
          </c:extLst>
        </c:ser>
        <c:ser>
          <c:idx val="6"/>
          <c:order val="6"/>
          <c:tx>
            <c:strRef>
              <c:f>'hsa-piR-3294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9:$F$9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.5863285192830257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5167-4836-A257-1846A74A9FAB}"/>
            </c:ext>
          </c:extLst>
        </c:ser>
        <c:ser>
          <c:idx val="7"/>
          <c:order val="7"/>
          <c:tx>
            <c:strRef>
              <c:f>'hsa-piR-3294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10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5167-4836-A257-1846A74A9F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470592"/>
        <c:axId val="213473152"/>
      </c:lineChart>
      <c:catAx>
        <c:axId val="21347059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62379521647264"/>
              <c:y val="0.7413180537839597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473152"/>
        <c:crosses val="autoZero"/>
        <c:auto val="1"/>
        <c:lblAlgn val="ctr"/>
        <c:lblOffset val="100"/>
        <c:noMultiLvlLbl val="0"/>
      </c:catAx>
      <c:valAx>
        <c:axId val="213473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4705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7684686298734532E-2"/>
          <c:y val="0.78989740854678669"/>
          <c:w val="0.95646069538987466"/>
          <c:h val="0.210102591453213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941'!$D$17</c:f>
          <c:strCache>
            <c:ptCount val="1"/>
            <c:pt idx="0">
              <c:v>hsa-piR-3294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172003499562554"/>
          <c:y val="0.17171302555884571"/>
          <c:w val="0.77919936321653782"/>
          <c:h val="0.54494181082264415"/>
        </c:manualLayout>
      </c:layout>
      <c:lineChart>
        <c:grouping val="standard"/>
        <c:varyColors val="0"/>
        <c:ser>
          <c:idx val="0"/>
          <c:order val="0"/>
          <c:tx>
            <c:strRef>
              <c:f>'hsa-piR-3294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3,'hsa-piR-32941'!$F$3)</c:f>
              <c:numCache>
                <c:formatCode>General</c:formatCode>
                <c:ptCount val="2"/>
                <c:pt idx="0">
                  <c:v>0.6559144792465379</c:v>
                </c:pt>
                <c:pt idx="1">
                  <c:v>1.01719051978435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568-459E-AE6A-DEB920D96132}"/>
            </c:ext>
          </c:extLst>
        </c:ser>
        <c:ser>
          <c:idx val="1"/>
          <c:order val="1"/>
          <c:tx>
            <c:strRef>
              <c:f>'hsa-piR-3294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4,'hsa-piR-32941'!$F$4)</c:f>
              <c:numCache>
                <c:formatCode>General</c:formatCode>
                <c:ptCount val="2"/>
                <c:pt idx="0">
                  <c:v>0</c:v>
                </c:pt>
                <c:pt idx="1">
                  <c:v>1.1575681807658471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1-D568-459E-AE6A-DEB920D96132}"/>
            </c:ext>
          </c:extLst>
        </c:ser>
        <c:ser>
          <c:idx val="2"/>
          <c:order val="2"/>
          <c:tx>
            <c:strRef>
              <c:f>'hsa-piR-3294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5,'hsa-piR-32941'!$F$5)</c:f>
              <c:numCache>
                <c:formatCode>General</c:formatCode>
                <c:ptCount val="2"/>
                <c:pt idx="0">
                  <c:v>0.69101671362125239</c:v>
                </c:pt>
                <c:pt idx="1">
                  <c:v>0.9177225064102916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568-459E-AE6A-DEB920D96132}"/>
            </c:ext>
          </c:extLst>
        </c:ser>
        <c:ser>
          <c:idx val="3"/>
          <c:order val="3"/>
          <c:tx>
            <c:strRef>
              <c:f>'hsa-piR-3294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6,'hsa-piR-32941'!$F$6)</c:f>
              <c:numCache>
                <c:formatCode>General</c:formatCode>
                <c:ptCount val="2"/>
                <c:pt idx="0">
                  <c:v>0</c:v>
                </c:pt>
                <c:pt idx="1">
                  <c:v>2.463803644704731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568-459E-AE6A-DEB920D96132}"/>
            </c:ext>
          </c:extLst>
        </c:ser>
        <c:ser>
          <c:idx val="4"/>
          <c:order val="4"/>
          <c:tx>
            <c:strRef>
              <c:f>'hsa-piR-3294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941'!$D$7</c:f>
              <c:numCache>
                <c:formatCode>General</c:formatCode>
                <c:ptCount val="1"/>
                <c:pt idx="0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4-D568-459E-AE6A-DEB920D96132}"/>
            </c:ext>
          </c:extLst>
        </c:ser>
        <c:ser>
          <c:idx val="5"/>
          <c:order val="5"/>
          <c:tx>
            <c:strRef>
              <c:f>'hsa-piR-3294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8,'hsa-piR-32941'!$F$8)</c:f>
              <c:numCache>
                <c:formatCode>General</c:formatCode>
                <c:ptCount val="2"/>
                <c:pt idx="0">
                  <c:v>0</c:v>
                </c:pt>
                <c:pt idx="1">
                  <c:v>1.14436312472928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D568-459E-AE6A-DEB920D96132}"/>
            </c:ext>
          </c:extLst>
        </c:ser>
        <c:ser>
          <c:idx val="6"/>
          <c:order val="6"/>
          <c:tx>
            <c:strRef>
              <c:f>'hsa-piR-3294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2941'!$D$9,'hsa-piR-32941'!$F$9)</c:f>
              <c:numCache>
                <c:formatCode>General</c:formatCode>
                <c:ptCount val="2"/>
                <c:pt idx="0">
                  <c:v>0</c:v>
                </c:pt>
                <c:pt idx="1">
                  <c:v>0.5863285192830257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D568-459E-AE6A-DEB920D96132}"/>
            </c:ext>
          </c:extLst>
        </c:ser>
        <c:ser>
          <c:idx val="7"/>
          <c:order val="7"/>
          <c:tx>
            <c:strRef>
              <c:f>'hsa-piR-3294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2941'!$D$2,'hsa-piR-329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2941'!$D$10</c:f>
              <c:numCache>
                <c:formatCode>General</c:formatCode>
                <c:ptCount val="1"/>
                <c:pt idx="0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7-D568-459E-AE6A-DEB920D961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3543936"/>
        <c:axId val="213546496"/>
        <c:extLst xmlns:c16r2="http://schemas.microsoft.com/office/drawing/2015/06/chart"/>
      </c:lineChart>
      <c:catAx>
        <c:axId val="213543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dirty="0"/>
                  <a:t>blood sample</a:t>
                </a:r>
              </a:p>
            </c:rich>
          </c:tx>
          <c:layout>
            <c:manualLayout>
              <c:xMode val="edge"/>
              <c:yMode val="edge"/>
              <c:x val="0.42989077171385232"/>
              <c:y val="0.7262447674386158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546496"/>
        <c:crosses val="autoZero"/>
        <c:auto val="1"/>
        <c:lblAlgn val="ctr"/>
        <c:lblOffset val="100"/>
        <c:noMultiLvlLbl val="0"/>
      </c:catAx>
      <c:valAx>
        <c:axId val="213546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dirty="0" err="1"/>
                  <a:t>normalized</a:t>
                </a:r>
                <a:r>
                  <a:rPr lang="de-DE" sz="700" dirty="0"/>
                  <a:t> </a:t>
                </a:r>
                <a:r>
                  <a:rPr lang="de-DE" sz="700" dirty="0" err="1"/>
                  <a:t>values</a:t>
                </a:r>
                <a:endParaRPr lang="en-US" sz="7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543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9636897619101524E-2"/>
          <c:y val="0.7833035948476742"/>
          <c:w val="0.94948038128014123"/>
          <c:h val="0.216696405152325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verage normalized</a:t>
            </a:r>
          </a:p>
        </c:rich>
      </c:tx>
      <c:layout>
        <c:manualLayout>
          <c:xMode val="edge"/>
          <c:yMode val="edge"/>
          <c:x val="0.30738156811280942"/>
          <c:y val="2.323894757178138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2941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2941'!$D$14:$F$14</c:f>
                <c:numCache>
                  <c:formatCode>General</c:formatCode>
                  <c:ptCount val="3"/>
                  <c:pt idx="0">
                    <c:v>0.3118951169404644</c:v>
                  </c:pt>
                  <c:pt idx="1">
                    <c:v>1.0321020008339343</c:v>
                  </c:pt>
                  <c:pt idx="2">
                    <c:v>0.64661075319932837</c:v>
                  </c:pt>
                </c:numCache>
              </c:numRef>
            </c:plus>
            <c:minus>
              <c:numRef>
                <c:f>'hsa-piR-32941'!$D$14:$F$14</c:f>
                <c:numCache>
                  <c:formatCode>General</c:formatCode>
                  <c:ptCount val="3"/>
                  <c:pt idx="0">
                    <c:v>0.3118951169404644</c:v>
                  </c:pt>
                  <c:pt idx="1">
                    <c:v>1.0321020008339343</c:v>
                  </c:pt>
                  <c:pt idx="2">
                    <c:v>0.646610753199328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29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41'!$D$12:$F$12</c:f>
              <c:numCache>
                <c:formatCode>General</c:formatCode>
                <c:ptCount val="3"/>
                <c:pt idx="0">
                  <c:v>0.16836639910847379</c:v>
                </c:pt>
                <c:pt idx="1">
                  <c:v>0.42135387742478619</c:v>
                </c:pt>
                <c:pt idx="2">
                  <c:v>1.2144960826129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23B-4744-81D9-F347B2FF9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572608"/>
        <c:axId val="213578496"/>
      </c:barChart>
      <c:catAx>
        <c:axId val="213572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578496"/>
        <c:crosses val="autoZero"/>
        <c:auto val="1"/>
        <c:lblAlgn val="ctr"/>
        <c:lblOffset val="100"/>
        <c:noMultiLvlLbl val="0"/>
      </c:catAx>
      <c:valAx>
        <c:axId val="213578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572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956'!$D$17</c:f>
          <c:strCache>
            <c:ptCount val="1"/>
            <c:pt idx="0">
              <c:v>hsa-piR-3295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183434826192789"/>
          <c:y val="0.17083036665362092"/>
          <c:w val="0.82182546501067122"/>
          <c:h val="0.50404834089020245"/>
        </c:manualLayout>
      </c:layout>
      <c:lineChart>
        <c:grouping val="standard"/>
        <c:varyColors val="0"/>
        <c:ser>
          <c:idx val="0"/>
          <c:order val="0"/>
          <c:tx>
            <c:strRef>
              <c:f>'hsa-piR-3295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3,'hsa-piR-32956'!$F$3)</c:f>
              <c:numCache>
                <c:formatCode>General</c:formatCode>
                <c:ptCount val="2"/>
                <c:pt idx="0">
                  <c:v>57.720474173695337</c:v>
                </c:pt>
                <c:pt idx="1">
                  <c:v>75.27209846404231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F11-46B1-8CBA-48C6FEA5CBD3}"/>
            </c:ext>
          </c:extLst>
        </c:ser>
        <c:ser>
          <c:idx val="1"/>
          <c:order val="1"/>
          <c:tx>
            <c:strRef>
              <c:f>'hsa-piR-3295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4,'hsa-piR-32956'!$F$4)</c:f>
              <c:numCache>
                <c:formatCode>General</c:formatCode>
                <c:ptCount val="2"/>
                <c:pt idx="0">
                  <c:v>46.443428586593782</c:v>
                </c:pt>
                <c:pt idx="1">
                  <c:v>75.2419317497800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F11-46B1-8CBA-48C6FEA5CBD3}"/>
            </c:ext>
          </c:extLst>
        </c:ser>
        <c:ser>
          <c:idx val="2"/>
          <c:order val="2"/>
          <c:tx>
            <c:strRef>
              <c:f>'hsa-piR-3295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5,'hsa-piR-32956'!$F$5)</c:f>
              <c:numCache>
                <c:formatCode>General</c:formatCode>
                <c:ptCount val="2"/>
                <c:pt idx="0">
                  <c:v>108.4896240385366</c:v>
                </c:pt>
                <c:pt idx="1">
                  <c:v>106.45581074359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4F11-46B1-8CBA-48C6FEA5CBD3}"/>
            </c:ext>
          </c:extLst>
        </c:ser>
        <c:ser>
          <c:idx val="3"/>
          <c:order val="3"/>
          <c:tx>
            <c:strRef>
              <c:f>'hsa-piR-3295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6,'hsa-piR-32956'!$F$6)</c:f>
              <c:numCache>
                <c:formatCode>General</c:formatCode>
                <c:ptCount val="2"/>
                <c:pt idx="0">
                  <c:v>80.871902348038262</c:v>
                </c:pt>
                <c:pt idx="1">
                  <c:v>70.2184038740848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4F11-46B1-8CBA-48C6FEA5CBD3}"/>
            </c:ext>
          </c:extLst>
        </c:ser>
        <c:ser>
          <c:idx val="4"/>
          <c:order val="4"/>
          <c:tx>
            <c:strRef>
              <c:f>'hsa-piR-32956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'hsa-piR-32956'!$D$7</c:f>
              <c:numCache>
                <c:formatCode>General</c:formatCode>
                <c:ptCount val="1"/>
                <c:pt idx="0">
                  <c:v>53.0848477664732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4F11-46B1-8CBA-48C6FEA5CBD3}"/>
            </c:ext>
          </c:extLst>
        </c:ser>
        <c:ser>
          <c:idx val="5"/>
          <c:order val="5"/>
          <c:tx>
            <c:strRef>
              <c:f>'hsa-piR-32956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8,'hsa-piR-32956'!$F$8)</c:f>
              <c:numCache>
                <c:formatCode>General</c:formatCode>
                <c:ptCount val="2"/>
                <c:pt idx="0">
                  <c:v>60.956835718217697</c:v>
                </c:pt>
                <c:pt idx="1">
                  <c:v>72.0948768579450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4F11-46B1-8CBA-48C6FEA5CBD3}"/>
            </c:ext>
          </c:extLst>
        </c:ser>
        <c:ser>
          <c:idx val="6"/>
          <c:order val="6"/>
          <c:tx>
            <c:strRef>
              <c:f>'hsa-piR-3295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('hsa-piR-32956'!$D$9,'hsa-piR-32956'!$F$9)</c:f>
              <c:numCache>
                <c:formatCode>General</c:formatCode>
                <c:ptCount val="2"/>
                <c:pt idx="0">
                  <c:v>28.868124416169412</c:v>
                </c:pt>
                <c:pt idx="1">
                  <c:v>49.54475987941567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4F11-46B1-8CBA-48C6FEA5CBD3}"/>
            </c:ext>
          </c:extLst>
        </c:ser>
        <c:ser>
          <c:idx val="7"/>
          <c:order val="7"/>
          <c:tx>
            <c:strRef>
              <c:f>'hsa-piR-32956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2956'!$D$2,'hsa-piR-3295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</c:strRef>
          </c:cat>
          <c:val>
            <c:numRef>
              <c:f>'hsa-piR-32956'!$D$10</c:f>
              <c:numCache>
                <c:formatCode>General</c:formatCode>
                <c:ptCount val="1"/>
                <c:pt idx="0">
                  <c:v>92.53911373057077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4F11-46B1-8CBA-48C6FEA5CB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210432"/>
        <c:axId val="214229376"/>
      </c:lineChart>
      <c:catAx>
        <c:axId val="2142104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6268371047898571"/>
              <c:y val="0.6955507183902925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229376"/>
        <c:crosses val="autoZero"/>
        <c:auto val="1"/>
        <c:lblAlgn val="ctr"/>
        <c:lblOffset val="100"/>
        <c:noMultiLvlLbl val="0"/>
      </c:catAx>
      <c:valAx>
        <c:axId val="214229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210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0709658329855884E-2"/>
          <c:y val="0.79744808713411874"/>
          <c:w val="0.95751696210056048"/>
          <c:h val="0.202551912865881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2956'!$D$17</c:f>
          <c:strCache>
            <c:ptCount val="1"/>
            <c:pt idx="0">
              <c:v>hsa-piR-3295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5027393754452198"/>
          <c:y val="0.14401786490700502"/>
          <c:w val="0.80004075238686734"/>
          <c:h val="0.52658957024322073"/>
        </c:manualLayout>
      </c:layout>
      <c:lineChart>
        <c:grouping val="standard"/>
        <c:varyColors val="0"/>
        <c:ser>
          <c:idx val="0"/>
          <c:order val="0"/>
          <c:tx>
            <c:strRef>
              <c:f>'hsa-piR-3295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3:$F$3</c:f>
              <c:numCache>
                <c:formatCode>General</c:formatCode>
                <c:ptCount val="3"/>
                <c:pt idx="0">
                  <c:v>57.720474173695337</c:v>
                </c:pt>
                <c:pt idx="1">
                  <c:v>72.680923858699103</c:v>
                </c:pt>
                <c:pt idx="2">
                  <c:v>75.27209846404231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CB5-457B-BEEF-E3245092BEE6}"/>
            </c:ext>
          </c:extLst>
        </c:ser>
        <c:ser>
          <c:idx val="1"/>
          <c:order val="1"/>
          <c:tx>
            <c:strRef>
              <c:f>'hsa-piR-3295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4:$F$4</c:f>
              <c:numCache>
                <c:formatCode>General</c:formatCode>
                <c:ptCount val="3"/>
                <c:pt idx="0">
                  <c:v>46.443428586593782</c:v>
                </c:pt>
                <c:pt idx="1">
                  <c:v>75.000990181611954</c:v>
                </c:pt>
                <c:pt idx="2">
                  <c:v>75.24193174978006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CB5-457B-BEEF-E3245092BEE6}"/>
            </c:ext>
          </c:extLst>
        </c:ser>
        <c:ser>
          <c:idx val="2"/>
          <c:order val="2"/>
          <c:tx>
            <c:strRef>
              <c:f>'hsa-piR-3295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5:$F$5</c:f>
              <c:numCache>
                <c:formatCode>General</c:formatCode>
                <c:ptCount val="3"/>
                <c:pt idx="0">
                  <c:v>108.4896240385366</c:v>
                </c:pt>
                <c:pt idx="1">
                  <c:v>107.594382005659</c:v>
                </c:pt>
                <c:pt idx="2">
                  <c:v>106.45581074359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CB5-457B-BEEF-E3245092BEE6}"/>
            </c:ext>
          </c:extLst>
        </c:ser>
        <c:ser>
          <c:idx val="3"/>
          <c:order val="3"/>
          <c:tx>
            <c:strRef>
              <c:f>'hsa-piR-3295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6:$F$6</c:f>
              <c:numCache>
                <c:formatCode>General</c:formatCode>
                <c:ptCount val="3"/>
                <c:pt idx="0">
                  <c:v>80.871902348038262</c:v>
                </c:pt>
                <c:pt idx="1">
                  <c:v>54.456534260490727</c:v>
                </c:pt>
                <c:pt idx="2">
                  <c:v>70.2184038740848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CB5-457B-BEEF-E3245092BEE6}"/>
            </c:ext>
          </c:extLst>
        </c:ser>
        <c:ser>
          <c:idx val="4"/>
          <c:order val="4"/>
          <c:tx>
            <c:strRef>
              <c:f>'hsa-piR-32956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7</c:f>
              <c:numCache>
                <c:formatCode>General</c:formatCode>
                <c:ptCount val="1"/>
                <c:pt idx="0">
                  <c:v>53.0848477664732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BCB5-457B-BEEF-E3245092BEE6}"/>
            </c:ext>
          </c:extLst>
        </c:ser>
        <c:ser>
          <c:idx val="5"/>
          <c:order val="5"/>
          <c:tx>
            <c:strRef>
              <c:f>'hsa-piR-32956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8:$F$8</c:f>
              <c:numCache>
                <c:formatCode>General</c:formatCode>
                <c:ptCount val="3"/>
                <c:pt idx="0">
                  <c:v>60.956835718217697</c:v>
                </c:pt>
                <c:pt idx="1">
                  <c:v>65.093851824285906</c:v>
                </c:pt>
                <c:pt idx="2">
                  <c:v>72.09487685794505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BCB5-457B-BEEF-E3245092BEE6}"/>
            </c:ext>
          </c:extLst>
        </c:ser>
        <c:ser>
          <c:idx val="6"/>
          <c:order val="6"/>
          <c:tx>
            <c:strRef>
              <c:f>'hsa-piR-3295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9:$F$9</c:f>
              <c:numCache>
                <c:formatCode>General</c:formatCode>
                <c:ptCount val="3"/>
                <c:pt idx="0">
                  <c:v>28.868124416169412</c:v>
                </c:pt>
                <c:pt idx="1">
                  <c:v>34.53843154074687</c:v>
                </c:pt>
                <c:pt idx="2">
                  <c:v>49.54475987941567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BCB5-457B-BEEF-E3245092BEE6}"/>
            </c:ext>
          </c:extLst>
        </c:ser>
        <c:ser>
          <c:idx val="7"/>
          <c:order val="7"/>
          <c:tx>
            <c:strRef>
              <c:f>'hsa-piR-32956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10</c:f>
              <c:numCache>
                <c:formatCode>General</c:formatCode>
                <c:ptCount val="1"/>
                <c:pt idx="0">
                  <c:v>92.53911373057077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BCB5-457B-BEEF-E3245092B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144512"/>
        <c:axId val="214159360"/>
      </c:lineChart>
      <c:catAx>
        <c:axId val="214144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6953498266393462"/>
              <c:y val="0.7425089334646471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159360"/>
        <c:crosses val="autoZero"/>
        <c:auto val="1"/>
        <c:lblAlgn val="ctr"/>
        <c:lblOffset val="100"/>
        <c:noMultiLvlLbl val="0"/>
      </c:catAx>
      <c:valAx>
        <c:axId val="214159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144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656177002287024E-2"/>
          <c:y val="0.7923664631569155"/>
          <c:w val="0.97834744180966682"/>
          <c:h val="0.207633536843084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2956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2956'!$D$14:$F$14</c:f>
                <c:numCache>
                  <c:formatCode>General</c:formatCode>
                  <c:ptCount val="3"/>
                  <c:pt idx="0">
                    <c:v>26.056993574463576</c:v>
                  </c:pt>
                  <c:pt idx="1">
                    <c:v>24.289409766773229</c:v>
                  </c:pt>
                  <c:pt idx="2">
                    <c:v>18.268247166736295</c:v>
                  </c:pt>
                </c:numCache>
              </c:numRef>
            </c:plus>
            <c:minus>
              <c:numRef>
                <c:f>'hsa-piR-32956'!$D$14:$F$14</c:f>
                <c:numCache>
                  <c:formatCode>General</c:formatCode>
                  <c:ptCount val="3"/>
                  <c:pt idx="0">
                    <c:v>26.056993574463576</c:v>
                  </c:pt>
                  <c:pt idx="1">
                    <c:v>24.289409766773229</c:v>
                  </c:pt>
                  <c:pt idx="2">
                    <c:v>18.2682471667362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295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2956'!$D$12:$F$12</c:f>
              <c:numCache>
                <c:formatCode>General</c:formatCode>
                <c:ptCount val="3"/>
                <c:pt idx="0">
                  <c:v>66.121793847286881</c:v>
                </c:pt>
                <c:pt idx="1">
                  <c:v>68.227518945248917</c:v>
                </c:pt>
                <c:pt idx="2">
                  <c:v>74.8046469281436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F1A-4473-980D-569A548469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927424"/>
        <c:axId val="213928960"/>
      </c:barChart>
      <c:catAx>
        <c:axId val="21392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928960"/>
        <c:crosses val="autoZero"/>
        <c:auto val="1"/>
        <c:lblAlgn val="ctr"/>
        <c:lblOffset val="100"/>
        <c:noMultiLvlLbl val="0"/>
      </c:catAx>
      <c:valAx>
        <c:axId val="213928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3927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36'!$D$17</c:f>
          <c:strCache>
            <c:ptCount val="1"/>
            <c:pt idx="0">
              <c:v>hsa-piR-3303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6873432709699041"/>
          <c:y val="0.14924990803803895"/>
          <c:w val="0.77243922858346292"/>
          <c:h val="0.54372061187748921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3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3,'hsa-piR-33036'!$F$3)</c:f>
              <c:numCache>
                <c:formatCode>General</c:formatCode>
                <c:ptCount val="2"/>
                <c:pt idx="0">
                  <c:v>3946.6374216264189</c:v>
                </c:pt>
                <c:pt idx="1">
                  <c:v>4355.609805716610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99D7-4A67-8DFD-5F0D2C266A39}"/>
            </c:ext>
          </c:extLst>
        </c:ser>
        <c:ser>
          <c:idx val="1"/>
          <c:order val="1"/>
          <c:tx>
            <c:strRef>
              <c:f>'hsa-piR-3303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4,'hsa-piR-33036'!$F$4)</c:f>
              <c:numCache>
                <c:formatCode>General</c:formatCode>
                <c:ptCount val="2"/>
                <c:pt idx="0">
                  <c:v>2738.8353315065592</c:v>
                </c:pt>
                <c:pt idx="1">
                  <c:v>4340.880677871927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9D7-4A67-8DFD-5F0D2C266A39}"/>
            </c:ext>
          </c:extLst>
        </c:ser>
        <c:ser>
          <c:idx val="2"/>
          <c:order val="2"/>
          <c:tx>
            <c:strRef>
              <c:f>'hsa-piR-3303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5,'hsa-piR-33036'!$F$5)</c:f>
              <c:numCache>
                <c:formatCode>General</c:formatCode>
                <c:ptCount val="2"/>
                <c:pt idx="0">
                  <c:v>2888.449862936835</c:v>
                </c:pt>
                <c:pt idx="1">
                  <c:v>4336.2388427886281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99D7-4A67-8DFD-5F0D2C266A39}"/>
            </c:ext>
          </c:extLst>
        </c:ser>
        <c:ser>
          <c:idx val="3"/>
          <c:order val="3"/>
          <c:tx>
            <c:strRef>
              <c:f>'hsa-piR-3303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6,'hsa-piR-33036'!$F$6)</c:f>
              <c:numCache>
                <c:formatCode>General</c:formatCode>
                <c:ptCount val="2"/>
                <c:pt idx="0">
                  <c:v>3214.2279486411799</c:v>
                </c:pt>
                <c:pt idx="1">
                  <c:v>4173.68337412981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9D7-4A67-8DFD-5F0D2C266A39}"/>
            </c:ext>
          </c:extLst>
        </c:ser>
        <c:ser>
          <c:idx val="4"/>
          <c:order val="4"/>
          <c:tx>
            <c:strRef>
              <c:f>'hsa-piR-33036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36'!$D$7</c:f>
              <c:numCache>
                <c:formatCode>General</c:formatCode>
                <c:ptCount val="1"/>
                <c:pt idx="0">
                  <c:v>4345.685619896492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99D7-4A67-8DFD-5F0D2C266A39}"/>
            </c:ext>
          </c:extLst>
        </c:ser>
        <c:ser>
          <c:idx val="5"/>
          <c:order val="5"/>
          <c:tx>
            <c:strRef>
              <c:f>'hsa-piR-33036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8,'hsa-piR-33036'!$F$8)</c:f>
              <c:numCache>
                <c:formatCode>General</c:formatCode>
                <c:ptCount val="2"/>
                <c:pt idx="0">
                  <c:v>3139.2770394882118</c:v>
                </c:pt>
                <c:pt idx="1">
                  <c:v>3960.068593125696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99D7-4A67-8DFD-5F0D2C266A39}"/>
            </c:ext>
          </c:extLst>
        </c:ser>
        <c:ser>
          <c:idx val="6"/>
          <c:order val="6"/>
          <c:tx>
            <c:strRef>
              <c:f>'hsa-piR-3303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36'!$D$9,'hsa-piR-33036'!$F$9)</c:f>
              <c:numCache>
                <c:formatCode>General</c:formatCode>
                <c:ptCount val="2"/>
                <c:pt idx="0">
                  <c:v>3033.3317900688198</c:v>
                </c:pt>
                <c:pt idx="1">
                  <c:v>4269.937441678635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99D7-4A67-8DFD-5F0D2C266A39}"/>
            </c:ext>
          </c:extLst>
        </c:ser>
        <c:ser>
          <c:idx val="7"/>
          <c:order val="7"/>
          <c:tx>
            <c:strRef>
              <c:f>'hsa-piR-33036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3036'!$D$2,'hsa-piR-33036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36'!$D$10</c:f>
              <c:numCache>
                <c:formatCode>General</c:formatCode>
                <c:ptCount val="1"/>
                <c:pt idx="0">
                  <c:v>2077.343553055226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99D7-4A67-8DFD-5F0D2C266A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675456"/>
        <c:axId val="214677760"/>
      </c:lineChart>
      <c:catAx>
        <c:axId val="214675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548829039354554"/>
              <c:y val="0.69487431182226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677760"/>
        <c:crosses val="autoZero"/>
        <c:auto val="1"/>
        <c:lblAlgn val="ctr"/>
        <c:lblOffset val="100"/>
        <c:noMultiLvlLbl val="0"/>
      </c:catAx>
      <c:valAx>
        <c:axId val="214677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675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4989261249607158E-2"/>
          <c:y val="0.77805761993222988"/>
          <c:w val="0.97423317929646291"/>
          <c:h val="0.211787115488853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36'!$D$17</c:f>
          <c:strCache>
            <c:ptCount val="1"/>
            <c:pt idx="0">
              <c:v>hsa-piR-33036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172003499562554"/>
          <c:y val="0.15319450028962539"/>
          <c:w val="0.82645420569311634"/>
          <c:h val="0.50625958839068075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36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3:$F$3</c:f>
              <c:numCache>
                <c:formatCode>General</c:formatCode>
                <c:ptCount val="3"/>
                <c:pt idx="0">
                  <c:v>3946.6374216264189</c:v>
                </c:pt>
                <c:pt idx="1">
                  <c:v>4154.2885952919587</c:v>
                </c:pt>
                <c:pt idx="2">
                  <c:v>4355.609805716610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C86-4FE0-8634-6B1056805C16}"/>
            </c:ext>
          </c:extLst>
        </c:ser>
        <c:ser>
          <c:idx val="1"/>
          <c:order val="1"/>
          <c:tx>
            <c:strRef>
              <c:f>'hsa-piR-33036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4:$F$4</c:f>
              <c:numCache>
                <c:formatCode>General</c:formatCode>
                <c:ptCount val="3"/>
                <c:pt idx="0">
                  <c:v>2738.8353315065592</c:v>
                </c:pt>
                <c:pt idx="1">
                  <c:v>3926.1754298441579</c:v>
                </c:pt>
                <c:pt idx="2">
                  <c:v>4340.8806778719272</c:v>
                </c:pt>
              </c:numCache>
            </c:numRef>
          </c:val>
          <c:smooth val="0"/>
          <c:extLst xmlns:c15="http://schemas.microsoft.com/office/drawing/2012/chart" xmlns:c16r2="http://schemas.microsoft.com/office/drawing/2015/06/chart">
            <c:ext xmlns:c16="http://schemas.microsoft.com/office/drawing/2014/chart" uri="{C3380CC4-5D6E-409C-BE32-E72D297353CC}">
              <c16:uniqueId val="{00000001-6C86-4FE0-8634-6B1056805C16}"/>
            </c:ext>
          </c:extLst>
        </c:ser>
        <c:ser>
          <c:idx val="2"/>
          <c:order val="2"/>
          <c:tx>
            <c:strRef>
              <c:f>'hsa-piR-33036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5:$F$5</c:f>
              <c:numCache>
                <c:formatCode>General</c:formatCode>
                <c:ptCount val="3"/>
                <c:pt idx="0">
                  <c:v>2888.449862936835</c:v>
                </c:pt>
                <c:pt idx="1">
                  <c:v>4337.9774678837894</c:v>
                </c:pt>
                <c:pt idx="2">
                  <c:v>4336.238842788628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C86-4FE0-8634-6B1056805C16}"/>
            </c:ext>
          </c:extLst>
        </c:ser>
        <c:ser>
          <c:idx val="3"/>
          <c:order val="3"/>
          <c:tx>
            <c:strRef>
              <c:f>'hsa-piR-33036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6:$F$6</c:f>
              <c:numCache>
                <c:formatCode>General</c:formatCode>
                <c:ptCount val="3"/>
                <c:pt idx="0">
                  <c:v>3214.2279486411799</c:v>
                </c:pt>
                <c:pt idx="1">
                  <c:v>3444.3757919760392</c:v>
                </c:pt>
                <c:pt idx="2">
                  <c:v>4173.68337412981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6C86-4FE0-8634-6B1056805C16}"/>
            </c:ext>
          </c:extLst>
        </c:ser>
        <c:ser>
          <c:idx val="5"/>
          <c:order val="4"/>
          <c:tx>
            <c:strRef>
              <c:f>'hsa-piR-33036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8:$F$8</c:f>
              <c:numCache>
                <c:formatCode>General</c:formatCode>
                <c:ptCount val="3"/>
                <c:pt idx="0">
                  <c:v>3139.2770394882118</c:v>
                </c:pt>
                <c:pt idx="1">
                  <c:v>3421.7258713671799</c:v>
                </c:pt>
                <c:pt idx="2">
                  <c:v>3960.068593125696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6C86-4FE0-8634-6B1056805C16}"/>
            </c:ext>
          </c:extLst>
        </c:ser>
        <c:ser>
          <c:idx val="6"/>
          <c:order val="5"/>
          <c:tx>
            <c:strRef>
              <c:f>'hsa-piR-33036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9:$F$9</c:f>
              <c:numCache>
                <c:formatCode>General</c:formatCode>
                <c:ptCount val="3"/>
                <c:pt idx="0">
                  <c:v>3033.3317900688198</c:v>
                </c:pt>
                <c:pt idx="1">
                  <c:v>3568.1339639004318</c:v>
                </c:pt>
                <c:pt idx="2">
                  <c:v>4269.93744167863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6C86-4FE0-8634-6B1056805C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427136"/>
        <c:axId val="214429696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4"/>
                <c:order val="4"/>
                <c:tx>
                  <c:strRef>
                    <c:extLst>
                      <c:ext uri="{02D57815-91ED-43cb-92C2-25804820EDAC}">
                        <c15:formulaRef>
                          <c15:sqref>'hsa-piR-33036'!$C$7</c15:sqref>
                        </c15:formulaRef>
                      </c:ext>
                    </c:extLst>
                    <c:strCache>
                      <c:ptCount val="1"/>
                      <c:pt idx="0">
                        <c:v>normalized_IR0015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'hsa-piR-33036'!$D$2:$F$2</c15:sqref>
                        </c15:formulaRef>
                      </c:ext>
                    </c:extLst>
                    <c:strCache>
                      <c:ptCount val="3"/>
                      <c:pt idx="0">
                        <c:v>T0</c:v>
                      </c:pt>
                      <c:pt idx="1">
                        <c:v>direct</c:v>
                      </c:pt>
                      <c:pt idx="2">
                        <c:v>3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hsa-piR-33036'!$D$7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4345.6856198964924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6C86-4FE0-8634-6B1056805C16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33036'!$C$10</c15:sqref>
                        </c15:formulaRef>
                      </c:ext>
                    </c:extLst>
                    <c:strCache>
                      <c:ptCount val="1"/>
                      <c:pt idx="0">
                        <c:v>normalized_IR0046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33036'!$D$2:$F$2</c15:sqref>
                        </c15:formulaRef>
                      </c:ext>
                    </c:extLst>
                    <c:strCache>
                      <c:ptCount val="3"/>
                      <c:pt idx="0">
                        <c:v>T0</c:v>
                      </c:pt>
                      <c:pt idx="1">
                        <c:v>direct</c:v>
                      </c:pt>
                      <c:pt idx="2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33036'!$D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2077.3435530552269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6C86-4FE0-8634-6B1056805C16}"/>
                  </c:ext>
                </c:extLst>
              </c15:ser>
            </c15:filteredLineSeries>
          </c:ext>
        </c:extLst>
      </c:lineChart>
      <c:catAx>
        <c:axId val="2144271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dirty="0"/>
                  <a:t>blood sample</a:t>
                </a:r>
              </a:p>
            </c:rich>
          </c:tx>
          <c:layout>
            <c:manualLayout>
              <c:xMode val="edge"/>
              <c:yMode val="edge"/>
              <c:x val="0.45971194062088871"/>
              <c:y val="0.7147818111383955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429696"/>
        <c:crosses val="autoZero"/>
        <c:auto val="1"/>
        <c:lblAlgn val="ctr"/>
        <c:lblOffset val="100"/>
        <c:noMultiLvlLbl val="0"/>
      </c:catAx>
      <c:valAx>
        <c:axId val="214429696"/>
        <c:scaling>
          <c:orientation val="minMax"/>
          <c:min val="25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dirty="0" err="1"/>
                  <a:t>normalized</a:t>
                </a:r>
                <a:r>
                  <a:rPr lang="de-DE" sz="700" baseline="0" dirty="0"/>
                  <a:t> </a:t>
                </a:r>
                <a:r>
                  <a:rPr lang="de-DE" sz="700" baseline="0" dirty="0" err="1"/>
                  <a:t>values</a:t>
                </a:r>
                <a:endParaRPr lang="en-US" sz="7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4271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77644562509000536"/>
          <c:w val="0.97161427140809398"/>
          <c:h val="0.2235543749099946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26116001157354751"/>
          <c:y val="5.5175318654030511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677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1677'!$D$14:$F$14</c:f>
                <c:numCache>
                  <c:formatCode>General</c:formatCode>
                  <c:ptCount val="3"/>
                  <c:pt idx="0">
                    <c:v>1.5950217807082552</c:v>
                  </c:pt>
                  <c:pt idx="1">
                    <c:v>1.2860236028653349</c:v>
                  </c:pt>
                  <c:pt idx="2">
                    <c:v>0.91110314203364473</c:v>
                  </c:pt>
                </c:numCache>
              </c:numRef>
            </c:plus>
            <c:minus>
              <c:numRef>
                <c:f>'1677'!$D$14:$F$14</c:f>
                <c:numCache>
                  <c:formatCode>General</c:formatCode>
                  <c:ptCount val="3"/>
                  <c:pt idx="0">
                    <c:v>1.5950217807082552</c:v>
                  </c:pt>
                  <c:pt idx="1">
                    <c:v>1.2860236028653349</c:v>
                  </c:pt>
                  <c:pt idx="2">
                    <c:v>0.911103142033644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167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1677'!$D$12:$F$12</c:f>
              <c:numCache>
                <c:formatCode>General</c:formatCode>
                <c:ptCount val="3"/>
                <c:pt idx="0">
                  <c:v>1.9353259356881884</c:v>
                </c:pt>
                <c:pt idx="1">
                  <c:v>2.711776227881487</c:v>
                </c:pt>
                <c:pt idx="2">
                  <c:v>2.78711872299769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DCB-43BE-8767-FF2ECFF056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3585024"/>
        <c:axId val="203586560"/>
      </c:barChart>
      <c:catAx>
        <c:axId val="203585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586560"/>
        <c:crosses val="autoZero"/>
        <c:auto val="1"/>
        <c:lblAlgn val="ctr"/>
        <c:lblOffset val="100"/>
        <c:noMultiLvlLbl val="0"/>
      </c:catAx>
      <c:valAx>
        <c:axId val="2035865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03585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3036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3036'!$D$14:$F$14</c:f>
                <c:numCache>
                  <c:formatCode>General</c:formatCode>
                  <c:ptCount val="3"/>
                  <c:pt idx="0">
                    <c:v>703.6619925125766</c:v>
                  </c:pt>
                  <c:pt idx="1">
                    <c:v>388.25756306603114</c:v>
                  </c:pt>
                  <c:pt idx="2">
                    <c:v>152.61589266298091</c:v>
                  </c:pt>
                </c:numCache>
              </c:numRef>
            </c:plus>
            <c:minus>
              <c:numRef>
                <c:f>'hsa-piR-33036'!$D$14:$F$14</c:f>
                <c:numCache>
                  <c:formatCode>General</c:formatCode>
                  <c:ptCount val="3"/>
                  <c:pt idx="0">
                    <c:v>703.6619925125766</c:v>
                  </c:pt>
                  <c:pt idx="1">
                    <c:v>388.25756306603114</c:v>
                  </c:pt>
                  <c:pt idx="2">
                    <c:v>152.615892662980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3036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36'!$D$12:$F$12</c:f>
              <c:numCache>
                <c:formatCode>General</c:formatCode>
                <c:ptCount val="3"/>
                <c:pt idx="0">
                  <c:v>3172.9735709024676</c:v>
                </c:pt>
                <c:pt idx="1">
                  <c:v>3808.7795200439264</c:v>
                </c:pt>
                <c:pt idx="2">
                  <c:v>4239.403122551885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0E3-49B0-A86D-CB986AF630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4459904"/>
        <c:axId val="214461440"/>
      </c:barChart>
      <c:catAx>
        <c:axId val="21445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461440"/>
        <c:crosses val="autoZero"/>
        <c:auto val="1"/>
        <c:lblAlgn val="ctr"/>
        <c:lblOffset val="100"/>
        <c:noMultiLvlLbl val="0"/>
      </c:catAx>
      <c:valAx>
        <c:axId val="214461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45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41'!$D$17</c:f>
          <c:strCache>
            <c:ptCount val="1"/>
            <c:pt idx="0">
              <c:v>hsa-piR-33041</c:v>
            </c:pt>
          </c:strCache>
        </c:strRef>
      </c:tx>
      <c:layout>
        <c:manualLayout>
          <c:xMode val="edge"/>
          <c:yMode val="edge"/>
          <c:x val="0.35190556834829129"/>
          <c:y val="4.30816861561354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0803614728253862"/>
          <c:y val="0.16961347686884531"/>
          <c:w val="0.84658648157116789"/>
          <c:h val="0.49975713041774072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4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3,'hsa-piR-33041'!$F$3)</c:f>
              <c:numCache>
                <c:formatCode>General</c:formatCode>
                <c:ptCount val="2"/>
                <c:pt idx="0">
                  <c:v>64.279618966160712</c:v>
                </c:pt>
                <c:pt idx="1">
                  <c:v>79.3408605431797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148-43DE-9154-C5145CA1A354}"/>
            </c:ext>
          </c:extLst>
        </c:ser>
        <c:ser>
          <c:idx val="1"/>
          <c:order val="1"/>
          <c:tx>
            <c:strRef>
              <c:f>'hsa-piR-3304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4,'hsa-piR-33041'!$F$4)</c:f>
              <c:numCache>
                <c:formatCode>General</c:formatCode>
                <c:ptCount val="2"/>
                <c:pt idx="0">
                  <c:v>69.001665328653601</c:v>
                </c:pt>
                <c:pt idx="1">
                  <c:v>49.775431772931427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148-43DE-9154-C5145CA1A354}"/>
            </c:ext>
          </c:extLst>
        </c:ser>
        <c:ser>
          <c:idx val="2"/>
          <c:order val="2"/>
          <c:tx>
            <c:strRef>
              <c:f>'hsa-piR-3304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5,'hsa-piR-33041'!$F$5)</c:f>
              <c:numCache>
                <c:formatCode>General</c:formatCode>
                <c:ptCount val="2"/>
                <c:pt idx="0">
                  <c:v>80.848955493686532</c:v>
                </c:pt>
                <c:pt idx="1">
                  <c:v>112.879868288465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148-43DE-9154-C5145CA1A354}"/>
            </c:ext>
          </c:extLst>
        </c:ser>
        <c:ser>
          <c:idx val="3"/>
          <c:order val="3"/>
          <c:tx>
            <c:strRef>
              <c:f>'hsa-piR-3304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6,'hsa-piR-33041'!$F$6)</c:f>
              <c:numCache>
                <c:formatCode>General</c:formatCode>
                <c:ptCount val="2"/>
                <c:pt idx="0">
                  <c:v>87.754617441488321</c:v>
                </c:pt>
                <c:pt idx="1">
                  <c:v>94.856440321132155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B148-43DE-9154-C5145CA1A354}"/>
            </c:ext>
          </c:extLst>
        </c:ser>
        <c:ser>
          <c:idx val="4"/>
          <c:order val="4"/>
          <c:tx>
            <c:strRef>
              <c:f>'hsa-piR-3304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41'!$D$7</c:f>
              <c:numCache>
                <c:formatCode>General</c:formatCode>
                <c:ptCount val="1"/>
                <c:pt idx="0">
                  <c:v>90.89871192889249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B148-43DE-9154-C5145CA1A354}"/>
            </c:ext>
          </c:extLst>
        </c:ser>
        <c:ser>
          <c:idx val="5"/>
          <c:order val="5"/>
          <c:tx>
            <c:strRef>
              <c:f>'hsa-piR-3304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8,'hsa-piR-33041'!$F$8)</c:f>
              <c:numCache>
                <c:formatCode>General</c:formatCode>
                <c:ptCount val="2"/>
                <c:pt idx="0">
                  <c:v>54.114741913111629</c:v>
                </c:pt>
                <c:pt idx="1">
                  <c:v>61.79560873538147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B148-43DE-9154-C5145CA1A354}"/>
            </c:ext>
          </c:extLst>
        </c:ser>
        <c:ser>
          <c:idx val="6"/>
          <c:order val="6"/>
          <c:tx>
            <c:strRef>
              <c:f>'hsa-piR-3304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41'!$D$9,'hsa-piR-33041'!$F$9)</c:f>
              <c:numCache>
                <c:formatCode>General</c:formatCode>
                <c:ptCount val="2"/>
                <c:pt idx="0">
                  <c:v>52.834114497517618</c:v>
                </c:pt>
                <c:pt idx="1">
                  <c:v>58.04652340901954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B148-43DE-9154-C5145CA1A354}"/>
            </c:ext>
          </c:extLst>
        </c:ser>
        <c:ser>
          <c:idx val="7"/>
          <c:order val="7"/>
          <c:tx>
            <c:strRef>
              <c:f>'hsa-piR-3304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3041'!$D$2,'hsa-piR-3304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41'!$D$10</c:f>
              <c:numCache>
                <c:formatCode>General</c:formatCode>
                <c:ptCount val="1"/>
                <c:pt idx="0">
                  <c:v>70.202086278364035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B148-43DE-9154-C5145CA1A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998400"/>
        <c:axId val="215000960"/>
      </c:lineChart>
      <c:catAx>
        <c:axId val="214998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414660496383613"/>
              <c:y val="0.6871839780499482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000960"/>
        <c:crosses val="autoZero"/>
        <c:auto val="1"/>
        <c:lblAlgn val="ctr"/>
        <c:lblOffset val="100"/>
        <c:noMultiLvlLbl val="0"/>
      </c:catAx>
      <c:valAx>
        <c:axId val="2150009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998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5.8309759512925732E-2"/>
          <c:y val="0.75991982078755249"/>
          <c:w val="0.91638220544418014"/>
          <c:h val="0.2134850916776854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41'!$D$17</c:f>
          <c:strCache>
            <c:ptCount val="1"/>
            <c:pt idx="0">
              <c:v>hsa-piR-3304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794348186506111"/>
          <c:y val="0.18335387463862282"/>
          <c:w val="0.81633749735323835"/>
          <c:h val="0.48989058009763342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4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3:$F$3</c:f>
              <c:numCache>
                <c:formatCode>General</c:formatCode>
                <c:ptCount val="3"/>
                <c:pt idx="0">
                  <c:v>64.279618966160712</c:v>
                </c:pt>
                <c:pt idx="1">
                  <c:v>59.674863799774002</c:v>
                </c:pt>
                <c:pt idx="2">
                  <c:v>79.340860543179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46E-427B-8A74-3AF6DF344755}"/>
            </c:ext>
          </c:extLst>
        </c:ser>
        <c:ser>
          <c:idx val="1"/>
          <c:order val="1"/>
          <c:tx>
            <c:strRef>
              <c:f>'hsa-piR-3304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4:$F$4</c:f>
              <c:numCache>
                <c:formatCode>General</c:formatCode>
                <c:ptCount val="3"/>
                <c:pt idx="0">
                  <c:v>69.001665328653601</c:v>
                </c:pt>
                <c:pt idx="1">
                  <c:v>88.484314259205107</c:v>
                </c:pt>
                <c:pt idx="2">
                  <c:v>49.77543177293142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46E-427B-8A74-3AF6DF344755}"/>
            </c:ext>
          </c:extLst>
        </c:ser>
        <c:ser>
          <c:idx val="2"/>
          <c:order val="2"/>
          <c:tx>
            <c:strRef>
              <c:f>'hsa-piR-3304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5:$F$5</c:f>
              <c:numCache>
                <c:formatCode>General</c:formatCode>
                <c:ptCount val="3"/>
                <c:pt idx="0">
                  <c:v>80.848955493686532</c:v>
                </c:pt>
                <c:pt idx="1">
                  <c:v>102.6065629722841</c:v>
                </c:pt>
                <c:pt idx="2">
                  <c:v>112.879868288465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46E-427B-8A74-3AF6DF344755}"/>
            </c:ext>
          </c:extLst>
        </c:ser>
        <c:ser>
          <c:idx val="3"/>
          <c:order val="3"/>
          <c:tx>
            <c:strRef>
              <c:f>'hsa-piR-3304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6:$F$6</c:f>
              <c:numCache>
                <c:formatCode>General</c:formatCode>
                <c:ptCount val="3"/>
                <c:pt idx="0">
                  <c:v>87.754617441488321</c:v>
                </c:pt>
                <c:pt idx="1">
                  <c:v>107.86582747751051</c:v>
                </c:pt>
                <c:pt idx="2">
                  <c:v>94.8564403211321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46E-427B-8A74-3AF6DF344755}"/>
            </c:ext>
          </c:extLst>
        </c:ser>
        <c:ser>
          <c:idx val="4"/>
          <c:order val="4"/>
          <c:tx>
            <c:strRef>
              <c:f>'hsa-piR-3304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7</c:f>
              <c:numCache>
                <c:formatCode>General</c:formatCode>
                <c:ptCount val="1"/>
                <c:pt idx="0">
                  <c:v>90.8987119288924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46E-427B-8A74-3AF6DF344755}"/>
            </c:ext>
          </c:extLst>
        </c:ser>
        <c:ser>
          <c:idx val="5"/>
          <c:order val="5"/>
          <c:tx>
            <c:strRef>
              <c:f>'hsa-piR-3304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8:$F$8</c:f>
              <c:numCache>
                <c:formatCode>General</c:formatCode>
                <c:ptCount val="3"/>
                <c:pt idx="0">
                  <c:v>54.114741913111629</c:v>
                </c:pt>
                <c:pt idx="1">
                  <c:v>73.691153008625548</c:v>
                </c:pt>
                <c:pt idx="2">
                  <c:v>61.79560873538147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46E-427B-8A74-3AF6DF344755}"/>
            </c:ext>
          </c:extLst>
        </c:ser>
        <c:ser>
          <c:idx val="6"/>
          <c:order val="6"/>
          <c:tx>
            <c:strRef>
              <c:f>'hsa-piR-3304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9:$F$9</c:f>
              <c:numCache>
                <c:formatCode>General</c:formatCode>
                <c:ptCount val="3"/>
                <c:pt idx="0">
                  <c:v>52.834114497517618</c:v>
                </c:pt>
                <c:pt idx="1">
                  <c:v>80.380349767556368</c:v>
                </c:pt>
                <c:pt idx="2">
                  <c:v>58.04652340901954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346E-427B-8A74-3AF6DF344755}"/>
            </c:ext>
          </c:extLst>
        </c:ser>
        <c:ser>
          <c:idx val="7"/>
          <c:order val="7"/>
          <c:tx>
            <c:strRef>
              <c:f>'hsa-piR-3304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10</c:f>
              <c:numCache>
                <c:formatCode>General</c:formatCode>
                <c:ptCount val="1"/>
                <c:pt idx="0">
                  <c:v>70.20208627836403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346E-427B-8A74-3AF6DF3447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4769024"/>
        <c:axId val="214771584"/>
      </c:lineChart>
      <c:catAx>
        <c:axId val="2147690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360370281523787"/>
              <c:y val="0.7344377395321863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771584"/>
        <c:crosses val="autoZero"/>
        <c:auto val="1"/>
        <c:lblAlgn val="ctr"/>
        <c:lblOffset val="100"/>
        <c:noMultiLvlLbl val="0"/>
      </c:catAx>
      <c:valAx>
        <c:axId val="214771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7690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78954734478872923"/>
          <c:w val="0.97731328590816724"/>
          <c:h val="0.197554035820583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3041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3041'!$D$14:$F$14</c:f>
                <c:numCache>
                  <c:formatCode>General</c:formatCode>
                  <c:ptCount val="3"/>
                  <c:pt idx="0">
                    <c:v>14.333352414665978</c:v>
                  </c:pt>
                  <c:pt idx="1">
                    <c:v>18.079565913821163</c:v>
                  </c:pt>
                  <c:pt idx="2">
                    <c:v>24.242899847112454</c:v>
                  </c:pt>
                </c:numCache>
              </c:numRef>
            </c:plus>
            <c:minus>
              <c:numRef>
                <c:f>'hsa-piR-33041'!$D$14:$F$14</c:f>
                <c:numCache>
                  <c:formatCode>General</c:formatCode>
                  <c:ptCount val="3"/>
                  <c:pt idx="0">
                    <c:v>14.333352414665978</c:v>
                  </c:pt>
                  <c:pt idx="1">
                    <c:v>18.079565913821163</c:v>
                  </c:pt>
                  <c:pt idx="2">
                    <c:v>24.242899847112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304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41'!$D$12:$F$12</c:f>
              <c:numCache>
                <c:formatCode>General</c:formatCode>
                <c:ptCount val="3"/>
                <c:pt idx="0">
                  <c:v>71.241813980984375</c:v>
                </c:pt>
                <c:pt idx="1">
                  <c:v>85.450511880825943</c:v>
                </c:pt>
                <c:pt idx="2">
                  <c:v>76.1157888450183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6EB-42B9-84F5-096C9466B6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4822272"/>
        <c:axId val="214828160"/>
      </c:barChart>
      <c:catAx>
        <c:axId val="214822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828160"/>
        <c:crosses val="autoZero"/>
        <c:auto val="1"/>
        <c:lblAlgn val="ctr"/>
        <c:lblOffset val="100"/>
        <c:noMultiLvlLbl val="0"/>
      </c:catAx>
      <c:valAx>
        <c:axId val="214828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4822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74'!$D$17</c:f>
          <c:strCache>
            <c:ptCount val="1"/>
            <c:pt idx="0">
              <c:v>hsa-piR-33074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209980298597338"/>
          <c:y val="0.1858952551477171"/>
          <c:w val="0.81218116127005324"/>
          <c:h val="0.50039341490102451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74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3,'hsa-piR-33074'!$F$3)</c:f>
              <c:numCache>
                <c:formatCode>General</c:formatCode>
                <c:ptCount val="2"/>
                <c:pt idx="0">
                  <c:v>75.430165113351862</c:v>
                </c:pt>
                <c:pt idx="1">
                  <c:v>97.65028989929811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D279-4C71-9A2E-7AC3C99A02A2}"/>
            </c:ext>
          </c:extLst>
        </c:ser>
        <c:ser>
          <c:idx val="1"/>
          <c:order val="1"/>
          <c:tx>
            <c:strRef>
              <c:f>'hsa-piR-33074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4,'hsa-piR-33074'!$F$4)</c:f>
              <c:numCache>
                <c:formatCode>General</c:formatCode>
                <c:ptCount val="2"/>
                <c:pt idx="0">
                  <c:v>45.116473484119659</c:v>
                </c:pt>
                <c:pt idx="1">
                  <c:v>96.07815900356531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279-4C71-9A2E-7AC3C99A02A2}"/>
            </c:ext>
          </c:extLst>
        </c:ser>
        <c:ser>
          <c:idx val="2"/>
          <c:order val="2"/>
          <c:tx>
            <c:strRef>
              <c:f>'hsa-piR-33074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5,'hsa-piR-33074'!$F$5)</c:f>
              <c:numCache>
                <c:formatCode>General</c:formatCode>
                <c:ptCount val="2"/>
                <c:pt idx="0">
                  <c:v>113.3267410338854</c:v>
                </c:pt>
                <c:pt idx="1">
                  <c:v>122.9748158589791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279-4C71-9A2E-7AC3C99A02A2}"/>
            </c:ext>
          </c:extLst>
        </c:ser>
        <c:ser>
          <c:idx val="3"/>
          <c:order val="3"/>
          <c:tx>
            <c:strRef>
              <c:f>'hsa-piR-33074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6,'hsa-piR-33074'!$F$6)</c:f>
              <c:numCache>
                <c:formatCode>General</c:formatCode>
                <c:ptCount val="2"/>
                <c:pt idx="0">
                  <c:v>84.313259894763277</c:v>
                </c:pt>
                <c:pt idx="1">
                  <c:v>101.01594943289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279-4C71-9A2E-7AC3C99A02A2}"/>
            </c:ext>
          </c:extLst>
        </c:ser>
        <c:ser>
          <c:idx val="4"/>
          <c:order val="4"/>
          <c:tx>
            <c:strRef>
              <c:f>'hsa-piR-33074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74'!$D$7</c:f>
              <c:numCache>
                <c:formatCode>General</c:formatCode>
                <c:ptCount val="1"/>
                <c:pt idx="0">
                  <c:v>37.08667446698812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D279-4C71-9A2E-7AC3C99A02A2}"/>
            </c:ext>
          </c:extLst>
        </c:ser>
        <c:ser>
          <c:idx val="5"/>
          <c:order val="5"/>
          <c:tx>
            <c:strRef>
              <c:f>'hsa-piR-33074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8,'hsa-piR-33074'!$F$8)</c:f>
              <c:numCache>
                <c:formatCode>General</c:formatCode>
                <c:ptCount val="2"/>
                <c:pt idx="0">
                  <c:v>62.20085277369153</c:v>
                </c:pt>
                <c:pt idx="1">
                  <c:v>70.37833217085112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D279-4C71-9A2E-7AC3C99A02A2}"/>
            </c:ext>
          </c:extLst>
        </c:ser>
        <c:ser>
          <c:idx val="6"/>
          <c:order val="6"/>
          <c:tx>
            <c:strRef>
              <c:f>'hsa-piR-33074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074'!$D$9,'hsa-piR-33074'!$F$9)</c:f>
              <c:numCache>
                <c:formatCode>General</c:formatCode>
                <c:ptCount val="2"/>
                <c:pt idx="0">
                  <c:v>27.234079637895679</c:v>
                </c:pt>
                <c:pt idx="1">
                  <c:v>51.59690969690627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D279-4C71-9A2E-7AC3C99A02A2}"/>
            </c:ext>
          </c:extLst>
        </c:ser>
        <c:ser>
          <c:idx val="7"/>
          <c:order val="7"/>
          <c:tx>
            <c:strRef>
              <c:f>'hsa-piR-33074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3074'!$D$2,'hsa-piR-33074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074'!$D$10</c:f>
              <c:numCache>
                <c:formatCode>General</c:formatCode>
                <c:ptCount val="1"/>
                <c:pt idx="0">
                  <c:v>86.15710588708314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D279-4C71-9A2E-7AC3C99A02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5406080"/>
        <c:axId val="215293952"/>
      </c:lineChart>
      <c:catAx>
        <c:axId val="2154060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3905688534569087"/>
              <c:y val="0.7020063662588281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293952"/>
        <c:crosses val="autoZero"/>
        <c:auto val="1"/>
        <c:lblAlgn val="ctr"/>
        <c:lblOffset val="100"/>
        <c:noMultiLvlLbl val="0"/>
      </c:catAx>
      <c:valAx>
        <c:axId val="2152939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406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2.5889999410921516E-2"/>
          <c:y val="0.78124738883915257"/>
          <c:w val="0.94406339793560723"/>
          <c:h val="0.1998030438675022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074'!$D$17</c:f>
          <c:strCache>
            <c:ptCount val="1"/>
            <c:pt idx="0">
              <c:v>hsa-piR-33074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773075240594924"/>
          <c:y val="0.13788633985645857"/>
          <c:w val="0.81511566568884775"/>
          <c:h val="0.49946151519610255"/>
        </c:manualLayout>
      </c:layout>
      <c:lineChart>
        <c:grouping val="standard"/>
        <c:varyColors val="0"/>
        <c:ser>
          <c:idx val="0"/>
          <c:order val="0"/>
          <c:tx>
            <c:strRef>
              <c:f>'hsa-piR-33074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3:$F$3</c:f>
              <c:numCache>
                <c:formatCode>General</c:formatCode>
                <c:ptCount val="3"/>
                <c:pt idx="0">
                  <c:v>75.430165113351862</c:v>
                </c:pt>
                <c:pt idx="1">
                  <c:v>104.04848047140079</c:v>
                </c:pt>
                <c:pt idx="2">
                  <c:v>97.65028989929811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60A-4338-9F5B-68F63FAD54E4}"/>
            </c:ext>
          </c:extLst>
        </c:ser>
        <c:ser>
          <c:idx val="1"/>
          <c:order val="1"/>
          <c:tx>
            <c:strRef>
              <c:f>'hsa-piR-33074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4:$F$4</c:f>
              <c:numCache>
                <c:formatCode>General</c:formatCode>
                <c:ptCount val="3"/>
                <c:pt idx="0">
                  <c:v>45.116473484119659</c:v>
                </c:pt>
                <c:pt idx="1">
                  <c:v>70.787451407364088</c:v>
                </c:pt>
                <c:pt idx="2">
                  <c:v>96.07815900356531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60A-4338-9F5B-68F63FAD54E4}"/>
            </c:ext>
          </c:extLst>
        </c:ser>
        <c:ser>
          <c:idx val="2"/>
          <c:order val="2"/>
          <c:tx>
            <c:strRef>
              <c:f>'hsa-piR-33074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5:$F$5</c:f>
              <c:numCache>
                <c:formatCode>General</c:formatCode>
                <c:ptCount val="3"/>
                <c:pt idx="0">
                  <c:v>113.3267410338854</c:v>
                </c:pt>
                <c:pt idx="1">
                  <c:v>117.57002007240889</c:v>
                </c:pt>
                <c:pt idx="2">
                  <c:v>122.974815858979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60A-4338-9F5B-68F63FAD54E4}"/>
            </c:ext>
          </c:extLst>
        </c:ser>
        <c:ser>
          <c:idx val="3"/>
          <c:order val="3"/>
          <c:tx>
            <c:strRef>
              <c:f>'hsa-piR-33074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6:$F$6</c:f>
              <c:numCache>
                <c:formatCode>General</c:formatCode>
                <c:ptCount val="3"/>
                <c:pt idx="0">
                  <c:v>84.313259894763277</c:v>
                </c:pt>
                <c:pt idx="1">
                  <c:v>51.314811130077807</c:v>
                </c:pt>
                <c:pt idx="2">
                  <c:v>101.01594943289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60A-4338-9F5B-68F63FAD54E4}"/>
            </c:ext>
          </c:extLst>
        </c:ser>
        <c:ser>
          <c:idx val="4"/>
          <c:order val="4"/>
          <c:tx>
            <c:strRef>
              <c:f>'hsa-piR-33074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7</c:f>
              <c:numCache>
                <c:formatCode>General</c:formatCode>
                <c:ptCount val="1"/>
                <c:pt idx="0">
                  <c:v>37.08667446698812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60A-4338-9F5B-68F63FAD54E4}"/>
            </c:ext>
          </c:extLst>
        </c:ser>
        <c:ser>
          <c:idx val="5"/>
          <c:order val="5"/>
          <c:tx>
            <c:strRef>
              <c:f>'hsa-piR-33074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8:$F$8</c:f>
              <c:numCache>
                <c:formatCode>General</c:formatCode>
                <c:ptCount val="3"/>
                <c:pt idx="0">
                  <c:v>62.20085277369153</c:v>
                </c:pt>
                <c:pt idx="1">
                  <c:v>84.744825959919382</c:v>
                </c:pt>
                <c:pt idx="2">
                  <c:v>70.3783321708511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60A-4338-9F5B-68F63FAD54E4}"/>
            </c:ext>
          </c:extLst>
        </c:ser>
        <c:ser>
          <c:idx val="6"/>
          <c:order val="6"/>
          <c:tx>
            <c:strRef>
              <c:f>'hsa-piR-33074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9:$F$9</c:f>
              <c:numCache>
                <c:formatCode>General</c:formatCode>
                <c:ptCount val="3"/>
                <c:pt idx="0">
                  <c:v>27.234079637895679</c:v>
                </c:pt>
                <c:pt idx="1">
                  <c:v>42.70206081401431</c:v>
                </c:pt>
                <c:pt idx="2">
                  <c:v>51.5969096969062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60A-4338-9F5B-68F63FAD54E4}"/>
            </c:ext>
          </c:extLst>
        </c:ser>
        <c:ser>
          <c:idx val="7"/>
          <c:order val="7"/>
          <c:tx>
            <c:strRef>
              <c:f>'hsa-piR-33074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10</c:f>
              <c:numCache>
                <c:formatCode>General</c:formatCode>
                <c:ptCount val="1"/>
                <c:pt idx="0">
                  <c:v>86.15710588708314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60A-4338-9F5B-68F63FAD54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5143936"/>
        <c:axId val="215150592"/>
      </c:lineChart>
      <c:catAx>
        <c:axId val="215143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8070705316247236"/>
              <c:y val="0.698911892850720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150592"/>
        <c:crosses val="autoZero"/>
        <c:auto val="1"/>
        <c:lblAlgn val="ctr"/>
        <c:lblOffset val="100"/>
        <c:noMultiLvlLbl val="0"/>
      </c:catAx>
      <c:valAx>
        <c:axId val="2151505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baseline="0">
                    <a:effectLst/>
                  </a:rPr>
                  <a:t>normalized values</a:t>
                </a:r>
                <a:endParaRPr lang="en-US" sz="70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143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1502238690751893E-3"/>
          <c:y val="0.7778249505452286"/>
          <c:w val="0.96061661946150423"/>
          <c:h val="0.222175049454771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3074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3074'!$D$14:$F$14</c:f>
                <c:numCache>
                  <c:formatCode>General</c:formatCode>
                  <c:ptCount val="3"/>
                  <c:pt idx="0">
                    <c:v>28.930307218964884</c:v>
                  </c:pt>
                  <c:pt idx="1">
                    <c:v>29.319600404384694</c:v>
                  </c:pt>
                  <c:pt idx="2">
                    <c:v>25.155326310609937</c:v>
                  </c:pt>
                </c:numCache>
              </c:numRef>
            </c:plus>
            <c:minus>
              <c:numRef>
                <c:f>'hsa-piR-33074'!$D$14:$F$14</c:f>
                <c:numCache>
                  <c:formatCode>General</c:formatCode>
                  <c:ptCount val="3"/>
                  <c:pt idx="0">
                    <c:v>28.930307218964884</c:v>
                  </c:pt>
                  <c:pt idx="1">
                    <c:v>29.319600404384694</c:v>
                  </c:pt>
                  <c:pt idx="2">
                    <c:v>25.1553263106099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3074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074'!$D$12:$F$12</c:f>
              <c:numCache>
                <c:formatCode>General</c:formatCode>
                <c:ptCount val="3"/>
                <c:pt idx="0">
                  <c:v>66.358169036472333</c:v>
                </c:pt>
                <c:pt idx="1">
                  <c:v>78.527941642530891</c:v>
                </c:pt>
                <c:pt idx="2">
                  <c:v>89.9490760104156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5D-4415-B5C6-C07E262E6B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5176704"/>
        <c:axId val="215178240"/>
      </c:barChart>
      <c:catAx>
        <c:axId val="215176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178240"/>
        <c:crosses val="autoZero"/>
        <c:auto val="1"/>
        <c:lblAlgn val="ctr"/>
        <c:lblOffset val="100"/>
        <c:noMultiLvlLbl val="0"/>
      </c:catAx>
      <c:valAx>
        <c:axId val="215178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176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33151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33151'!$D$14:$F$14</c:f>
                <c:numCache>
                  <c:formatCode>General</c:formatCode>
                  <c:ptCount val="3"/>
                  <c:pt idx="0">
                    <c:v>1.3202973735924557</c:v>
                  </c:pt>
                  <c:pt idx="1">
                    <c:v>2.9354965080664361</c:v>
                  </c:pt>
                  <c:pt idx="2">
                    <c:v>0.40223562331426921</c:v>
                  </c:pt>
                </c:numCache>
              </c:numRef>
            </c:plus>
            <c:minus>
              <c:numRef>
                <c:f>'hsa-piR-33151'!$D$14:$F$14</c:f>
                <c:numCache>
                  <c:formatCode>General</c:formatCode>
                  <c:ptCount val="3"/>
                  <c:pt idx="0">
                    <c:v>1.3202973735924557</c:v>
                  </c:pt>
                  <c:pt idx="1">
                    <c:v>2.9354965080664361</c:v>
                  </c:pt>
                  <c:pt idx="2">
                    <c:v>0.402235623314269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12:$F$12</c:f>
              <c:numCache>
                <c:formatCode>General</c:formatCode>
                <c:ptCount val="3"/>
                <c:pt idx="0">
                  <c:v>1.4355812811493043</c:v>
                </c:pt>
                <c:pt idx="1">
                  <c:v>1.7436366433729413</c:v>
                </c:pt>
                <c:pt idx="2">
                  <c:v>0.250675170948886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63D-4BAA-958F-21F199BA06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5257088"/>
        <c:axId val="215258624"/>
      </c:barChart>
      <c:catAx>
        <c:axId val="215257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258624"/>
        <c:crosses val="autoZero"/>
        <c:auto val="1"/>
        <c:lblAlgn val="ctr"/>
        <c:lblOffset val="100"/>
        <c:noMultiLvlLbl val="0"/>
      </c:catAx>
      <c:valAx>
        <c:axId val="215258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257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151'!$D$17</c:f>
          <c:strCache>
            <c:ptCount val="1"/>
            <c:pt idx="0">
              <c:v>hsa-piR-3315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15000514641552"/>
          <c:y val="0.18549995093558896"/>
          <c:w val="0.81356530801296878"/>
          <c:h val="0.46434558607824317"/>
        </c:manualLayout>
      </c:layout>
      <c:lineChart>
        <c:grouping val="standard"/>
        <c:varyColors val="0"/>
        <c:ser>
          <c:idx val="0"/>
          <c:order val="0"/>
          <c:tx>
            <c:strRef>
              <c:f>'hsa-piR-3315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3:$F$3</c:f>
              <c:numCache>
                <c:formatCode>General</c:formatCode>
                <c:ptCount val="3"/>
                <c:pt idx="0">
                  <c:v>2.623657916986152</c:v>
                </c:pt>
                <c:pt idx="1">
                  <c:v>7.6506235640735909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DC4-4357-8830-F47C9A1F4679}"/>
            </c:ext>
          </c:extLst>
        </c:ser>
        <c:ser>
          <c:idx val="1"/>
          <c:order val="1"/>
          <c:tx>
            <c:strRef>
              <c:f>'hsa-piR-3315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4:$F$4</c:f>
              <c:numCache>
                <c:formatCode>General</c:formatCode>
                <c:ptCount val="3"/>
                <c:pt idx="0">
                  <c:v>2.6539102049482159</c:v>
                </c:pt>
                <c:pt idx="1">
                  <c:v>0.84270775484957239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DC4-4357-8830-F47C9A1F4679}"/>
            </c:ext>
          </c:extLst>
        </c:ser>
        <c:ser>
          <c:idx val="2"/>
          <c:order val="2"/>
          <c:tx>
            <c:strRef>
              <c:f>'hsa-piR-3315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5:$F$5</c:f>
              <c:numCache>
                <c:formatCode>General</c:formatCode>
                <c:ptCount val="3"/>
                <c:pt idx="0">
                  <c:v>1.382033427242505</c:v>
                </c:pt>
                <c:pt idx="1">
                  <c:v>0.71254557619641745</c:v>
                </c:pt>
                <c:pt idx="2">
                  <c:v>0.9177225064102916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DC4-4357-8830-F47C9A1F4679}"/>
            </c:ext>
          </c:extLst>
        </c:ser>
        <c:ser>
          <c:idx val="3"/>
          <c:order val="3"/>
          <c:tx>
            <c:strRef>
              <c:f>'hsa-piR-3315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6:$F$6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DC4-4357-8830-F47C9A1F4679}"/>
            </c:ext>
          </c:extLst>
        </c:ser>
        <c:ser>
          <c:idx val="4"/>
          <c:order val="4"/>
          <c:tx>
            <c:strRef>
              <c:f>'hsa-piR-3315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DC4-4357-8830-F47C9A1F4679}"/>
            </c:ext>
          </c:extLst>
        </c:ser>
        <c:ser>
          <c:idx val="5"/>
          <c:order val="5"/>
          <c:tx>
            <c:strRef>
              <c:f>'hsa-piR-3315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8:$F$8</c:f>
              <c:numCache>
                <c:formatCode>General</c:formatCode>
                <c:ptCount val="3"/>
                <c:pt idx="0">
                  <c:v>0</c:v>
                </c:pt>
                <c:pt idx="1">
                  <c:v>0</c:v>
                </c:pt>
                <c:pt idx="2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ADC4-4357-8830-F47C9A1F4679}"/>
            </c:ext>
          </c:extLst>
        </c:ser>
        <c:ser>
          <c:idx val="6"/>
          <c:order val="6"/>
          <c:tx>
            <c:strRef>
              <c:f>'hsa-piR-3315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9:$F$9</c:f>
              <c:numCache>
                <c:formatCode>General</c:formatCode>
                <c:ptCount val="3"/>
                <c:pt idx="0">
                  <c:v>1.6340447782737411</c:v>
                </c:pt>
                <c:pt idx="1">
                  <c:v>1.255942965118068</c:v>
                </c:pt>
                <c:pt idx="2">
                  <c:v>0.5863285192830257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ADC4-4357-8830-F47C9A1F4679}"/>
            </c:ext>
          </c:extLst>
        </c:ser>
        <c:ser>
          <c:idx val="7"/>
          <c:order val="7"/>
          <c:tx>
            <c:strRef>
              <c:f>'hsa-piR-3315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33151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33151'!$D$10</c:f>
              <c:numCache>
                <c:formatCode>General</c:formatCode>
                <c:ptCount val="1"/>
                <c:pt idx="0">
                  <c:v>3.191003921743820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ADC4-4357-8830-F47C9A1F46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5783296"/>
        <c:axId val="215798144"/>
      </c:lineChart>
      <c:catAx>
        <c:axId val="215783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5736130410169318"/>
              <c:y val="0.7182798582629347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798144"/>
        <c:crosses val="autoZero"/>
        <c:auto val="1"/>
        <c:lblAlgn val="ctr"/>
        <c:lblOffset val="100"/>
        <c:noMultiLvlLbl val="0"/>
      </c:catAx>
      <c:valAx>
        <c:axId val="21579814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7832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4024239617106683E-2"/>
          <c:y val="0.78708408920783324"/>
          <c:w val="0.92786623179455507"/>
          <c:h val="0.212915910792166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33151'!$D$17</c:f>
          <c:strCache>
            <c:ptCount val="1"/>
            <c:pt idx="0">
              <c:v>hsa-piR-33151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250590714814015"/>
          <c:y val="0.17948378590806519"/>
          <c:w val="0.8292218927746251"/>
          <c:h val="0.48993585355340896"/>
        </c:manualLayout>
      </c:layout>
      <c:lineChart>
        <c:grouping val="standard"/>
        <c:varyColors val="0"/>
        <c:ser>
          <c:idx val="0"/>
          <c:order val="0"/>
          <c:tx>
            <c:strRef>
              <c:f>'hsa-piR-33151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3,'hsa-piR-33151'!$F$3)</c:f>
              <c:numCache>
                <c:formatCode>General</c:formatCode>
                <c:ptCount val="2"/>
                <c:pt idx="0">
                  <c:v>2.623657916986152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DC0-4F42-87E0-03C42FC14CB8}"/>
            </c:ext>
          </c:extLst>
        </c:ser>
        <c:ser>
          <c:idx val="1"/>
          <c:order val="1"/>
          <c:tx>
            <c:strRef>
              <c:f>'hsa-piR-33151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4,'hsa-piR-33151'!$F$4)</c:f>
              <c:numCache>
                <c:formatCode>General</c:formatCode>
                <c:ptCount val="2"/>
                <c:pt idx="0">
                  <c:v>2.6539102049482159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DC0-4F42-87E0-03C42FC14CB8}"/>
            </c:ext>
          </c:extLst>
        </c:ser>
        <c:ser>
          <c:idx val="2"/>
          <c:order val="2"/>
          <c:tx>
            <c:strRef>
              <c:f>'hsa-piR-33151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5,'hsa-piR-33151'!$F$5)</c:f>
              <c:numCache>
                <c:formatCode>General</c:formatCode>
                <c:ptCount val="2"/>
                <c:pt idx="0">
                  <c:v>1.382033427242505</c:v>
                </c:pt>
                <c:pt idx="1">
                  <c:v>0.9177225064102916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DC0-4F42-87E0-03C42FC14CB8}"/>
            </c:ext>
          </c:extLst>
        </c:ser>
        <c:ser>
          <c:idx val="3"/>
          <c:order val="3"/>
          <c:tx>
            <c:strRef>
              <c:f>'hsa-piR-33151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6,'hsa-piR-33151'!$F$6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DC0-4F42-87E0-03C42FC14CB8}"/>
            </c:ext>
          </c:extLst>
        </c:ser>
        <c:ser>
          <c:idx val="4"/>
          <c:order val="4"/>
          <c:tx>
            <c:strRef>
              <c:f>'hsa-piR-33151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151'!$D$7</c:f>
              <c:numCache>
                <c:formatCode>General</c:formatCode>
                <c:ptCount val="1"/>
                <c:pt idx="0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DC0-4F42-87E0-03C42FC14CB8}"/>
            </c:ext>
          </c:extLst>
        </c:ser>
        <c:ser>
          <c:idx val="5"/>
          <c:order val="5"/>
          <c:tx>
            <c:strRef>
              <c:f>'hsa-piR-33151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8,'hsa-piR-33151'!$F$8)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DC0-4F42-87E0-03C42FC14CB8}"/>
            </c:ext>
          </c:extLst>
        </c:ser>
        <c:ser>
          <c:idx val="6"/>
          <c:order val="6"/>
          <c:tx>
            <c:strRef>
              <c:f>'hsa-piR-33151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33151'!$D$9,'hsa-piR-33151'!$F$9)</c:f>
              <c:numCache>
                <c:formatCode>General</c:formatCode>
                <c:ptCount val="2"/>
                <c:pt idx="0">
                  <c:v>1.6340447782737411</c:v>
                </c:pt>
                <c:pt idx="1">
                  <c:v>0.5863285192830257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EDC0-4F42-87E0-03C42FC14CB8}"/>
            </c:ext>
          </c:extLst>
        </c:ser>
        <c:ser>
          <c:idx val="7"/>
          <c:order val="7"/>
          <c:tx>
            <c:strRef>
              <c:f>'hsa-piR-33151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33151'!$D$2,'hsa-piR-33151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33151'!$D$10</c:f>
              <c:numCache>
                <c:formatCode>General</c:formatCode>
                <c:ptCount val="1"/>
                <c:pt idx="0">
                  <c:v>3.1910039217438202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EDC0-4F42-87E0-03C42FC14C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5648128"/>
        <c:axId val="215662976"/>
      </c:lineChart>
      <c:catAx>
        <c:axId val="2156481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300534752357951"/>
              <c:y val="0.6795552851094037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662976"/>
        <c:crosses val="autoZero"/>
        <c:auto val="1"/>
        <c:lblAlgn val="ctr"/>
        <c:lblOffset val="100"/>
        <c:noMultiLvlLbl val="0"/>
      </c:catAx>
      <c:valAx>
        <c:axId val="215662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5648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3.0046275387646371E-2"/>
          <c:y val="0.74242793032631016"/>
          <c:w val="0.9648447778192315"/>
          <c:h val="0.231302958849927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11119'!$D$17</c:f>
          <c:strCache>
            <c:ptCount val="1"/>
            <c:pt idx="0">
              <c:v>hsa-piR-11119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0643507386550426"/>
          <c:y val="0.15662701154843514"/>
          <c:w val="0.86021994610098107"/>
          <c:h val="0.54182980036671047"/>
        </c:manualLayout>
      </c:layout>
      <c:lineChart>
        <c:grouping val="standard"/>
        <c:varyColors val="0"/>
        <c:ser>
          <c:idx val="0"/>
          <c:order val="0"/>
          <c:tx>
            <c:strRef>
              <c:f>'hsa-piR-11119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3,'hsa-piR-11119'!$F$3)</c:f>
              <c:numCache>
                <c:formatCode>General</c:formatCode>
                <c:ptCount val="2"/>
                <c:pt idx="0">
                  <c:v>45.91401354725766</c:v>
                </c:pt>
                <c:pt idx="1">
                  <c:v>51.87671650900213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C01-4302-A463-13BEC37A27D4}"/>
            </c:ext>
          </c:extLst>
        </c:ser>
        <c:ser>
          <c:idx val="1"/>
          <c:order val="1"/>
          <c:tx>
            <c:strRef>
              <c:f>'hsa-piR-11119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4,'hsa-piR-11119'!$F$4)</c:f>
              <c:numCache>
                <c:formatCode>General</c:formatCode>
                <c:ptCount val="2"/>
                <c:pt idx="0">
                  <c:v>27.866057151956259</c:v>
                </c:pt>
                <c:pt idx="1">
                  <c:v>31.2543408806778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C01-4302-A463-13BEC37A27D4}"/>
            </c:ext>
          </c:extLst>
        </c:ser>
        <c:ser>
          <c:idx val="2"/>
          <c:order val="2"/>
          <c:tx>
            <c:strRef>
              <c:f>'hsa-piR-11119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5,'hsa-piR-11119'!$F$5)</c:f>
              <c:numCache>
                <c:formatCode>General</c:formatCode>
                <c:ptCount val="2"/>
                <c:pt idx="0">
                  <c:v>47.680153239866407</c:v>
                </c:pt>
                <c:pt idx="1">
                  <c:v>40.379790282052831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2C01-4302-A463-13BEC37A27D4}"/>
            </c:ext>
          </c:extLst>
        </c:ser>
        <c:ser>
          <c:idx val="3"/>
          <c:order val="3"/>
          <c:tx>
            <c:strRef>
              <c:f>'hsa-piR-11119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6,'hsa-piR-11119'!$F$6)</c:f>
              <c:numCache>
                <c:formatCode>General</c:formatCode>
                <c:ptCount val="2"/>
                <c:pt idx="0">
                  <c:v>55.061720747600511</c:v>
                </c:pt>
                <c:pt idx="1">
                  <c:v>56.66748382820882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2C01-4302-A463-13BEC37A27D4}"/>
            </c:ext>
          </c:extLst>
        </c:ser>
        <c:ser>
          <c:idx val="4"/>
          <c:order val="4"/>
          <c:tx>
            <c:strRef>
              <c:f>'hsa-piR-11119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11119'!$D$7</c:f>
              <c:numCache>
                <c:formatCode>General</c:formatCode>
                <c:ptCount val="1"/>
                <c:pt idx="0">
                  <c:v>33.450725989832428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2C01-4302-A463-13BEC37A27D4}"/>
            </c:ext>
          </c:extLst>
        </c:ser>
        <c:ser>
          <c:idx val="5"/>
          <c:order val="5"/>
          <c:tx>
            <c:strRef>
              <c:f>'hsa-piR-11119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8,'hsa-piR-11119'!$F$8)</c:f>
              <c:numCache>
                <c:formatCode>General</c:formatCode>
                <c:ptCount val="2"/>
                <c:pt idx="0">
                  <c:v>49.760682218953221</c:v>
                </c:pt>
                <c:pt idx="1">
                  <c:v>36.047438428972526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2C01-4302-A463-13BEC37A27D4}"/>
            </c:ext>
          </c:extLst>
        </c:ser>
        <c:ser>
          <c:idx val="6"/>
          <c:order val="6"/>
          <c:tx>
            <c:strRef>
              <c:f>'hsa-piR-11119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1119'!$D$9,'hsa-piR-11119'!$F$9)</c:f>
              <c:numCache>
                <c:formatCode>General</c:formatCode>
                <c:ptCount val="2"/>
                <c:pt idx="0">
                  <c:v>41.395801049601417</c:v>
                </c:pt>
                <c:pt idx="1">
                  <c:v>60.68500174579317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2C01-4302-A463-13BEC37A27D4}"/>
            </c:ext>
          </c:extLst>
        </c:ser>
        <c:ser>
          <c:idx val="7"/>
          <c:order val="7"/>
          <c:tx>
            <c:strRef>
              <c:f>'hsa-piR-11119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('hsa-piR-11119'!$D$2,'hsa-piR-11119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'hsa-piR-11119'!$D$10</c:f>
              <c:numCache>
                <c:formatCode>General</c:formatCode>
                <c:ptCount val="1"/>
                <c:pt idx="0">
                  <c:v>73.39309020010786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2C01-4302-A463-13BEC37A27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261696"/>
        <c:axId val="211268352"/>
      </c:lineChart>
      <c:catAx>
        <c:axId val="2112616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3710532092099308"/>
              <c:y val="0.7447658041169077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268352"/>
        <c:crosses val="autoZero"/>
        <c:auto val="1"/>
        <c:lblAlgn val="ctr"/>
        <c:lblOffset val="100"/>
        <c:noMultiLvlLbl val="0"/>
      </c:catAx>
      <c:valAx>
        <c:axId val="211268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2616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0.80217504876361301"/>
          <c:w val="1"/>
          <c:h val="0.197824951236387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11119'!$D$17</c:f>
          <c:strCache>
            <c:ptCount val="1"/>
            <c:pt idx="0">
              <c:v>hsa-piR-11119</c:v>
            </c:pt>
          </c:strCache>
        </c:strRef>
      </c:tx>
      <c:layout>
        <c:manualLayout>
          <c:xMode val="edge"/>
          <c:yMode val="edge"/>
          <c:x val="0.36878055684215943"/>
          <c:y val="1.97360446480094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780299521383357"/>
          <c:y val="0.14482582620900855"/>
          <c:w val="0.79275256034172203"/>
          <c:h val="0.54010622687252774"/>
        </c:manualLayout>
      </c:layout>
      <c:lineChart>
        <c:grouping val="standard"/>
        <c:varyColors val="0"/>
        <c:ser>
          <c:idx val="0"/>
          <c:order val="0"/>
          <c:tx>
            <c:strRef>
              <c:f>'hsa-piR-11119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3:$F$3</c:f>
              <c:numCache>
                <c:formatCode>General</c:formatCode>
                <c:ptCount val="3"/>
                <c:pt idx="0">
                  <c:v>45.91401354725766</c:v>
                </c:pt>
                <c:pt idx="1">
                  <c:v>68.855612076662311</c:v>
                </c:pt>
                <c:pt idx="2">
                  <c:v>51.87671650900213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792-41AD-A620-049450BB744A}"/>
            </c:ext>
          </c:extLst>
        </c:ser>
        <c:ser>
          <c:idx val="1"/>
          <c:order val="1"/>
          <c:tx>
            <c:strRef>
              <c:f>'hsa-piR-11119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4:$F$4</c:f>
              <c:numCache>
                <c:formatCode>General</c:formatCode>
                <c:ptCount val="3"/>
                <c:pt idx="0">
                  <c:v>27.866057151956259</c:v>
                </c:pt>
                <c:pt idx="1">
                  <c:v>42.135387742478621</c:v>
                </c:pt>
                <c:pt idx="2">
                  <c:v>31.2543408806778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792-41AD-A620-049450BB744A}"/>
            </c:ext>
          </c:extLst>
        </c:ser>
        <c:ser>
          <c:idx val="2"/>
          <c:order val="2"/>
          <c:tx>
            <c:strRef>
              <c:f>'hsa-piR-11119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5:$F$5</c:f>
              <c:numCache>
                <c:formatCode>General</c:formatCode>
                <c:ptCount val="3"/>
                <c:pt idx="0">
                  <c:v>47.680153239866407</c:v>
                </c:pt>
                <c:pt idx="1">
                  <c:v>62.704010705284738</c:v>
                </c:pt>
                <c:pt idx="2">
                  <c:v>40.37979028205283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792-41AD-A620-049450BB744A}"/>
            </c:ext>
          </c:extLst>
        </c:ser>
        <c:ser>
          <c:idx val="3"/>
          <c:order val="3"/>
          <c:tx>
            <c:strRef>
              <c:f>'hsa-piR-11119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58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dPt>
            <c:idx val="2"/>
            <c:bubble3D val="0"/>
            <c:spPr>
              <a:ln w="19050" cap="rnd">
                <a:solidFill>
                  <a:schemeClr val="accent4"/>
                </a:solidFill>
                <a:round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9224-41E1-8F7F-B492DB2C7142}"/>
              </c:ext>
            </c:extLst>
          </c:dPt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6:$F$6</c:f>
              <c:numCache>
                <c:formatCode>General</c:formatCode>
                <c:ptCount val="3"/>
                <c:pt idx="0">
                  <c:v>55.061720747600511</c:v>
                </c:pt>
                <c:pt idx="1">
                  <c:v>89.015488695032943</c:v>
                </c:pt>
                <c:pt idx="2">
                  <c:v>56.66748382820882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1792-41AD-A620-049450BB744A}"/>
            </c:ext>
          </c:extLst>
        </c:ser>
        <c:ser>
          <c:idx val="4"/>
          <c:order val="4"/>
          <c:tx>
            <c:strRef>
              <c:f>'hsa-piR-11119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7</c:f>
              <c:numCache>
                <c:formatCode>General</c:formatCode>
                <c:ptCount val="1"/>
                <c:pt idx="0">
                  <c:v>33.45072598983242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1792-41AD-A620-049450BB744A}"/>
            </c:ext>
          </c:extLst>
        </c:ser>
        <c:ser>
          <c:idx val="5"/>
          <c:order val="5"/>
          <c:tx>
            <c:strRef>
              <c:f>'hsa-piR-11119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8:$F$8</c:f>
              <c:numCache>
                <c:formatCode>General</c:formatCode>
                <c:ptCount val="3"/>
                <c:pt idx="0">
                  <c:v>49.760682218953221</c:v>
                </c:pt>
                <c:pt idx="1">
                  <c:v>50.355621222560792</c:v>
                </c:pt>
                <c:pt idx="2">
                  <c:v>36.04743842897252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1792-41AD-A620-049450BB744A}"/>
            </c:ext>
          </c:extLst>
        </c:ser>
        <c:ser>
          <c:idx val="6"/>
          <c:order val="6"/>
          <c:tx>
            <c:strRef>
              <c:f>'hsa-piR-11119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9:$F$9</c:f>
              <c:numCache>
                <c:formatCode>General</c:formatCode>
                <c:ptCount val="3"/>
                <c:pt idx="0">
                  <c:v>41.395801049601417</c:v>
                </c:pt>
                <c:pt idx="1">
                  <c:v>56.517433430313062</c:v>
                </c:pt>
                <c:pt idx="2">
                  <c:v>60.68500174579317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1792-41AD-A620-049450BB744A}"/>
            </c:ext>
          </c:extLst>
        </c:ser>
        <c:ser>
          <c:idx val="7"/>
          <c:order val="7"/>
          <c:tx>
            <c:strRef>
              <c:f>'hsa-piR-11119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10</c:f>
              <c:numCache>
                <c:formatCode>General</c:formatCode>
                <c:ptCount val="1"/>
                <c:pt idx="0">
                  <c:v>73.39309020010786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1792-41AD-A620-049450BB74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1454976"/>
        <c:axId val="211461632"/>
      </c:lineChart>
      <c:catAx>
        <c:axId val="211454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3611947403633372"/>
              <c:y val="0.752520595412785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461632"/>
        <c:crosses val="autoZero"/>
        <c:auto val="1"/>
        <c:lblAlgn val="ctr"/>
        <c:lblOffset val="100"/>
        <c:noMultiLvlLbl val="0"/>
      </c:catAx>
      <c:valAx>
        <c:axId val="211461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454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4357856003293704E-2"/>
          <c:y val="0.78538553097486286"/>
          <c:w val="0.95494441871236679"/>
          <c:h val="0.214614469025137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</a:t>
            </a:r>
            <a:r>
              <a:rPr lang="en-US" sz="1100" baseline="0" dirty="0"/>
              <a:t> </a:t>
            </a:r>
            <a:r>
              <a:rPr lang="en-US" sz="1100" dirty="0"/>
              <a:t>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11119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11119'!$D$14:$F$14</c:f>
                <c:numCache>
                  <c:formatCode>General</c:formatCode>
                  <c:ptCount val="3"/>
                  <c:pt idx="0">
                    <c:v>13.895911853785643</c:v>
                  </c:pt>
                  <c:pt idx="1">
                    <c:v>16.349993204366537</c:v>
                  </c:pt>
                  <c:pt idx="2">
                    <c:v>11.932449334044527</c:v>
                  </c:pt>
                </c:numCache>
              </c:numRef>
            </c:plus>
            <c:minus>
              <c:numRef>
                <c:f>'hsa-piR-11119'!$D$14:$F$14</c:f>
                <c:numCache>
                  <c:formatCode>General</c:formatCode>
                  <c:ptCount val="3"/>
                  <c:pt idx="0">
                    <c:v>13.895911853785643</c:v>
                  </c:pt>
                  <c:pt idx="1">
                    <c:v>16.349993204366537</c:v>
                  </c:pt>
                  <c:pt idx="2">
                    <c:v>11.9324493340445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11119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1119'!$D$12:$F$12</c:f>
              <c:numCache>
                <c:formatCode>General</c:formatCode>
                <c:ptCount val="3"/>
                <c:pt idx="0">
                  <c:v>46.815280518146963</c:v>
                </c:pt>
                <c:pt idx="1">
                  <c:v>61.597258978722074</c:v>
                </c:pt>
                <c:pt idx="2">
                  <c:v>46.1517952791178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9A-4376-8722-0229EFE6EE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058048"/>
        <c:axId val="211367040"/>
      </c:barChart>
      <c:catAx>
        <c:axId val="211058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367040"/>
        <c:crosses val="autoZero"/>
        <c:auto val="1"/>
        <c:lblAlgn val="ctr"/>
        <c:lblOffset val="100"/>
        <c:noMultiLvlLbl val="0"/>
      </c:catAx>
      <c:valAx>
        <c:axId val="2113670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1058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12547'!$D$17</c:f>
          <c:strCache>
            <c:ptCount val="1"/>
            <c:pt idx="0">
              <c:v>hsa-piR-12547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5359174242870513"/>
          <c:y val="0.21116144989627469"/>
          <c:w val="0.79653294585059642"/>
          <c:h val="0.49618645985599313"/>
        </c:manualLayout>
      </c:layout>
      <c:lineChart>
        <c:grouping val="standard"/>
        <c:varyColors val="0"/>
        <c:ser>
          <c:idx val="0"/>
          <c:order val="0"/>
          <c:tx>
            <c:strRef>
              <c:f>'hsa-piR-12547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('hsa-piR-12547'!$D$2,'hsa-piR-1254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2547'!$D$3,'hsa-piR-12547'!$F$3)</c:f>
              <c:numCache>
                <c:formatCode>General</c:formatCode>
                <c:ptCount val="2"/>
                <c:pt idx="0">
                  <c:v>0</c:v>
                </c:pt>
                <c:pt idx="1">
                  <c:v>3.051571559353067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085-408E-9488-A324F15F6509}"/>
            </c:ext>
          </c:extLst>
        </c:ser>
        <c:ser>
          <c:idx val="2"/>
          <c:order val="1"/>
          <c:tx>
            <c:strRef>
              <c:f>'hsa-piR-12547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('hsa-piR-12547'!$D$2,'hsa-piR-1254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2547'!$D$5,'hsa-piR-12547'!$F$5)</c:f>
              <c:numCache>
                <c:formatCode>General</c:formatCode>
                <c:ptCount val="2"/>
                <c:pt idx="0">
                  <c:v>7.6011838498337756</c:v>
                </c:pt>
                <c:pt idx="1">
                  <c:v>0.91772250641029163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085-408E-9488-A324F15F6509}"/>
            </c:ext>
          </c:extLst>
        </c:ser>
        <c:ser>
          <c:idx val="3"/>
          <c:order val="2"/>
          <c:tx>
            <c:strRef>
              <c:f>'hsa-piR-12547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('hsa-piR-12547'!$D$2,'hsa-piR-1254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2547'!$D$6,'hsa-piR-12547'!$F$6)</c:f>
              <c:numCache>
                <c:formatCode>General</c:formatCode>
                <c:ptCount val="2"/>
                <c:pt idx="0">
                  <c:v>1.720678773362516</c:v>
                </c:pt>
                <c:pt idx="1">
                  <c:v>1.2319018223523659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085-408E-9488-A324F15F6509}"/>
            </c:ext>
          </c:extLst>
        </c:ser>
        <c:ser>
          <c:idx val="5"/>
          <c:order val="3"/>
          <c:tx>
            <c:strRef>
              <c:f>'hsa-piR-12547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('hsa-piR-12547'!$D$2,'hsa-piR-1254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2547'!$D$8,'hsa-piR-12547'!$F$8)</c:f>
              <c:numCache>
                <c:formatCode>General</c:formatCode>
                <c:ptCount val="2"/>
                <c:pt idx="0">
                  <c:v>0.62200852773691517</c:v>
                </c:pt>
                <c:pt idx="1">
                  <c:v>0.57218156236464324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085-408E-9488-A324F15F6509}"/>
            </c:ext>
          </c:extLst>
        </c:ser>
        <c:ser>
          <c:idx val="6"/>
          <c:order val="4"/>
          <c:tx>
            <c:strRef>
              <c:f>'hsa-piR-12547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('hsa-piR-12547'!$D$2,'hsa-piR-12547'!$F$2)</c:f>
              <c:strCache>
                <c:ptCount val="2"/>
                <c:pt idx="0">
                  <c:v>T0</c:v>
                </c:pt>
                <c:pt idx="1">
                  <c:v>3h</c:v>
                </c:pt>
              </c:strCache>
              <c:extLst xmlns:c16r2="http://schemas.microsoft.com/office/drawing/2015/06/chart"/>
            </c:strRef>
          </c:cat>
          <c:val>
            <c:numRef>
              <c:f>('hsa-piR-12547'!$D$9,'hsa-piR-12547'!$F$9)</c:f>
              <c:numCache>
                <c:formatCode>General</c:formatCode>
                <c:ptCount val="2"/>
                <c:pt idx="0">
                  <c:v>1.089363185515827</c:v>
                </c:pt>
                <c:pt idx="1">
                  <c:v>0.8794927789245387</c:v>
                </c:pt>
              </c:numCache>
              <c:extLst xmlns:c16r2="http://schemas.microsoft.com/office/drawing/2015/06/chart"/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085-408E-9488-A324F15F65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725120"/>
        <c:axId val="210739968"/>
        <c:extLst xmlns:c16r2="http://schemas.microsoft.com/office/drawing/2015/06/chart">
          <c:ext xmlns:c15="http://schemas.microsoft.com/office/drawing/2012/chart" uri="{02D57815-91ED-43cb-92C2-25804820EDAC}">
            <c15:filteredLine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'hsa-piR-12547'!$C$4</c15:sqref>
                        </c15:formulaRef>
                      </c:ext>
                    </c:extLst>
                    <c:strCache>
                      <c:ptCount val="1"/>
                      <c:pt idx="0">
                        <c:v>normalized_IR0008</c:v>
                      </c:pt>
                    </c:strCache>
                  </c:strRef>
                </c:tx>
                <c:spPr>
                  <a:ln w="28575" cap="rnd">
                    <a:solidFill>
                      <a:schemeClr val="accent2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solidFill>
                        <a:schemeClr val="accent2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('hsa-piR-12547'!$D$2,'hsa-piR-12547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('hsa-piR-12547'!$D$4,'hsa-piR-12547'!$F$4)</c15:sqref>
                        </c15:formulaRef>
                      </c:ext>
                    </c:extLst>
                    <c:numCache>
                      <c:formatCode>General</c:formatCode>
                      <c:ptCount val="2"/>
                      <c:pt idx="0">
                        <c:v>54.405159201438423</c:v>
                      </c:pt>
                      <c:pt idx="1">
                        <c:v>2.3151363615316942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5-E085-408E-9488-A324F15F6509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12547'!$C$7</c15:sqref>
                        </c15:formulaRef>
                      </c:ext>
                    </c:extLst>
                    <c:strCache>
                      <c:ptCount val="1"/>
                      <c:pt idx="0">
                        <c:v>normalized_IR0015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hsa-piR-12547'!$D$2,'hsa-piR-12547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12547'!$D$7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23.997259949227612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E085-408E-9488-A324F15F6509}"/>
                  </c:ext>
                </c:extLst>
              </c15:ser>
            </c15:filteredLineSeries>
            <c15:filteredLineSeries>
              <c15:ser>
                <c:idx val="7"/>
                <c:order val="7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12547'!$C$10</c15:sqref>
                        </c15:formulaRef>
                      </c:ext>
                    </c:extLst>
                    <c:strCache>
                      <c:ptCount val="1"/>
                      <c:pt idx="0">
                        <c:v>normalized_IR0046</c:v>
                      </c:pt>
                    </c:strCache>
                  </c:strRef>
                </c:tx>
                <c:spPr>
                  <a:ln w="28575" cap="rnd">
                    <a:solidFill>
                      <a:schemeClr val="accent2">
                        <a:lumMod val="60000"/>
                      </a:schemeClr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2">
                        <a:lumMod val="60000"/>
                      </a:schemeClr>
                    </a:solidFill>
                    <a:ln w="9525">
                      <a:solidFill>
                        <a:schemeClr val="accent2">
                          <a:lumMod val="60000"/>
                        </a:schemeClr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('hsa-piR-12547'!$D$2,'hsa-piR-12547'!$F$2)</c15:sqref>
                        </c15:formulaRef>
                      </c:ext>
                    </c:extLst>
                    <c:strCache>
                      <c:ptCount val="2"/>
                      <c:pt idx="0">
                        <c:v>T0</c:v>
                      </c:pt>
                      <c:pt idx="1">
                        <c:v>3h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hsa-piR-12547'!$D$10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252.0893098177618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E085-408E-9488-A324F15F6509}"/>
                  </c:ext>
                </c:extLst>
              </c15:ser>
            </c15:filteredLineSeries>
          </c:ext>
        </c:extLst>
      </c:lineChart>
      <c:catAx>
        <c:axId val="210725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4272455344578188"/>
              <c:y val="0.7483317160706833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739968"/>
        <c:crosses val="autoZero"/>
        <c:auto val="1"/>
        <c:lblAlgn val="ctr"/>
        <c:lblOffset val="100"/>
        <c:noMultiLvlLbl val="0"/>
      </c:catAx>
      <c:valAx>
        <c:axId val="210739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725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4233772524070402E-2"/>
          <c:y val="0.84206497665621038"/>
          <c:w val="0.98576622747592957"/>
          <c:h val="0.142676883854015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strRef>
          <c:f>'hsa-piR-12547'!$D$17</c:f>
          <c:strCache>
            <c:ptCount val="1"/>
            <c:pt idx="0">
              <c:v>hsa-piR-12547</c:v>
            </c:pt>
          </c:strCache>
        </c:strRef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783175081056044"/>
          <c:y val="0.17957882203263803"/>
          <c:w val="0.80723360866656391"/>
          <c:h val="0.43722791068731259"/>
        </c:manualLayout>
      </c:layout>
      <c:lineChart>
        <c:grouping val="standard"/>
        <c:varyColors val="0"/>
        <c:ser>
          <c:idx val="0"/>
          <c:order val="0"/>
          <c:tx>
            <c:strRef>
              <c:f>'hsa-piR-12547'!$C$3</c:f>
              <c:strCache>
                <c:ptCount val="1"/>
                <c:pt idx="0">
                  <c:v>normalized_IR0005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3:$F$3</c:f>
              <c:numCache>
                <c:formatCode>General</c:formatCode>
                <c:ptCount val="3"/>
                <c:pt idx="0">
                  <c:v>0</c:v>
                </c:pt>
                <c:pt idx="1">
                  <c:v>1.530124712814718</c:v>
                </c:pt>
                <c:pt idx="2">
                  <c:v>3.0515715593530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8D0-4668-99AC-681C71052F94}"/>
            </c:ext>
          </c:extLst>
        </c:ser>
        <c:ser>
          <c:idx val="1"/>
          <c:order val="1"/>
          <c:tx>
            <c:strRef>
              <c:f>'hsa-piR-12547'!$C$4</c:f>
              <c:strCache>
                <c:ptCount val="1"/>
                <c:pt idx="0">
                  <c:v>normalized_IR0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4:$F$4</c:f>
              <c:numCache>
                <c:formatCode>General</c:formatCode>
                <c:ptCount val="3"/>
                <c:pt idx="0">
                  <c:v>54.405159201438423</c:v>
                </c:pt>
                <c:pt idx="1">
                  <c:v>0</c:v>
                </c:pt>
                <c:pt idx="2">
                  <c:v>2.315136361531694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8D0-4668-99AC-681C71052F94}"/>
            </c:ext>
          </c:extLst>
        </c:ser>
        <c:ser>
          <c:idx val="2"/>
          <c:order val="2"/>
          <c:tx>
            <c:strRef>
              <c:f>'hsa-piR-12547'!$C$5</c:f>
              <c:strCache>
                <c:ptCount val="1"/>
                <c:pt idx="0">
                  <c:v>normalized_IR0010</c:v>
                </c:pt>
              </c:strCache>
            </c:strRef>
          </c:tx>
          <c:spPr>
            <a:ln w="158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5:$F$5</c:f>
              <c:numCache>
                <c:formatCode>General</c:formatCode>
                <c:ptCount val="3"/>
                <c:pt idx="0">
                  <c:v>7.6011838498337756</c:v>
                </c:pt>
                <c:pt idx="1">
                  <c:v>4.2752734571785043</c:v>
                </c:pt>
                <c:pt idx="2">
                  <c:v>0.9177225064102916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8D0-4668-99AC-681C71052F94}"/>
            </c:ext>
          </c:extLst>
        </c:ser>
        <c:ser>
          <c:idx val="3"/>
          <c:order val="3"/>
          <c:tx>
            <c:strRef>
              <c:f>'hsa-piR-12547'!$C$6</c:f>
              <c:strCache>
                <c:ptCount val="1"/>
                <c:pt idx="0">
                  <c:v>normalized_IR0012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6:$F$6</c:f>
              <c:numCache>
                <c:formatCode>General</c:formatCode>
                <c:ptCount val="3"/>
                <c:pt idx="0">
                  <c:v>1.720678773362516</c:v>
                </c:pt>
                <c:pt idx="1">
                  <c:v>2.094482086941952</c:v>
                </c:pt>
                <c:pt idx="2">
                  <c:v>1.231901822352365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8D0-4668-99AC-681C71052F94}"/>
            </c:ext>
          </c:extLst>
        </c:ser>
        <c:ser>
          <c:idx val="4"/>
          <c:order val="4"/>
          <c:tx>
            <c:strRef>
              <c:f>'hsa-piR-12547'!$C$7</c:f>
              <c:strCache>
                <c:ptCount val="1"/>
                <c:pt idx="0">
                  <c:v>normalized_IR001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7</c:f>
              <c:numCache>
                <c:formatCode>General</c:formatCode>
                <c:ptCount val="1"/>
                <c:pt idx="0">
                  <c:v>23.99725994922761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8D0-4668-99AC-681C71052F94}"/>
            </c:ext>
          </c:extLst>
        </c:ser>
        <c:ser>
          <c:idx val="5"/>
          <c:order val="5"/>
          <c:tx>
            <c:strRef>
              <c:f>'hsa-piR-12547'!$C$8</c:f>
              <c:strCache>
                <c:ptCount val="1"/>
                <c:pt idx="0">
                  <c:v>normalized_IR0030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8:$F$8</c:f>
              <c:numCache>
                <c:formatCode>General</c:formatCode>
                <c:ptCount val="3"/>
                <c:pt idx="0">
                  <c:v>0.62200852773691517</c:v>
                </c:pt>
                <c:pt idx="1">
                  <c:v>0</c:v>
                </c:pt>
                <c:pt idx="2">
                  <c:v>0.5721815623646432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8D0-4668-99AC-681C71052F94}"/>
            </c:ext>
          </c:extLst>
        </c:ser>
        <c:ser>
          <c:idx val="6"/>
          <c:order val="6"/>
          <c:tx>
            <c:strRef>
              <c:f>'hsa-piR-12547'!$C$9</c:f>
              <c:strCache>
                <c:ptCount val="1"/>
                <c:pt idx="0">
                  <c:v>normalized_IR0042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9:$F$9</c:f>
              <c:numCache>
                <c:formatCode>General</c:formatCode>
                <c:ptCount val="3"/>
                <c:pt idx="0">
                  <c:v>1.089363185515827</c:v>
                </c:pt>
                <c:pt idx="1">
                  <c:v>1.8839144476771019</c:v>
                </c:pt>
                <c:pt idx="2">
                  <c:v>0.879492778924538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E8D0-4668-99AC-681C71052F94}"/>
            </c:ext>
          </c:extLst>
        </c:ser>
        <c:ser>
          <c:idx val="7"/>
          <c:order val="7"/>
          <c:tx>
            <c:strRef>
              <c:f>'hsa-piR-12547'!$C$10</c:f>
              <c:strCache>
                <c:ptCount val="1"/>
                <c:pt idx="0">
                  <c:v>normalized_IR0046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10</c:f>
              <c:numCache>
                <c:formatCode>General</c:formatCode>
                <c:ptCount val="1"/>
                <c:pt idx="0">
                  <c:v>252.089309817761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E8D0-4668-99AC-681C71052F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679680"/>
        <c:axId val="210690432"/>
      </c:lineChart>
      <c:catAx>
        <c:axId val="210679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blood sample</a:t>
                </a:r>
              </a:p>
            </c:rich>
          </c:tx>
          <c:layout>
            <c:manualLayout>
              <c:xMode val="edge"/>
              <c:yMode val="edge"/>
              <c:x val="0.46052731460038082"/>
              <c:y val="0.6767401157565481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690432"/>
        <c:crosses val="autoZero"/>
        <c:auto val="1"/>
        <c:lblAlgn val="ctr"/>
        <c:lblOffset val="100"/>
        <c:noMultiLvlLbl val="0"/>
      </c:catAx>
      <c:valAx>
        <c:axId val="210690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normalized</a:t>
                </a:r>
                <a:r>
                  <a:rPr lang="de-DE" sz="700" b="0" i="0" u="none" strike="noStrike" kern="1200" baseline="0" dirty="0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 </a:t>
                </a:r>
                <a:r>
                  <a:rPr lang="de-DE" sz="700" b="0" i="0" u="none" strike="noStrike" kern="1200" baseline="0" dirty="0" err="1">
                    <a:solidFill>
                      <a:srgbClr val="595959"/>
                    </a:solidFill>
                    <a:latin typeface="+mn-lt"/>
                    <a:ea typeface="+mn-ea"/>
                    <a:cs typeface="+mn-cs"/>
                  </a:rPr>
                  <a:t>values</a:t>
                </a:r>
                <a:endParaRPr lang="en-US" sz="700" b="0" i="0" u="none" strike="noStrike" kern="1200" baseline="0" dirty="0">
                  <a:solidFill>
                    <a:srgbClr val="595959"/>
                  </a:solidFill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679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9.5144356955380593E-3"/>
          <c:y val="0.781247280039431"/>
          <c:w val="0.97688583963769238"/>
          <c:h val="0.180853566524205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/>
              <a:t>average normalized</a:t>
            </a:r>
          </a:p>
        </c:rich>
      </c:tx>
      <c:layout>
        <c:manualLayout>
          <c:xMode val="edge"/>
          <c:yMode val="edge"/>
          <c:x val="0.30738141831011973"/>
          <c:y val="2.3238926971519507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a-piR-12547'!$C$12</c:f>
              <c:strCache>
                <c:ptCount val="1"/>
                <c:pt idx="0">
                  <c:v>Durchschnitt_normaliz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a-piR-12547'!$D$14:$F$14</c:f>
                <c:numCache>
                  <c:formatCode>General</c:formatCode>
                  <c:ptCount val="3"/>
                  <c:pt idx="0">
                    <c:v>86.657956295565583</c:v>
                  </c:pt>
                  <c:pt idx="1">
                    <c:v>1.5875427863278977</c:v>
                  </c:pt>
                  <c:pt idx="2">
                    <c:v>0.97246603769343642</c:v>
                  </c:pt>
                </c:numCache>
              </c:numRef>
            </c:plus>
            <c:minus>
              <c:numRef>
                <c:f>'hsa-piR-12547'!$D$14:$F$14</c:f>
                <c:numCache>
                  <c:formatCode>General</c:formatCode>
                  <c:ptCount val="3"/>
                  <c:pt idx="0">
                    <c:v>86.657956295565583</c:v>
                  </c:pt>
                  <c:pt idx="1">
                    <c:v>1.5875427863278977</c:v>
                  </c:pt>
                  <c:pt idx="2">
                    <c:v>0.972466037693436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hsa-piR-12547'!$D$2:$F$2</c:f>
              <c:strCache>
                <c:ptCount val="3"/>
                <c:pt idx="0">
                  <c:v>T0</c:v>
                </c:pt>
                <c:pt idx="1">
                  <c:v>direct</c:v>
                </c:pt>
                <c:pt idx="2">
                  <c:v>3h</c:v>
                </c:pt>
              </c:strCache>
            </c:strRef>
          </c:cat>
          <c:val>
            <c:numRef>
              <c:f>'hsa-piR-12547'!$D$12:$F$12</c:f>
              <c:numCache>
                <c:formatCode>General</c:formatCode>
                <c:ptCount val="3"/>
                <c:pt idx="0">
                  <c:v>42.690620413109606</c:v>
                </c:pt>
                <c:pt idx="1">
                  <c:v>1.6306324507687127</c:v>
                </c:pt>
                <c:pt idx="2">
                  <c:v>1.49466776515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3C1-458F-8053-01E109845F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0782080"/>
        <c:axId val="210783616"/>
      </c:barChart>
      <c:catAx>
        <c:axId val="21078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783616"/>
        <c:crosses val="autoZero"/>
        <c:auto val="1"/>
        <c:lblAlgn val="ctr"/>
        <c:lblOffset val="100"/>
        <c:noMultiLvlLbl val="0"/>
      </c:catAx>
      <c:valAx>
        <c:axId val="2107836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782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640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2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420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28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242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117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478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576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482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650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801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7DE99-5130-44FC-9EE9-6D86F05A8B10}" type="datetimeFigureOut">
              <a:rPr lang="en-US" smtClean="0"/>
              <a:t>4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2BCB-F6CC-4D1C-AB8E-39EC7A0F44A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80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9.xml"/><Relationship Id="rId2" Type="http://schemas.openxmlformats.org/officeDocument/2006/relationships/chart" Target="../charts/chart28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0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5.xml"/><Relationship Id="rId2" Type="http://schemas.openxmlformats.org/officeDocument/2006/relationships/chart" Target="../charts/chart3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8.xml"/><Relationship Id="rId2" Type="http://schemas.openxmlformats.org/officeDocument/2006/relationships/chart" Target="../charts/chart3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3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6.xml"/><Relationship Id="rId2" Type="http://schemas.openxmlformats.org/officeDocument/2006/relationships/chart" Target="../charts/chart2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68159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1677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663324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8906731"/>
              </p:ext>
            </p:extLst>
          </p:nvPr>
        </p:nvGraphicFramePr>
        <p:xfrm>
          <a:off x="449580" y="784483"/>
          <a:ext cx="6164580" cy="76999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43277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-hsa-1359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2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CGAGGCT</a:t>
                      </a:r>
                      <a:r>
                        <a:rPr lang="en-US" sz="11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</a:t>
                      </a:r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GTCACGCTTGGGTATCGGCT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96240" y="8242676"/>
            <a:ext cx="2952078" cy="130574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Girard, A., </a:t>
            </a:r>
            <a:r>
              <a:rPr lang="en-US" sz="900" dirty="0" err="1"/>
              <a:t>Sachidanandam</a:t>
            </a:r>
            <a:r>
              <a:rPr lang="en-US" sz="900" dirty="0"/>
              <a:t>, R., Hannon, G. J., &amp; </a:t>
            </a:r>
            <a:r>
              <a:rPr lang="en-US" sz="900" dirty="0" err="1"/>
              <a:t>Carmell</a:t>
            </a:r>
            <a:r>
              <a:rPr lang="en-US" sz="900" dirty="0"/>
              <a:t>, M. A. (2006). </a:t>
            </a:r>
            <a:r>
              <a:rPr lang="en-US" sz="900" b="1" dirty="0"/>
              <a:t>A germline-specific class of small RNAs binds mammalian Piwi proteins</a:t>
            </a:r>
            <a:r>
              <a:rPr lang="en-US" sz="900" dirty="0"/>
              <a:t>. </a:t>
            </a:r>
            <a:r>
              <a:rPr lang="en-US" sz="900" i="1" dirty="0"/>
              <a:t>Nature</a:t>
            </a:r>
            <a:r>
              <a:rPr lang="en-US" sz="900" dirty="0"/>
              <a:t>, </a:t>
            </a:r>
            <a:r>
              <a:rPr lang="en-US" sz="900" i="1" dirty="0"/>
              <a:t>442</a:t>
            </a:r>
            <a:r>
              <a:rPr lang="en-US" sz="900" dirty="0"/>
              <a:t>(7099), 199-20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at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0200-000002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30207354"/>
              </p:ext>
            </p:extLst>
          </p:nvPr>
        </p:nvGraphicFramePr>
        <p:xfrm>
          <a:off x="434340" y="1692723"/>
          <a:ext cx="3032759" cy="1951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0200-000005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61726869"/>
              </p:ext>
            </p:extLst>
          </p:nvPr>
        </p:nvGraphicFramePr>
        <p:xfrm>
          <a:off x="3531870" y="1701424"/>
          <a:ext cx="3055620" cy="1951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0200-00000400000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48449018"/>
              </p:ext>
            </p:extLst>
          </p:nvPr>
        </p:nvGraphicFramePr>
        <p:xfrm>
          <a:off x="478791" y="3748124"/>
          <a:ext cx="2950209" cy="18621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BB6E7BF0-9475-52B9-8382-0BFE0B87D0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852940"/>
              </p:ext>
            </p:extLst>
          </p:nvPr>
        </p:nvGraphicFramePr>
        <p:xfrm>
          <a:off x="396240" y="5821681"/>
          <a:ext cx="6191249" cy="20605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72025">
                  <a:extLst>
                    <a:ext uri="{9D8B030D-6E8A-4147-A177-3AD203B41FA5}">
                      <a16:colId xmlns="" xmlns:a16="http://schemas.microsoft.com/office/drawing/2014/main" val="29208914"/>
                    </a:ext>
                  </a:extLst>
                </a:gridCol>
                <a:gridCol w="1326696">
                  <a:extLst>
                    <a:ext uri="{9D8B030D-6E8A-4147-A177-3AD203B41FA5}">
                      <a16:colId xmlns="" xmlns:a16="http://schemas.microsoft.com/office/drawing/2014/main" val="1876069325"/>
                    </a:ext>
                  </a:extLst>
                </a:gridCol>
                <a:gridCol w="1345278">
                  <a:extLst>
                    <a:ext uri="{9D8B030D-6E8A-4147-A177-3AD203B41FA5}">
                      <a16:colId xmlns="" xmlns:a16="http://schemas.microsoft.com/office/drawing/2014/main" val="2571400846"/>
                    </a:ext>
                  </a:extLst>
                </a:gridCol>
                <a:gridCol w="1747250">
                  <a:extLst>
                    <a:ext uri="{9D8B030D-6E8A-4147-A177-3AD203B41FA5}">
                      <a16:colId xmlns="" xmlns:a16="http://schemas.microsoft.com/office/drawing/2014/main" val="1106743714"/>
                    </a:ext>
                  </a:extLst>
                </a:gridCol>
              </a:tblGrid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Expression: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d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175503701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3118289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.060249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.051571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79996537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.9808653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528123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157568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609276830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4.146100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4.275273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.670890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648326409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094482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463803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354497239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454379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208015165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3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866025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.684557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860907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339246881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723407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627971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.517971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32285741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984298346"/>
                  </a:ext>
                </a:extLst>
              </a:tr>
              <a:tr h="1969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9353259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7117762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7871187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611528922"/>
                  </a:ext>
                </a:extLst>
              </a:tr>
              <a:tr h="1969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5950217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28602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911103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219058507"/>
                  </a:ext>
                </a:extLst>
              </a:tr>
              <a:tr h="196961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416184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423662</a:t>
                      </a:r>
                    </a:p>
                  </a:txBody>
                  <a:tcPr marL="0" marR="0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689786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303730852"/>
                  </a:ext>
                </a:extLst>
              </a:tr>
              <a:tr h="1469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5440944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653856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8301089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587242037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6911DAB2-24C0-D28D-C7BD-FE8D430A68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43189622"/>
              </p:ext>
            </p:extLst>
          </p:nvPr>
        </p:nvGraphicFramePr>
        <p:xfrm>
          <a:off x="3581398" y="4468995"/>
          <a:ext cx="3006090" cy="5546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2030">
                  <a:extLst>
                    <a:ext uri="{9D8B030D-6E8A-4147-A177-3AD203B41FA5}">
                      <a16:colId xmlns="" xmlns:a16="http://schemas.microsoft.com/office/drawing/2014/main" val="731365146"/>
                    </a:ext>
                  </a:extLst>
                </a:gridCol>
                <a:gridCol w="1002030">
                  <a:extLst>
                    <a:ext uri="{9D8B030D-6E8A-4147-A177-3AD203B41FA5}">
                      <a16:colId xmlns="" xmlns:a16="http://schemas.microsoft.com/office/drawing/2014/main" val="4290869628"/>
                    </a:ext>
                  </a:extLst>
                </a:gridCol>
                <a:gridCol w="1002030">
                  <a:extLst>
                    <a:ext uri="{9D8B030D-6E8A-4147-A177-3AD203B41FA5}">
                      <a16:colId xmlns="" xmlns:a16="http://schemas.microsoft.com/office/drawing/2014/main" val="3701496978"/>
                    </a:ext>
                  </a:extLst>
                </a:gridCol>
              </a:tblGrid>
              <a:tr h="41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direct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3h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3h/direct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100932445"/>
                  </a:ext>
                </a:extLst>
              </a:tr>
              <a:tr h="13249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486661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526197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0395363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92607699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="" xmlns:a16="http://schemas.microsoft.com/office/drawing/2014/main" id="{F0124AB6-B172-FD8A-82B4-B37E5BC4AB97}"/>
              </a:ext>
            </a:extLst>
          </p:cNvPr>
          <p:cNvSpPr txBox="1"/>
          <p:nvPr/>
        </p:nvSpPr>
        <p:spPr>
          <a:xfrm>
            <a:off x="3651883" y="8242676"/>
            <a:ext cx="2865120" cy="1237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- found per immunoprecipitation in testi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2467407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3036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171741"/>
              </p:ext>
            </p:extLst>
          </p:nvPr>
        </p:nvGraphicFramePr>
        <p:xfrm>
          <a:off x="449580" y="784483"/>
          <a:ext cx="6164580" cy="6592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2961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r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299; piR-hsa-8541161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2961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6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b="1" dirty="0"/>
                        <a:t>T</a:t>
                      </a:r>
                      <a:r>
                        <a:rPr lang="en-US" sz="1100" dirty="0"/>
                        <a:t>GTAAACATCCTTGACTGGAAGCTGT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627120" y="7879931"/>
            <a:ext cx="2865120" cy="735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  <p:sp>
        <p:nvSpPr>
          <p:cNvPr id="12" name="Textfeld 11">
            <a:extLst>
              <a:ext uri="{FF2B5EF4-FFF2-40B4-BE49-F238E27FC236}">
                <a16:creationId xmlns="" xmlns:a16="http://schemas.microsoft.com/office/drawing/2014/main" id="{246465BE-F654-8FCB-CCBD-E11296F6D4B1}"/>
              </a:ext>
            </a:extLst>
          </p:cNvPr>
          <p:cNvSpPr txBox="1"/>
          <p:nvPr/>
        </p:nvSpPr>
        <p:spPr>
          <a:xfrm>
            <a:off x="417022" y="7879931"/>
            <a:ext cx="2962911" cy="145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evant p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’ uridine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BA674C0F-DE0C-B1FE-7D84-F53B5D6B80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3961003"/>
              </p:ext>
            </p:extLst>
          </p:nvPr>
        </p:nvGraphicFramePr>
        <p:xfrm>
          <a:off x="417022" y="5708448"/>
          <a:ext cx="6184304" cy="1951863"/>
        </p:xfrm>
        <a:graphic>
          <a:graphicData uri="http://schemas.openxmlformats.org/drawingml/2006/table">
            <a:tbl>
              <a:tblPr/>
              <a:tblGrid>
                <a:gridCol w="1613134">
                  <a:extLst>
                    <a:ext uri="{9D8B030D-6E8A-4147-A177-3AD203B41FA5}">
                      <a16:colId xmlns="" xmlns:a16="http://schemas.microsoft.com/office/drawing/2014/main" val="1706953693"/>
                    </a:ext>
                  </a:extLst>
                </a:gridCol>
                <a:gridCol w="1479018">
                  <a:extLst>
                    <a:ext uri="{9D8B030D-6E8A-4147-A177-3AD203B41FA5}">
                      <a16:colId xmlns="" xmlns:a16="http://schemas.microsoft.com/office/drawing/2014/main" val="2516404334"/>
                    </a:ext>
                  </a:extLst>
                </a:gridCol>
                <a:gridCol w="1546076">
                  <a:extLst>
                    <a:ext uri="{9D8B030D-6E8A-4147-A177-3AD203B41FA5}">
                      <a16:colId xmlns="" xmlns:a16="http://schemas.microsoft.com/office/drawing/2014/main" val="965748866"/>
                    </a:ext>
                  </a:extLst>
                </a:gridCol>
                <a:gridCol w="1546076">
                  <a:extLst>
                    <a:ext uri="{9D8B030D-6E8A-4147-A177-3AD203B41FA5}">
                      <a16:colId xmlns="" xmlns:a16="http://schemas.microsoft.com/office/drawing/2014/main" val="3275588853"/>
                    </a:ext>
                  </a:extLst>
                </a:gridCol>
              </a:tblGrid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388137252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46.637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54.28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55.6098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02194162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38.8353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26.175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40.880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588112259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88.449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37.977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36.238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47881904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14.2279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44.375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73.683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81578301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45.685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29183023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39.277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21.725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60.068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066021717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33.331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68.133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69.937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07438927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7.343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53964134"/>
                  </a:ext>
                </a:extLst>
              </a:tr>
              <a:tr h="1934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72.9735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08.779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39.403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84658118"/>
                  </a:ext>
                </a:extLst>
              </a:tr>
              <a:tr h="1934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devi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3.6619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8.2575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.6158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31892399"/>
                  </a:ext>
                </a:extLst>
              </a:tr>
              <a:tr h="193421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1767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1937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999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32417213"/>
                  </a:ext>
                </a:extLst>
              </a:tr>
              <a:tr h="13295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514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0743.9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291.61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18583595"/>
                  </a:ext>
                </a:extLst>
              </a:tr>
            </a:tbl>
          </a:graphicData>
        </a:graphic>
      </p:graphicFrame>
      <p:graphicFrame>
        <p:nvGraphicFramePr>
          <p:cNvPr id="17" name="Diagramm 16">
            <a:extLst>
              <a:ext uri="{FF2B5EF4-FFF2-40B4-BE49-F238E27FC236}">
                <a16:creationId xmlns="" xmlns:a16="http://schemas.microsoft.com/office/drawing/2014/main" id="{00000000-0008-0000-15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2674552"/>
              </p:ext>
            </p:extLst>
          </p:nvPr>
        </p:nvGraphicFramePr>
        <p:xfrm>
          <a:off x="3525982" y="1555482"/>
          <a:ext cx="3067396" cy="1951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8" name="Tabelle 17">
            <a:extLst>
              <a:ext uri="{FF2B5EF4-FFF2-40B4-BE49-F238E27FC236}">
                <a16:creationId xmlns="" xmlns:a16="http://schemas.microsoft.com/office/drawing/2014/main" id="{8BB8A554-E865-021C-5071-95C5A408D6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8184455"/>
              </p:ext>
            </p:extLst>
          </p:nvPr>
        </p:nvGraphicFramePr>
        <p:xfrm>
          <a:off x="3643129" y="4251476"/>
          <a:ext cx="2833101" cy="588757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515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3493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8025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4532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="" xmlns:a16="http://schemas.microsoft.com/office/drawing/2014/main" id="{00000000-0008-0000-15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6931928"/>
              </p:ext>
            </p:extLst>
          </p:nvPr>
        </p:nvGraphicFramePr>
        <p:xfrm>
          <a:off x="449580" y="1604789"/>
          <a:ext cx="3055620" cy="18818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Diagramm 9">
            <a:extLst>
              <a:ext uri="{FF2B5EF4-FFF2-40B4-BE49-F238E27FC236}">
                <a16:creationId xmlns="" xmlns:a16="http://schemas.microsoft.com/office/drawing/2014/main" id="{00000000-0008-0000-15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3446345"/>
              </p:ext>
            </p:extLst>
          </p:nvPr>
        </p:nvGraphicFramePr>
        <p:xfrm>
          <a:off x="417022" y="3586902"/>
          <a:ext cx="3088177" cy="191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491951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279500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3041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2180449"/>
              </p:ext>
            </p:extLst>
          </p:nvPr>
        </p:nvGraphicFramePr>
        <p:xfrm>
          <a:off x="449580" y="701152"/>
          <a:ext cx="6164580" cy="9512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39341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139; piRNA-L-296; piRNA-L-434; piRNA-L-444; piRNA-L-47; piR-hsa-8529423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56896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6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b="1" dirty="0"/>
                        <a:t>T</a:t>
                      </a:r>
                      <a:r>
                        <a:rPr lang="en-US" sz="1100" dirty="0"/>
                        <a:t>TCTCACTACTGCACTTGACTAGTCT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804833" y="8049279"/>
            <a:ext cx="2805664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</a:p>
        </p:txBody>
      </p:sp>
      <p:graphicFrame>
        <p:nvGraphicFramePr>
          <p:cNvPr id="14" name="Tabelle 13">
            <a:extLst>
              <a:ext uri="{FF2B5EF4-FFF2-40B4-BE49-F238E27FC236}">
                <a16:creationId xmlns="" xmlns:a16="http://schemas.microsoft.com/office/drawing/2014/main" id="{A0E5A064-782F-CC4A-950C-FAAF7B8903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7319062"/>
              </p:ext>
            </p:extLst>
          </p:nvPr>
        </p:nvGraphicFramePr>
        <p:xfrm>
          <a:off x="396239" y="5733932"/>
          <a:ext cx="6214258" cy="2081323"/>
        </p:xfrm>
        <a:graphic>
          <a:graphicData uri="http://schemas.openxmlformats.org/drawingml/2006/table">
            <a:tbl>
              <a:tblPr/>
              <a:tblGrid>
                <a:gridCol w="1683151">
                  <a:extLst>
                    <a:ext uri="{9D8B030D-6E8A-4147-A177-3AD203B41FA5}">
                      <a16:colId xmlns="" xmlns:a16="http://schemas.microsoft.com/office/drawing/2014/main" val="2380665603"/>
                    </a:ext>
                  </a:extLst>
                </a:gridCol>
                <a:gridCol w="1423977">
                  <a:extLst>
                    <a:ext uri="{9D8B030D-6E8A-4147-A177-3AD203B41FA5}">
                      <a16:colId xmlns="" xmlns:a16="http://schemas.microsoft.com/office/drawing/2014/main" val="3288125685"/>
                    </a:ext>
                  </a:extLst>
                </a:gridCol>
                <a:gridCol w="1553565">
                  <a:extLst>
                    <a:ext uri="{9D8B030D-6E8A-4147-A177-3AD203B41FA5}">
                      <a16:colId xmlns="" xmlns:a16="http://schemas.microsoft.com/office/drawing/2014/main" val="1973840633"/>
                    </a:ext>
                  </a:extLst>
                </a:gridCol>
                <a:gridCol w="1553565">
                  <a:extLst>
                    <a:ext uri="{9D8B030D-6E8A-4147-A177-3AD203B41FA5}">
                      <a16:colId xmlns="" xmlns:a16="http://schemas.microsoft.com/office/drawing/2014/main" val="2985924011"/>
                    </a:ext>
                  </a:extLst>
                </a:gridCol>
              </a:tblGrid>
              <a:tr h="11981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786094879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.2796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67486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34086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685178062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00166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48431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77543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95187322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84895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2.6065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2.8798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65875941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.75461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.8658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85644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18217703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89871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32878478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11474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6911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79560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75133337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.83411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38034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04652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96623463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20208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630098909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2418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45051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11578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0592707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devi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33335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07956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24289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70742224"/>
                  </a:ext>
                </a:extLst>
              </a:tr>
              <a:tr h="164273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1192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11579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8500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0317065"/>
                  </a:ext>
                </a:extLst>
              </a:tr>
              <a:tr h="11981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5.44499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6.8707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7.7181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21991126"/>
                  </a:ext>
                </a:extLst>
              </a:tr>
            </a:tbl>
          </a:graphicData>
        </a:graphic>
      </p:graphicFrame>
      <p:graphicFrame>
        <p:nvGraphicFramePr>
          <p:cNvPr id="16" name="Diagramm 15">
            <a:extLst>
              <a:ext uri="{FF2B5EF4-FFF2-40B4-BE49-F238E27FC236}">
                <a16:creationId xmlns="" xmlns:a16="http://schemas.microsoft.com/office/drawing/2014/main" id="{00000000-0008-0000-16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5380533"/>
              </p:ext>
            </p:extLst>
          </p:nvPr>
        </p:nvGraphicFramePr>
        <p:xfrm>
          <a:off x="3531870" y="1537088"/>
          <a:ext cx="3078627" cy="20154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Tabelle 16">
            <a:extLst>
              <a:ext uri="{FF2B5EF4-FFF2-40B4-BE49-F238E27FC236}">
                <a16:creationId xmlns="" xmlns:a16="http://schemas.microsoft.com/office/drawing/2014/main" id="{0002416C-21EF-E5E1-1942-A92BCB039F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5858719"/>
              </p:ext>
            </p:extLst>
          </p:nvPr>
        </p:nvGraphicFramePr>
        <p:xfrm>
          <a:off x="3600835" y="4244362"/>
          <a:ext cx="2940696" cy="616509"/>
        </p:xfrm>
        <a:graphic>
          <a:graphicData uri="http://schemas.openxmlformats.org/drawingml/2006/table">
            <a:tbl>
              <a:tblPr/>
              <a:tblGrid>
                <a:gridCol w="980232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496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6690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2364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5471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689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sp>
        <p:nvSpPr>
          <p:cNvPr id="18" name="Textfeld 17">
            <a:extLst>
              <a:ext uri="{FF2B5EF4-FFF2-40B4-BE49-F238E27FC236}">
                <a16:creationId xmlns="" xmlns:a16="http://schemas.microsoft.com/office/drawing/2014/main" id="{1AE094B6-B33D-6D71-89F3-4589EFE46E68}"/>
              </a:ext>
            </a:extLst>
          </p:cNvPr>
          <p:cNvSpPr txBox="1"/>
          <p:nvPr/>
        </p:nvSpPr>
        <p:spPr>
          <a:xfrm>
            <a:off x="396239" y="8049279"/>
            <a:ext cx="3204596" cy="1485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  <a:endParaRPr lang="en-US" sz="11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’ uridine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Diagramm 8">
            <a:extLst>
              <a:ext uri="{FF2B5EF4-FFF2-40B4-BE49-F238E27FC236}">
                <a16:creationId xmlns="" xmlns:a16="http://schemas.microsoft.com/office/drawing/2014/main" id="{00000000-0008-0000-16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9965146"/>
              </p:ext>
            </p:extLst>
          </p:nvPr>
        </p:nvGraphicFramePr>
        <p:xfrm>
          <a:off x="438076" y="1526164"/>
          <a:ext cx="3055621" cy="19692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Diagramm 9">
            <a:extLst>
              <a:ext uri="{FF2B5EF4-FFF2-40B4-BE49-F238E27FC236}">
                <a16:creationId xmlns="" xmlns:a16="http://schemas.microsoft.com/office/drawing/2014/main" id="{00000000-0008-0000-16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0838647"/>
              </p:ext>
            </p:extLst>
          </p:nvPr>
        </p:nvGraphicFramePr>
        <p:xfrm>
          <a:off x="449580" y="3633626"/>
          <a:ext cx="2998856" cy="1955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38274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236918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3074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6669479"/>
              </p:ext>
            </p:extLst>
          </p:nvPr>
        </p:nvGraphicFramePr>
        <p:xfrm>
          <a:off x="449580" y="721456"/>
          <a:ext cx="6164580" cy="6894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262779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 smtClean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eq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2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AGGCTGGTCCGAGTGCAGTGGTGTTTACAACT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69570" y="8069889"/>
            <a:ext cx="3108960" cy="1463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Rizzo, F., Rinaldi, A., Marchese, G., </a:t>
            </a:r>
            <a:r>
              <a:rPr lang="en-US" sz="900" dirty="0" err="1"/>
              <a:t>Coviello</a:t>
            </a:r>
            <a:r>
              <a:rPr lang="en-US" sz="900" dirty="0"/>
              <a:t>, E., </a:t>
            </a:r>
            <a:r>
              <a:rPr lang="en-US" sz="900" dirty="0" err="1"/>
              <a:t>Sellitto</a:t>
            </a:r>
            <a:r>
              <a:rPr lang="en-US" sz="900" dirty="0"/>
              <a:t>, A., </a:t>
            </a:r>
            <a:r>
              <a:rPr lang="en-US" sz="900" dirty="0" err="1"/>
              <a:t>Cordella</a:t>
            </a:r>
            <a:r>
              <a:rPr lang="en-US" sz="900" dirty="0"/>
              <a:t>, A., ... &amp; Weisz, A. (2016). </a:t>
            </a:r>
            <a:r>
              <a:rPr lang="en-US" sz="900" b="1" dirty="0"/>
              <a:t>Specific patterns of PIWI-interacting small noncoding RNA expression in dysplastic liver nodules and hepatocellular carcinoma</a:t>
            </a:r>
            <a:r>
              <a:rPr lang="en-US" sz="900" dirty="0"/>
              <a:t>. </a:t>
            </a:r>
            <a:r>
              <a:rPr lang="en-US" sz="900" i="1" dirty="0" err="1"/>
              <a:t>Oncotarget</a:t>
            </a:r>
            <a:r>
              <a:rPr lang="en-US" sz="900" dirty="0"/>
              <a:t>, </a:t>
            </a:r>
            <a:r>
              <a:rPr lang="en-US" sz="900" i="1" dirty="0"/>
              <a:t>7</a:t>
            </a:r>
            <a:r>
              <a:rPr lang="en-US" sz="900" dirty="0"/>
              <a:t>(34), 54650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22370" y="8069889"/>
            <a:ext cx="2865120" cy="8837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dysplastic</a:t>
            </a:r>
            <a:r>
              <a:rPr lang="de-DE" sz="900" dirty="0"/>
              <a:t> </a:t>
            </a:r>
            <a:r>
              <a:rPr lang="de-DE" sz="900" dirty="0" err="1"/>
              <a:t>liver</a:t>
            </a:r>
            <a:r>
              <a:rPr lang="de-DE" sz="900" dirty="0"/>
              <a:t> </a:t>
            </a:r>
            <a:r>
              <a:rPr lang="de-DE" sz="900" dirty="0" err="1"/>
              <a:t>nodules</a:t>
            </a:r>
            <a:r>
              <a:rPr lang="de-DE" sz="900" dirty="0"/>
              <a:t> and in </a:t>
            </a:r>
            <a:r>
              <a:rPr lang="de-DE" sz="900" dirty="0" err="1"/>
              <a:t>hepatocellular</a:t>
            </a:r>
            <a:r>
              <a:rPr lang="de-DE" sz="900" dirty="0"/>
              <a:t> </a:t>
            </a:r>
            <a:r>
              <a:rPr lang="de-DE" sz="900" dirty="0" err="1"/>
              <a:t>carcinoma</a:t>
            </a:r>
            <a:endParaRPr lang="de-DE" sz="900" dirty="0"/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endParaRPr lang="de-DE" sz="900" dirty="0"/>
          </a:p>
        </p:txBody>
      </p:sp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9378B981-6285-39EC-49D7-6F1C7576DC2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4917089"/>
              </p:ext>
            </p:extLst>
          </p:nvPr>
        </p:nvGraphicFramePr>
        <p:xfrm>
          <a:off x="3531870" y="1526162"/>
          <a:ext cx="3055620" cy="201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4274F761-E1C1-5094-173E-98F2A12859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5498404"/>
              </p:ext>
            </p:extLst>
          </p:nvPr>
        </p:nvGraphicFramePr>
        <p:xfrm>
          <a:off x="396240" y="5725594"/>
          <a:ext cx="6217920" cy="1984151"/>
        </p:xfrm>
        <a:graphic>
          <a:graphicData uri="http://schemas.openxmlformats.org/drawingml/2006/table">
            <a:tbl>
              <a:tblPr/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2517704907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77504634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4219520914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980305586"/>
                    </a:ext>
                  </a:extLst>
                </a:gridCol>
              </a:tblGrid>
              <a:tr h="109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Express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84889581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43016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4.0484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65028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98354025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11647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78745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0781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50066524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3.3267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.570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2.9748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1789101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31325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31481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1.0159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47695396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.086674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74704272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20085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.7448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37833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088411023"/>
                  </a:ext>
                </a:extLst>
              </a:tr>
              <a:tr h="135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234079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70206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59690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37384999"/>
                  </a:ext>
                </a:extLst>
              </a:tr>
              <a:tr h="1378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15710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29309492"/>
                  </a:ext>
                </a:extLst>
              </a:tr>
              <a:tr h="2039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3581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52794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9490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97883034"/>
                  </a:ext>
                </a:extLst>
              </a:tr>
              <a:tr h="2039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devi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93030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31960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155326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24436693"/>
                  </a:ext>
                </a:extLst>
              </a:tr>
              <a:tr h="203946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5972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336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9661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95963530"/>
                  </a:ext>
                </a:extLst>
              </a:tr>
              <a:tr h="109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6.9626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9.6389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2.7904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88772145"/>
                  </a:ext>
                </a:extLst>
              </a:tr>
            </a:tbl>
          </a:graphicData>
        </a:graphic>
      </p:graphicFrame>
      <p:graphicFrame>
        <p:nvGraphicFramePr>
          <p:cNvPr id="17" name="Tabelle 16">
            <a:extLst>
              <a:ext uri="{FF2B5EF4-FFF2-40B4-BE49-F238E27FC236}">
                <a16:creationId xmlns="" xmlns:a16="http://schemas.microsoft.com/office/drawing/2014/main" id="{78807897-BDC2-495C-5143-34DE1CE04B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3409142"/>
              </p:ext>
            </p:extLst>
          </p:nvPr>
        </p:nvGraphicFramePr>
        <p:xfrm>
          <a:off x="3600835" y="4244362"/>
          <a:ext cx="2940696" cy="616509"/>
        </p:xfrm>
        <a:graphic>
          <a:graphicData uri="http://schemas.openxmlformats.org/drawingml/2006/table">
            <a:tbl>
              <a:tblPr/>
              <a:tblGrid>
                <a:gridCol w="980232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496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6690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29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8834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5902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="" xmlns:a16="http://schemas.microsoft.com/office/drawing/2014/main" id="{00000000-0008-0000-18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6298701"/>
              </p:ext>
            </p:extLst>
          </p:nvPr>
        </p:nvGraphicFramePr>
        <p:xfrm>
          <a:off x="422910" y="1526162"/>
          <a:ext cx="3108960" cy="1957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Diagramm 15">
            <a:extLst>
              <a:ext uri="{FF2B5EF4-FFF2-40B4-BE49-F238E27FC236}">
                <a16:creationId xmlns="" xmlns:a16="http://schemas.microsoft.com/office/drawing/2014/main" id="{00000000-0008-0000-18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5232505"/>
              </p:ext>
            </p:extLst>
          </p:nvPr>
        </p:nvGraphicFramePr>
        <p:xfrm>
          <a:off x="422911" y="3587069"/>
          <a:ext cx="3082290" cy="19602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6898607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3151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4248563"/>
              </p:ext>
            </p:extLst>
          </p:nvPr>
        </p:nvGraphicFramePr>
        <p:xfrm>
          <a:off x="449580" y="784483"/>
          <a:ext cx="6164580" cy="79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log2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fc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eq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5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GGGCGGTG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TGACCCCAACATGCCATCTGAGTGTC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49040" y="8069889"/>
            <a:ext cx="2865120" cy="8837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dysplastic</a:t>
            </a:r>
            <a:r>
              <a:rPr lang="de-DE" sz="900" dirty="0"/>
              <a:t> </a:t>
            </a:r>
            <a:r>
              <a:rPr lang="de-DE" sz="900" dirty="0" err="1"/>
              <a:t>liver</a:t>
            </a:r>
            <a:r>
              <a:rPr lang="de-DE" sz="900" dirty="0"/>
              <a:t> </a:t>
            </a:r>
            <a:r>
              <a:rPr lang="de-DE" sz="900" dirty="0" err="1"/>
              <a:t>nodules</a:t>
            </a:r>
            <a:r>
              <a:rPr lang="de-DE" sz="900" dirty="0"/>
              <a:t> and in </a:t>
            </a:r>
            <a:r>
              <a:rPr lang="de-DE" sz="900" dirty="0" err="1"/>
              <a:t>hepatocellular</a:t>
            </a:r>
            <a:r>
              <a:rPr lang="de-DE" sz="900" dirty="0"/>
              <a:t> </a:t>
            </a:r>
            <a:r>
              <a:rPr lang="de-DE" sz="900" dirty="0" err="1"/>
              <a:t>carcinoma</a:t>
            </a:r>
            <a:endParaRPr lang="de-DE" sz="900" dirty="0"/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endParaRPr lang="en-US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3A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6481901"/>
              </p:ext>
            </p:extLst>
          </p:nvPr>
        </p:nvGraphicFramePr>
        <p:xfrm>
          <a:off x="396240" y="3591845"/>
          <a:ext cx="3108960" cy="19207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3A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9456568"/>
              </p:ext>
            </p:extLst>
          </p:nvPr>
        </p:nvGraphicFramePr>
        <p:xfrm>
          <a:off x="396240" y="1555617"/>
          <a:ext cx="3108960" cy="1946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E35073D0-BB58-409F-92E0-6FA13084B6C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7253738"/>
              </p:ext>
            </p:extLst>
          </p:nvPr>
        </p:nvGraphicFramePr>
        <p:xfrm>
          <a:off x="396240" y="5779296"/>
          <a:ext cx="6217920" cy="197493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3912890439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736182645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3415021348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3286761442"/>
                    </a:ext>
                  </a:extLst>
                </a:gridCol>
              </a:tblGrid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d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868534820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623657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.650623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44830315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65391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42707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102536433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382033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712545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917722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51858903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57626268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28421928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3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292328850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normalized_IR004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634044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2559429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586328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346636448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.191003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60288176"/>
                  </a:ext>
                </a:extLst>
              </a:tr>
              <a:tr h="18603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435581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743636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2506751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09801887"/>
                  </a:ext>
                </a:extLst>
              </a:tr>
              <a:tr h="18603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320297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935496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4022356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87890624"/>
                  </a:ext>
                </a:extLst>
              </a:tr>
              <a:tr h="186037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969531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835483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0460895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34813011"/>
                  </a:ext>
                </a:extLst>
              </a:tr>
              <a:tr h="1416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743185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8.617139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161793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89626229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0C2D3A62-9B56-4A66-8E86-92BF1C354C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7488952"/>
              </p:ext>
            </p:extLst>
          </p:nvPr>
        </p:nvGraphicFramePr>
        <p:xfrm>
          <a:off x="3600835" y="4244362"/>
          <a:ext cx="2940696" cy="616509"/>
        </p:xfrm>
        <a:graphic>
          <a:graphicData uri="http://schemas.openxmlformats.org/drawingml/2006/table">
            <a:tbl>
              <a:tblPr/>
              <a:tblGrid>
                <a:gridCol w="980232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80232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496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6690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0464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1774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79820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graphicFrame>
        <p:nvGraphicFramePr>
          <p:cNvPr id="17" name="Diagramm 16">
            <a:extLst>
              <a:ext uri="{FF2B5EF4-FFF2-40B4-BE49-F238E27FC236}">
                <a16:creationId xmlns="" xmlns:a16="http://schemas.microsoft.com/office/drawing/2014/main" id="{D91F0973-BFD6-4700-9945-001291F58C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9058279"/>
              </p:ext>
            </p:extLst>
          </p:nvPr>
        </p:nvGraphicFramePr>
        <p:xfrm>
          <a:off x="3505200" y="1555618"/>
          <a:ext cx="3055620" cy="1972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8" name="Textfeld 17">
            <a:extLst>
              <a:ext uri="{FF2B5EF4-FFF2-40B4-BE49-F238E27FC236}">
                <a16:creationId xmlns="" xmlns:a16="http://schemas.microsoft.com/office/drawing/2014/main" id="{991894E4-FC94-D106-AE89-0D3772D31B57}"/>
              </a:ext>
            </a:extLst>
          </p:cNvPr>
          <p:cNvSpPr txBox="1"/>
          <p:nvPr/>
        </p:nvSpPr>
        <p:spPr>
          <a:xfrm>
            <a:off x="369570" y="8069889"/>
            <a:ext cx="3108960" cy="1740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p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Rizzo, F., Rinaldi, A., Marchese, G., </a:t>
            </a:r>
            <a:r>
              <a:rPr lang="en-US" sz="900" dirty="0" err="1"/>
              <a:t>Coviello</a:t>
            </a:r>
            <a:r>
              <a:rPr lang="en-US" sz="900" dirty="0"/>
              <a:t>, E., </a:t>
            </a:r>
            <a:r>
              <a:rPr lang="en-US" sz="900" dirty="0" err="1"/>
              <a:t>Sellitto</a:t>
            </a:r>
            <a:r>
              <a:rPr lang="en-US" sz="900" dirty="0"/>
              <a:t>, A., </a:t>
            </a:r>
            <a:r>
              <a:rPr lang="en-US" sz="900" dirty="0" err="1"/>
              <a:t>Cordella</a:t>
            </a:r>
            <a:r>
              <a:rPr lang="en-US" sz="900" dirty="0"/>
              <a:t>, A., ... &amp; Weisz, A. (2016). </a:t>
            </a:r>
            <a:r>
              <a:rPr lang="en-US" sz="900" b="1" dirty="0"/>
              <a:t>Specific patterns of PIWI-interacting small noncoding RNA expression in dysplastic liver nodules and hepatocellular carcinoma</a:t>
            </a:r>
            <a:r>
              <a:rPr lang="en-US" sz="900" dirty="0"/>
              <a:t>. </a:t>
            </a:r>
            <a:r>
              <a:rPr lang="en-US" sz="900" i="1" dirty="0" err="1"/>
              <a:t>Oncotarget</a:t>
            </a:r>
            <a:r>
              <a:rPr lang="en-US" sz="900" dirty="0"/>
              <a:t>, </a:t>
            </a:r>
            <a:r>
              <a:rPr lang="en-US" sz="900" i="1" dirty="0"/>
              <a:t>7</a:t>
            </a:r>
            <a:r>
              <a:rPr lang="en-US" sz="900" dirty="0"/>
              <a:t>(34), 54650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close to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9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9628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11119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3255881"/>
              </p:ext>
            </p:extLst>
          </p:nvPr>
        </p:nvGraphicFramePr>
        <p:xfrm>
          <a:off x="449580" y="767408"/>
          <a:ext cx="6164580" cy="74713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20417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-hsa-11360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2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b="1" dirty="0"/>
                        <a:t>T</a:t>
                      </a:r>
                      <a:r>
                        <a:rPr lang="en-US" sz="1100" dirty="0"/>
                        <a:t>GAGGTAGT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GATTGTATAGTTGTGGGGTAG</a:t>
                      </a:r>
                      <a:r>
                        <a:rPr lang="en-US" sz="1100" b="0" dirty="0"/>
                        <a:t>T</a:t>
                      </a:r>
                      <a:r>
                        <a:rPr lang="en-US" sz="1100" b="1" dirty="0"/>
                        <a:t>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38269" y="7904563"/>
            <a:ext cx="3090731" cy="144424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evant publications: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Girard, A., </a:t>
            </a:r>
            <a:r>
              <a:rPr lang="en-US" sz="900" dirty="0" err="1"/>
              <a:t>Sachidanandam</a:t>
            </a:r>
            <a:r>
              <a:rPr lang="en-US" sz="900" dirty="0"/>
              <a:t>, R., Hannon, G. J., &amp; </a:t>
            </a:r>
            <a:r>
              <a:rPr lang="en-US" sz="900" dirty="0" err="1"/>
              <a:t>Carmell</a:t>
            </a:r>
            <a:r>
              <a:rPr lang="en-US" sz="900" dirty="0"/>
              <a:t>, M. A. (2006). </a:t>
            </a:r>
            <a:r>
              <a:rPr lang="en-US" sz="900" b="1" dirty="0"/>
              <a:t>A germline-specific class of small RNAs binds mammalian Piwi proteins</a:t>
            </a:r>
            <a:r>
              <a:rPr lang="en-US" sz="900" dirty="0"/>
              <a:t>. </a:t>
            </a:r>
            <a:r>
              <a:rPr lang="en-US" sz="900" i="1" dirty="0"/>
              <a:t>Nature</a:t>
            </a:r>
            <a:r>
              <a:rPr lang="en-US" sz="900" dirty="0"/>
              <a:t>, </a:t>
            </a:r>
            <a:r>
              <a:rPr lang="en-US" sz="900" i="1" dirty="0"/>
              <a:t>442</a:t>
            </a:r>
            <a:r>
              <a:rPr lang="en-US" sz="900" dirty="0"/>
              <a:t>(7099), 199-20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 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’ uridine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at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</a:p>
        </p:txBody>
      </p:sp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03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2511675"/>
              </p:ext>
            </p:extLst>
          </p:nvPr>
        </p:nvGraphicFramePr>
        <p:xfrm>
          <a:off x="3558539" y="1542108"/>
          <a:ext cx="3002281" cy="19830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Diagramm 14">
            <a:extLst>
              <a:ext uri="{FF2B5EF4-FFF2-40B4-BE49-F238E27FC236}">
                <a16:creationId xmlns=""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7219244"/>
              </p:ext>
            </p:extLst>
          </p:nvPr>
        </p:nvGraphicFramePr>
        <p:xfrm>
          <a:off x="396240" y="1537781"/>
          <a:ext cx="3108960" cy="20062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343A0F73-08DD-F9BC-8E42-FF398498B9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6481338"/>
              </p:ext>
            </p:extLst>
          </p:nvPr>
        </p:nvGraphicFramePr>
        <p:xfrm>
          <a:off x="396240" y="5743859"/>
          <a:ext cx="6217919" cy="1871655"/>
        </p:xfrm>
        <a:graphic>
          <a:graphicData uri="http://schemas.openxmlformats.org/drawingml/2006/table">
            <a:tbl>
              <a:tblPr/>
              <a:tblGrid>
                <a:gridCol w="1646976">
                  <a:extLst>
                    <a:ext uri="{9D8B030D-6E8A-4147-A177-3AD203B41FA5}">
                      <a16:colId xmlns="" xmlns:a16="http://schemas.microsoft.com/office/drawing/2014/main" val="924223853"/>
                    </a:ext>
                  </a:extLst>
                </a:gridCol>
                <a:gridCol w="1461983">
                  <a:extLst>
                    <a:ext uri="{9D8B030D-6E8A-4147-A177-3AD203B41FA5}">
                      <a16:colId xmlns="" xmlns:a16="http://schemas.microsoft.com/office/drawing/2014/main" val="2597875783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914507775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730920595"/>
                    </a:ext>
                  </a:extLst>
                </a:gridCol>
              </a:tblGrid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Expression: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71104073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91401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85561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.87671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12968969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.86605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13538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25434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61962946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.68015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70401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379790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46155758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06172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01548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66748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45993635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4507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46078057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76068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35562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04743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50543185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3958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.51743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68500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13414677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39309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70646382"/>
                  </a:ext>
                </a:extLst>
              </a:tr>
              <a:tr h="1666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81528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59725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15179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787978687"/>
                  </a:ext>
                </a:extLst>
              </a:tr>
              <a:tr h="1666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devi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9591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34999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932449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486780240"/>
                  </a:ext>
                </a:extLst>
              </a:tr>
              <a:tr h="166685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6824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5433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8547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154258006"/>
                  </a:ext>
                </a:extLst>
              </a:tr>
              <a:tr h="1204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.09636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7.3222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2.3833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31434443"/>
                  </a:ext>
                </a:extLst>
              </a:tr>
            </a:tbl>
          </a:graphicData>
        </a:graphic>
      </p:graphicFrame>
      <p:graphicFrame>
        <p:nvGraphicFramePr>
          <p:cNvPr id="9" name="Tabelle 8">
            <a:extLst>
              <a:ext uri="{FF2B5EF4-FFF2-40B4-BE49-F238E27FC236}">
                <a16:creationId xmlns="" xmlns:a16="http://schemas.microsoft.com/office/drawing/2014/main" id="{80210FD8-7E3D-1E4D-2D51-400D490BE6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115374"/>
              </p:ext>
            </p:extLst>
          </p:nvPr>
        </p:nvGraphicFramePr>
        <p:xfrm>
          <a:off x="3556635" y="4278442"/>
          <a:ext cx="3006090" cy="5546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2030">
                  <a:extLst>
                    <a:ext uri="{9D8B030D-6E8A-4147-A177-3AD203B41FA5}">
                      <a16:colId xmlns="" xmlns:a16="http://schemas.microsoft.com/office/drawing/2014/main" val="731365146"/>
                    </a:ext>
                  </a:extLst>
                </a:gridCol>
                <a:gridCol w="1002030">
                  <a:extLst>
                    <a:ext uri="{9D8B030D-6E8A-4147-A177-3AD203B41FA5}">
                      <a16:colId xmlns="" xmlns:a16="http://schemas.microsoft.com/office/drawing/2014/main" val="4290869628"/>
                    </a:ext>
                  </a:extLst>
                </a:gridCol>
                <a:gridCol w="1002030">
                  <a:extLst>
                    <a:ext uri="{9D8B030D-6E8A-4147-A177-3AD203B41FA5}">
                      <a16:colId xmlns="" xmlns:a16="http://schemas.microsoft.com/office/drawing/2014/main" val="3701496978"/>
                    </a:ext>
                  </a:extLst>
                </a:gridCol>
              </a:tblGrid>
              <a:tr h="4175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direct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3h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3h/direct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100932445"/>
                  </a:ext>
                </a:extLst>
              </a:tr>
              <a:tr h="13249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588665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05927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164794</a:t>
                      </a:r>
                    </a:p>
                  </a:txBody>
                  <a:tcPr marL="0" marR="0" marT="0" marB="0" anchor="b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92607699"/>
                  </a:ext>
                </a:extLst>
              </a:tr>
            </a:tbl>
          </a:graphicData>
        </a:graphic>
      </p:graphicFrame>
      <p:graphicFrame>
        <p:nvGraphicFramePr>
          <p:cNvPr id="11" name="Diagramm 10">
            <a:extLst>
              <a:ext uri="{FF2B5EF4-FFF2-40B4-BE49-F238E27FC236}">
                <a16:creationId xmlns="" xmlns:a16="http://schemas.microsoft.com/office/drawing/2014/main" id="{00000000-0008-0000-03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08194939"/>
              </p:ext>
            </p:extLst>
          </p:nvPr>
        </p:nvGraphicFramePr>
        <p:xfrm>
          <a:off x="449580" y="3564325"/>
          <a:ext cx="3055620" cy="19670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Textfeld 11">
            <a:extLst>
              <a:ext uri="{FF2B5EF4-FFF2-40B4-BE49-F238E27FC236}">
                <a16:creationId xmlns="" xmlns:a16="http://schemas.microsoft.com/office/drawing/2014/main" id="{6CA9D929-8E79-57C0-C783-593A6F871359}"/>
              </a:ext>
            </a:extLst>
          </p:cNvPr>
          <p:cNvSpPr txBox="1"/>
          <p:nvPr/>
        </p:nvSpPr>
        <p:spPr>
          <a:xfrm>
            <a:off x="3716703" y="7969215"/>
            <a:ext cx="2865120" cy="1237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- found per immunoprecipitation in testi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716565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12547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0829954"/>
              </p:ext>
            </p:extLst>
          </p:nvPr>
        </p:nvGraphicFramePr>
        <p:xfrm>
          <a:off x="449580" y="784483"/>
          <a:ext cx="6164580" cy="79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log2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fc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DQ582459.1; hsa_piRNA_29500; piR-32571; piR-hsa-12682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; URS00004D79E4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8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CAGGTTAGTTTTACCCTACTGATGATGT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58140" y="7969215"/>
            <a:ext cx="3108960" cy="15565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Girard, A., </a:t>
            </a:r>
            <a:r>
              <a:rPr lang="en-US" sz="900" dirty="0" err="1"/>
              <a:t>Sachidanandam</a:t>
            </a:r>
            <a:r>
              <a:rPr lang="en-US" sz="900" dirty="0"/>
              <a:t>, R., Hannon, G. J., &amp; </a:t>
            </a:r>
            <a:r>
              <a:rPr lang="en-US" sz="900" dirty="0" err="1"/>
              <a:t>Carmell</a:t>
            </a:r>
            <a:r>
              <a:rPr lang="en-US" sz="900" dirty="0"/>
              <a:t>, M. A. (2006). </a:t>
            </a:r>
            <a:r>
              <a:rPr lang="en-US" sz="900" b="1" dirty="0"/>
              <a:t>A germline-specific class of small RNAs binds mammalian Piwi proteins</a:t>
            </a:r>
            <a:r>
              <a:rPr lang="en-US" sz="900" dirty="0"/>
              <a:t>. </a:t>
            </a:r>
            <a:r>
              <a:rPr lang="en-US" sz="900" i="1" dirty="0"/>
              <a:t>Nature</a:t>
            </a:r>
            <a:r>
              <a:rPr lang="en-US" sz="900" dirty="0"/>
              <a:t>, </a:t>
            </a:r>
            <a:r>
              <a:rPr lang="en-US" sz="900" i="1" dirty="0"/>
              <a:t>442</a:t>
            </a:r>
            <a:r>
              <a:rPr lang="en-US" sz="900" dirty="0"/>
              <a:t>(7099), 199-20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- length in between 24-35 nucleotides</a:t>
            </a:r>
          </a:p>
          <a:p>
            <a:endParaRPr lang="en-US" sz="900" dirty="0"/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16703" y="7969215"/>
            <a:ext cx="2865120" cy="12370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- found per immunoprecipitation in testi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0F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2687593"/>
              </p:ext>
            </p:extLst>
          </p:nvPr>
        </p:nvGraphicFramePr>
        <p:xfrm>
          <a:off x="3558540" y="1526163"/>
          <a:ext cx="3055620" cy="2010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0F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0278996"/>
              </p:ext>
            </p:extLst>
          </p:nvPr>
        </p:nvGraphicFramePr>
        <p:xfrm>
          <a:off x="396240" y="1545073"/>
          <a:ext cx="3108960" cy="2010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0F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5794750"/>
              </p:ext>
            </p:extLst>
          </p:nvPr>
        </p:nvGraphicFramePr>
        <p:xfrm>
          <a:off x="358140" y="3563243"/>
          <a:ext cx="3185160" cy="1991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1F1A1CB6-2DE2-BF99-2464-49E7D35D4DA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1950469"/>
              </p:ext>
            </p:extLst>
          </p:nvPr>
        </p:nvGraphicFramePr>
        <p:xfrm>
          <a:off x="396240" y="5825465"/>
          <a:ext cx="6217920" cy="18880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2864873931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81948913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261111981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973552157"/>
                    </a:ext>
                  </a:extLst>
                </a:gridCol>
              </a:tblGrid>
              <a:tr h="1431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d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679408645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5301247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.051571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61392280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54.40515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315136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1381846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.601183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4.275273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917722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75887013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720678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094482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231901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24571317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3.997259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90203230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normalized_IR003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622008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572181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30477013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089363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883914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79492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250991905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52.089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56607872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42.69062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6306324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494667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79236274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86.657956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5875427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972466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10177233"/>
                  </a:ext>
                </a:extLst>
              </a:tr>
              <a:tr h="145618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29906229		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3574876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0623543</a:t>
                      </a: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61610740"/>
                  </a:ext>
                </a:extLst>
              </a:tr>
              <a:tr h="1431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509.601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52029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945690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616559826"/>
                  </a:ext>
                </a:extLst>
              </a:tr>
            </a:tbl>
          </a:graphicData>
        </a:graphic>
      </p:graphicFrame>
      <p:graphicFrame>
        <p:nvGraphicFramePr>
          <p:cNvPr id="17" name="Tabelle 16">
            <a:extLst>
              <a:ext uri="{FF2B5EF4-FFF2-40B4-BE49-F238E27FC236}">
                <a16:creationId xmlns="" xmlns:a16="http://schemas.microsoft.com/office/drawing/2014/main" id="{F3038B19-5D58-C9E3-449B-C6155B037F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46521"/>
              </p:ext>
            </p:extLst>
          </p:nvPr>
        </p:nvGraphicFramePr>
        <p:xfrm>
          <a:off x="3916679" y="4089624"/>
          <a:ext cx="2465169" cy="72874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1723">
                  <a:extLst>
                    <a:ext uri="{9D8B030D-6E8A-4147-A177-3AD203B41FA5}">
                      <a16:colId xmlns="" xmlns:a16="http://schemas.microsoft.com/office/drawing/2014/main" val="258568992"/>
                    </a:ext>
                  </a:extLst>
                </a:gridCol>
                <a:gridCol w="821723">
                  <a:extLst>
                    <a:ext uri="{9D8B030D-6E8A-4147-A177-3AD203B41FA5}">
                      <a16:colId xmlns="" xmlns:a16="http://schemas.microsoft.com/office/drawing/2014/main" val="3572055851"/>
                    </a:ext>
                  </a:extLst>
                </a:gridCol>
                <a:gridCol w="821723">
                  <a:extLst>
                    <a:ext uri="{9D8B030D-6E8A-4147-A177-3AD203B41FA5}">
                      <a16:colId xmlns="" xmlns:a16="http://schemas.microsoft.com/office/drawing/2014/main" val="3646214747"/>
                    </a:ext>
                  </a:extLst>
                </a:gridCol>
              </a:tblGrid>
              <a:tr h="43724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 direct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 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 3h/T0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(fold change 3h/direct)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891719153"/>
                  </a:ext>
                </a:extLst>
              </a:tr>
              <a:tr h="29149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-4.71041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-4.83602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-0.12560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431423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4628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25111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290762"/>
              </p:ext>
            </p:extLst>
          </p:nvPr>
        </p:nvGraphicFramePr>
        <p:xfrm>
          <a:off x="449580" y="784483"/>
          <a:ext cx="6164580" cy="60617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227231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-hsa-25131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47091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9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b="1" dirty="0"/>
                        <a:t>T</a:t>
                      </a:r>
                      <a:r>
                        <a:rPr lang="en-US" sz="1100" dirty="0"/>
                        <a:t>TGCAAGCA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CACTCTGTGGCAGATGATC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96240" y="8106746"/>
            <a:ext cx="3108960" cy="1582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Girard, A., </a:t>
            </a:r>
            <a:r>
              <a:rPr lang="en-US" sz="900" dirty="0" err="1"/>
              <a:t>Sachidanandam</a:t>
            </a:r>
            <a:r>
              <a:rPr lang="en-US" sz="900" dirty="0"/>
              <a:t>, R., Hannon, G. J., &amp; </a:t>
            </a:r>
            <a:r>
              <a:rPr lang="en-US" sz="900" dirty="0" err="1"/>
              <a:t>Carmell</a:t>
            </a:r>
            <a:r>
              <a:rPr lang="en-US" sz="900" dirty="0"/>
              <a:t>, M. A. (2006). </a:t>
            </a:r>
            <a:r>
              <a:rPr lang="en-US" sz="900" b="1" dirty="0"/>
              <a:t>A germline-specific class of small RNAs binds mammalian Piwi proteins</a:t>
            </a:r>
            <a:r>
              <a:rPr lang="en-US" sz="900" dirty="0"/>
              <a:t>. </a:t>
            </a:r>
            <a:r>
              <a:rPr lang="en-US" sz="900" i="1" dirty="0"/>
              <a:t>Nature</a:t>
            </a:r>
            <a:r>
              <a:rPr lang="en-US" sz="900" dirty="0"/>
              <a:t>, </a:t>
            </a:r>
            <a:r>
              <a:rPr lang="en-US" sz="900" i="1" dirty="0"/>
              <a:t>442</a:t>
            </a:r>
            <a:r>
              <a:rPr lang="en-US" sz="900" dirty="0"/>
              <a:t>(7099), 199-20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  <a:endParaRPr lang="en-US" sz="9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’ uridine 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at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</a:p>
          <a:p>
            <a:pPr algn="just"/>
            <a:endParaRPr lang="en-US" sz="900" dirty="0"/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49040" y="8106746"/>
            <a:ext cx="2865120" cy="986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- found per immunoprecipitation in testis</a:t>
            </a:r>
            <a:endParaRPr lang="en-US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06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0869763"/>
              </p:ext>
            </p:extLst>
          </p:nvPr>
        </p:nvGraphicFramePr>
        <p:xfrm>
          <a:off x="3505200" y="1520302"/>
          <a:ext cx="3085231" cy="1961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06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0222954"/>
              </p:ext>
            </p:extLst>
          </p:nvPr>
        </p:nvGraphicFramePr>
        <p:xfrm>
          <a:off x="419969" y="1526163"/>
          <a:ext cx="3085231" cy="2004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Tabelle 18">
            <a:extLst>
              <a:ext uri="{FF2B5EF4-FFF2-40B4-BE49-F238E27FC236}">
                <a16:creationId xmlns="" xmlns:a16="http://schemas.microsoft.com/office/drawing/2014/main" id="{E6393CB5-DB33-30A8-10C4-B12EBC7B0C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8862533"/>
              </p:ext>
            </p:extLst>
          </p:nvPr>
        </p:nvGraphicFramePr>
        <p:xfrm>
          <a:off x="396240" y="5708858"/>
          <a:ext cx="6217920" cy="21680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1141871462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516825587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3265298436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513371189"/>
                    </a:ext>
                  </a:extLst>
                </a:gridCol>
              </a:tblGrid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Expression: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318211230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967743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295187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034381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2427678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42707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315136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753453920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691016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137636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753167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0663315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047241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463803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31029137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181569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58394741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3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622008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228185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572181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424957534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6340447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638478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18539306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52159627"/>
                  </a:ext>
                </a:extLst>
              </a:tr>
              <a:tr h="2019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87047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258493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129524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52154344"/>
                  </a:ext>
                </a:extLst>
              </a:tr>
              <a:tr h="201985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915807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54383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803558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934958"/>
                  </a:ext>
                </a:extLst>
              </a:tr>
              <a:tr h="201985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3242221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889411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734153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74837265"/>
                  </a:ext>
                </a:extLst>
              </a:tr>
              <a:tr h="1562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38704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729971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6457056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38415424"/>
                  </a:ext>
                </a:extLst>
              </a:tr>
            </a:tbl>
          </a:graphicData>
        </a:graphic>
      </p:graphicFrame>
      <p:graphicFrame>
        <p:nvGraphicFramePr>
          <p:cNvPr id="21" name="Tabelle 20">
            <a:extLst>
              <a:ext uri="{FF2B5EF4-FFF2-40B4-BE49-F238E27FC236}">
                <a16:creationId xmlns="" xmlns:a16="http://schemas.microsoft.com/office/drawing/2014/main" id="{785749FB-E7B5-1783-C867-42D94413E1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8653928"/>
              </p:ext>
            </p:extLst>
          </p:nvPr>
        </p:nvGraphicFramePr>
        <p:xfrm>
          <a:off x="3671760" y="4201124"/>
          <a:ext cx="2833101" cy="751876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6147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4613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63447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8834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graphicFrame>
        <p:nvGraphicFramePr>
          <p:cNvPr id="9" name="Diagramm 8">
            <a:extLst>
              <a:ext uri="{FF2B5EF4-FFF2-40B4-BE49-F238E27FC236}">
                <a16:creationId xmlns="" xmlns:a16="http://schemas.microsoft.com/office/drawing/2014/main" id="{00000000-0008-0000-06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5891912"/>
              </p:ext>
            </p:extLst>
          </p:nvPr>
        </p:nvGraphicFramePr>
        <p:xfrm>
          <a:off x="419969" y="3482072"/>
          <a:ext cx="3061502" cy="2059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3135922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2835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3794066"/>
              </p:ext>
            </p:extLst>
          </p:nvPr>
        </p:nvGraphicFramePr>
        <p:xfrm>
          <a:off x="449580" y="784483"/>
          <a:ext cx="6164580" cy="7416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 smtClean="0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 smtClean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410; piR-hsa-8500871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6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AACATTCA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CGCTGTCGGTGAGTTTG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84808" y="7990714"/>
            <a:ext cx="3108960" cy="145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</a:t>
            </a:r>
            <a:r>
              <a:rPr lang="en-US" sz="900" b="1" dirty="0"/>
              <a:t>). 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close to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  <a:endParaRPr lang="en-US" sz="900" dirty="0"/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47874" y="7990714"/>
            <a:ext cx="2865120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 algn="just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</a:p>
        </p:txBody>
      </p:sp>
      <p:graphicFrame>
        <p:nvGraphicFramePr>
          <p:cNvPr id="12" name="Tabelle 11">
            <a:extLst>
              <a:ext uri="{FF2B5EF4-FFF2-40B4-BE49-F238E27FC236}">
                <a16:creationId xmlns="" xmlns:a16="http://schemas.microsoft.com/office/drawing/2014/main" id="{1FBC201C-A90B-392C-54BC-3029F6291B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60358841"/>
              </p:ext>
            </p:extLst>
          </p:nvPr>
        </p:nvGraphicFramePr>
        <p:xfrm>
          <a:off x="395074" y="5698060"/>
          <a:ext cx="6217920" cy="1980879"/>
        </p:xfrm>
        <a:graphic>
          <a:graphicData uri="http://schemas.openxmlformats.org/drawingml/2006/table">
            <a:tbl>
              <a:tblPr/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4276886466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93276201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911951901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377873652"/>
                    </a:ext>
                  </a:extLst>
                </a:gridCol>
              </a:tblGrid>
              <a:tr h="1140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Expression: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729065105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075342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.66309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2892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56931182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.4816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57391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.9689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841633860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64658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5663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.91146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903886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96290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94482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4355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0282778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26641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90656888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.664955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51664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244510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79715917"/>
                  </a:ext>
                </a:extLst>
              </a:tr>
              <a:tr h="1353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.029845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91046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170557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91896121"/>
                  </a:ext>
                </a:extLst>
              </a:tr>
              <a:tr h="1372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.910039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81357821"/>
                  </a:ext>
                </a:extLst>
              </a:tr>
              <a:tr h="2030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.2963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02921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836730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9673556"/>
                  </a:ext>
                </a:extLst>
              </a:tr>
              <a:tr h="203056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.49814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40796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127270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06807634"/>
                  </a:ext>
                </a:extLst>
              </a:tr>
              <a:tr h="203056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87801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56006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59193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34720105"/>
                  </a:ext>
                </a:extLst>
              </a:tr>
              <a:tr h="1140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2.17003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41.147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8.59794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00054406"/>
                  </a:ext>
                </a:extLst>
              </a:tr>
            </a:tbl>
          </a:graphicData>
        </a:graphic>
      </p:graphicFrame>
      <p:graphicFrame>
        <p:nvGraphicFramePr>
          <p:cNvPr id="15" name="Diagramm 14">
            <a:extLst>
              <a:ext uri="{FF2B5EF4-FFF2-40B4-BE49-F238E27FC236}">
                <a16:creationId xmlns="" xmlns:a16="http://schemas.microsoft.com/office/drawing/2014/main" id="{150DFE81-D0B2-4521-90EE-6CEFFE4B8E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5261066"/>
              </p:ext>
            </p:extLst>
          </p:nvPr>
        </p:nvGraphicFramePr>
        <p:xfrm>
          <a:off x="3504034" y="1537523"/>
          <a:ext cx="3131820" cy="19878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Tabelle 8">
            <a:extLst>
              <a:ext uri="{FF2B5EF4-FFF2-40B4-BE49-F238E27FC236}">
                <a16:creationId xmlns="" xmlns:a16="http://schemas.microsoft.com/office/drawing/2014/main" id="{E6A7AC53-2993-9725-234A-67E7043F6E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3020369"/>
              </p:ext>
            </p:extLst>
          </p:nvPr>
        </p:nvGraphicFramePr>
        <p:xfrm>
          <a:off x="3671760" y="4201124"/>
          <a:ext cx="2833101" cy="751876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6147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122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4610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33835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graphicFrame>
        <p:nvGraphicFramePr>
          <p:cNvPr id="16" name="Diagramm 15">
            <a:extLst>
              <a:ext uri="{FF2B5EF4-FFF2-40B4-BE49-F238E27FC236}">
                <a16:creationId xmlns="" xmlns:a16="http://schemas.microsoft.com/office/drawing/2014/main" id="{00000000-0008-0000-0A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8213819"/>
              </p:ext>
            </p:extLst>
          </p:nvPr>
        </p:nvGraphicFramePr>
        <p:xfrm>
          <a:off x="449580" y="1567179"/>
          <a:ext cx="3032760" cy="1945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Diagramm 17">
            <a:extLst>
              <a:ext uri="{FF2B5EF4-FFF2-40B4-BE49-F238E27FC236}">
                <a16:creationId xmlns="" xmlns:a16="http://schemas.microsoft.com/office/drawing/2014/main" id="{00000000-0008-0000-0A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6438251"/>
              </p:ext>
            </p:extLst>
          </p:nvPr>
        </p:nvGraphicFramePr>
        <p:xfrm>
          <a:off x="449580" y="3505590"/>
          <a:ext cx="3044188" cy="19878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4326102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75708" y="205508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2874</a:t>
            </a:r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347344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4824930"/>
              </p:ext>
            </p:extLst>
          </p:nvPr>
        </p:nvGraphicFramePr>
        <p:xfrm>
          <a:off x="449580" y="515012"/>
          <a:ext cx="6164580" cy="853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132; piRNA-L-133; piRNA-L-261; piR-hsa-8566750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1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AGTTGTAA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C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CCACTGCACTCGGACCAGCC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96240" y="7837554"/>
            <a:ext cx="2636520" cy="16504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close to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  <a:endParaRPr lang="en-US" sz="900" dirty="0"/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032760" y="7837554"/>
            <a:ext cx="3581400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de-DE" sz="900" dirty="0"/>
              <a:t>- </a:t>
            </a: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 </a:t>
            </a:r>
            <a:endParaRPr lang="de-DE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0E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7670018"/>
              </p:ext>
            </p:extLst>
          </p:nvPr>
        </p:nvGraphicFramePr>
        <p:xfrm>
          <a:off x="375708" y="1368452"/>
          <a:ext cx="3102822" cy="1963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0E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9919527"/>
              </p:ext>
            </p:extLst>
          </p:nvPr>
        </p:nvGraphicFramePr>
        <p:xfrm>
          <a:off x="3552402" y="1291356"/>
          <a:ext cx="3061758" cy="2010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0E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3552380"/>
              </p:ext>
            </p:extLst>
          </p:nvPr>
        </p:nvGraphicFramePr>
        <p:xfrm>
          <a:off x="399308" y="3394978"/>
          <a:ext cx="3055621" cy="19106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B37516D1-F983-EC8A-C323-61CBA81D6B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5044954"/>
              </p:ext>
            </p:extLst>
          </p:nvPr>
        </p:nvGraphicFramePr>
        <p:xfrm>
          <a:off x="396240" y="5556790"/>
          <a:ext cx="6217920" cy="20807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29449927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230796350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295550281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162562823"/>
                    </a:ext>
                  </a:extLst>
                </a:gridCol>
              </a:tblGrid>
              <a:tr h="1217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Expression: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5595139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62.31187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91.807482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10.87376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873744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61.03993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1.63015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81.02977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872404667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27.8380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35.3836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48.6710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40583906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98.07869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60.73998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3.91410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116249985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53.81203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58461830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3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52.87072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82.288454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85.25505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42912754"/>
                  </a:ext>
                </a:extLst>
              </a:tr>
              <a:tr h="140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2.1362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9.56220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51.8900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48288187"/>
                  </a:ext>
                </a:extLst>
              </a:tr>
              <a:tr h="1426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normalized_IR0046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18.0671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87193683"/>
                  </a:ext>
                </a:extLst>
              </a:tr>
              <a:tr h="22622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75.76933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80.23532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91.93897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633240388"/>
                  </a:ext>
                </a:extLst>
              </a:tr>
              <a:tr h="22622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4.44736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2.52042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3.67358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80017186"/>
                  </a:ext>
                </a:extLst>
              </a:tr>
              <a:tr h="226224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5463456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531303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626014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332970880"/>
                  </a:ext>
                </a:extLst>
              </a:tr>
              <a:tr h="1217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186.620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057.577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133.9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89737666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A88E611C-6813-6DCC-9F48-623C1B98A4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4137837"/>
              </p:ext>
            </p:extLst>
          </p:nvPr>
        </p:nvGraphicFramePr>
        <p:xfrm>
          <a:off x="3666730" y="3974385"/>
          <a:ext cx="2833101" cy="751876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61471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26233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9062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6438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30151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2886</a:t>
            </a:r>
            <a:endParaRPr lang="en-US" b="1" u="sng" dirty="0"/>
          </a:p>
        </p:txBody>
      </p:sp>
      <p:grpSp>
        <p:nvGrpSpPr>
          <p:cNvPr id="16" name="Gruppieren 15">
            <a:extLst>
              <a:ext uri="{FF2B5EF4-FFF2-40B4-BE49-F238E27FC236}">
                <a16:creationId xmlns="" xmlns:a16="http://schemas.microsoft.com/office/drawing/2014/main" id="{7AB322AF-1C53-B8FB-B88E-6590EDF07141}"/>
              </a:ext>
            </a:extLst>
          </p:cNvPr>
          <p:cNvGrpSpPr/>
          <p:nvPr/>
        </p:nvGrpSpPr>
        <p:grpSpPr>
          <a:xfrm>
            <a:off x="396240" y="1526163"/>
            <a:ext cx="6217920" cy="4021198"/>
            <a:chOff x="396240" y="1526163"/>
            <a:chExt cx="6217920" cy="4021198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526163"/>
              <a:ext cx="6217920" cy="20105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536762"/>
              <a:ext cx="3108960" cy="20105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05200" y="3536762"/>
              <a:ext cx="3108960" cy="20105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3119189"/>
              </p:ext>
            </p:extLst>
          </p:nvPr>
        </p:nvGraphicFramePr>
        <p:xfrm>
          <a:off x="449580" y="784483"/>
          <a:ext cx="6164580" cy="685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244217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log2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fc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468; piR-hsa-8537029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9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CACCATGATGGAACTGAGGATCTGAGGAA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636938" y="8052010"/>
            <a:ext cx="2865120" cy="986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2A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6969207"/>
              </p:ext>
            </p:extLst>
          </p:nvPr>
        </p:nvGraphicFramePr>
        <p:xfrm>
          <a:off x="422911" y="1537805"/>
          <a:ext cx="3044632" cy="1943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2A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5391706"/>
              </p:ext>
            </p:extLst>
          </p:nvPr>
        </p:nvGraphicFramePr>
        <p:xfrm>
          <a:off x="422910" y="3592642"/>
          <a:ext cx="3014345" cy="201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Tabelle 13">
            <a:extLst>
              <a:ext uri="{FF2B5EF4-FFF2-40B4-BE49-F238E27FC236}">
                <a16:creationId xmlns="" xmlns:a16="http://schemas.microsoft.com/office/drawing/2014/main" id="{182C9AAF-04B0-E006-90AA-E9926368DFA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5041648"/>
              </p:ext>
            </p:extLst>
          </p:nvPr>
        </p:nvGraphicFramePr>
        <p:xfrm>
          <a:off x="396239" y="5726645"/>
          <a:ext cx="6217920" cy="200892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298540905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569129576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3672887259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465001849"/>
                    </a:ext>
                  </a:extLst>
                </a:gridCol>
              </a:tblGrid>
              <a:tr h="135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18955916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881788528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842707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534244774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14582254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2.094482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364232995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154912236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>
                          <a:effectLst/>
                        </a:rPr>
                        <a:t>normalized_IR003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622008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.6845576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572181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51163556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2559429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381497315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860996451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077751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312948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0953635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19409241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219913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407648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233592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90113219"/>
                  </a:ext>
                </a:extLst>
              </a:tr>
              <a:tr h="157691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2842712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7212763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4948974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957549602"/>
                  </a:ext>
                </a:extLst>
              </a:tr>
              <a:tr h="135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04836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981473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0545652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100531112"/>
                  </a:ext>
                </a:extLst>
              </a:tr>
            </a:tbl>
          </a:graphicData>
        </a:graphic>
      </p:graphicFrame>
      <p:sp>
        <p:nvSpPr>
          <p:cNvPr id="15" name="Textfeld 14">
            <a:extLst>
              <a:ext uri="{FF2B5EF4-FFF2-40B4-BE49-F238E27FC236}">
                <a16:creationId xmlns="" xmlns:a16="http://schemas.microsoft.com/office/drawing/2014/main" id="{9F128959-475F-DB87-A728-D6A500EBB909}"/>
              </a:ext>
            </a:extLst>
          </p:cNvPr>
          <p:cNvSpPr txBox="1"/>
          <p:nvPr/>
        </p:nvSpPr>
        <p:spPr>
          <a:xfrm>
            <a:off x="396239" y="8052010"/>
            <a:ext cx="2636520" cy="1463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r>
              <a:rPr lang="en-US" sz="900" b="1" dirty="0">
                <a:latin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  <a:endParaRPr lang="en-US" sz="900" dirty="0"/>
          </a:p>
        </p:txBody>
      </p:sp>
      <p:graphicFrame>
        <p:nvGraphicFramePr>
          <p:cNvPr id="17" name="Tabelle 16">
            <a:extLst>
              <a:ext uri="{FF2B5EF4-FFF2-40B4-BE49-F238E27FC236}">
                <a16:creationId xmlns="" xmlns:a16="http://schemas.microsoft.com/office/drawing/2014/main" id="{99CB393A-927E-FB70-BC5C-3C9AB3DDEA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2898334"/>
              </p:ext>
            </p:extLst>
          </p:nvPr>
        </p:nvGraphicFramePr>
        <p:xfrm>
          <a:off x="3636938" y="4257188"/>
          <a:ext cx="2833101" cy="588757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515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77803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4576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78322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  <p:cxnSp>
        <p:nvCxnSpPr>
          <p:cNvPr id="7" name="Gerader Verbinder 6">
            <a:extLst>
              <a:ext uri="{FF2B5EF4-FFF2-40B4-BE49-F238E27FC236}">
                <a16:creationId xmlns="" xmlns:a16="http://schemas.microsoft.com/office/drawing/2014/main" id="{43FD1C14-F5C6-1EA5-CB7C-D1427AA9D298}"/>
              </a:ext>
            </a:extLst>
          </p:cNvPr>
          <p:cNvCxnSpPr>
            <a:cxnSpLocks/>
            <a:endCxn id="3" idx="0"/>
          </p:cNvCxnSpPr>
          <p:nvPr/>
        </p:nvCxnSpPr>
        <p:spPr>
          <a:xfrm flipV="1">
            <a:off x="3505200" y="1526163"/>
            <a:ext cx="0" cy="20443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0" name="Diagramm 9">
            <a:extLst>
              <a:ext uri="{FF2B5EF4-FFF2-40B4-BE49-F238E27FC236}">
                <a16:creationId xmlns="" xmlns:a16="http://schemas.microsoft.com/office/drawing/2014/main" id="{00000000-0008-0000-2A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294687"/>
              </p:ext>
            </p:extLst>
          </p:nvPr>
        </p:nvGraphicFramePr>
        <p:xfrm>
          <a:off x="3542857" y="1593686"/>
          <a:ext cx="3033643" cy="18871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3682923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38" y="29804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2941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5509469"/>
              </p:ext>
            </p:extLst>
          </p:nvPr>
        </p:nvGraphicFramePr>
        <p:xfrm>
          <a:off x="449580" y="743860"/>
          <a:ext cx="6164580" cy="685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248980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log2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fc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34; piR-hsa-3559158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29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GCCTGGGAAT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ACGGGTGCTGTAGGCTTT 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96240" y="8186735"/>
            <a:ext cx="3108960" cy="145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levant </a:t>
            </a: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 algn="just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  <a:endParaRPr lang="en-US" sz="900" b="1" dirty="0">
              <a:latin typeface="Calibri" panose="020F0502020204030204" pitchFamily="34" charset="0"/>
              <a:cs typeface="Arial" panose="020B0604020202020204" pitchFamily="34" charset="0"/>
            </a:endParaRP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close to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  <a:endParaRPr lang="en-US" sz="900" dirty="0"/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749040" y="8186735"/>
            <a:ext cx="2865120" cy="735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  <a:endParaRPr lang="de-DE" sz="900" dirty="0"/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900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2C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9524428"/>
              </p:ext>
            </p:extLst>
          </p:nvPr>
        </p:nvGraphicFramePr>
        <p:xfrm>
          <a:off x="396238" y="1564278"/>
          <a:ext cx="3108961" cy="19724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2C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745111"/>
              </p:ext>
            </p:extLst>
          </p:nvPr>
        </p:nvGraphicFramePr>
        <p:xfrm>
          <a:off x="3505201" y="1535211"/>
          <a:ext cx="3091690" cy="19710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2C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5144038"/>
              </p:ext>
            </p:extLst>
          </p:nvPr>
        </p:nvGraphicFramePr>
        <p:xfrm>
          <a:off x="396240" y="3601691"/>
          <a:ext cx="3108960" cy="1915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409426D5-1083-E163-6684-052523709B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1781187"/>
              </p:ext>
            </p:extLst>
          </p:nvPr>
        </p:nvGraphicFramePr>
        <p:xfrm>
          <a:off x="396240" y="5740716"/>
          <a:ext cx="6217920" cy="20746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1864521467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479147584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144149135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4042128077"/>
                    </a:ext>
                  </a:extLst>
                </a:gridCol>
              </a:tblGrid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 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T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3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269786702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655914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017190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2078487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08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528123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157568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6903351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6910167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917722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27777898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2.463803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99572714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15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928943497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3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144363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37800379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586328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15791661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normalized_IR0046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 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 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36935714"/>
                  </a:ext>
                </a:extLst>
              </a:tr>
              <a:tr h="234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average normalized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16836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421353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1.214496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869716996"/>
                  </a:ext>
                </a:extLst>
              </a:tr>
              <a:tr h="234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standard 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0.311895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0321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6466107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619048399"/>
                  </a:ext>
                </a:extLst>
              </a:tr>
              <a:tr h="234348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524784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4948974</a:t>
                      </a:r>
                    </a:p>
                  </a:txBody>
                  <a:tcPr marL="0" marR="0" marT="0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241074</a:t>
                      </a: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65862567"/>
                  </a:ext>
                </a:extLst>
              </a:tr>
              <a:tr h="1246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</a:rPr>
                        <a:t>varianc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097278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1.065234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0.418105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4076498650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73600A95-53CF-9FE3-443D-B5D7F2CD16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8790181"/>
              </p:ext>
            </p:extLst>
          </p:nvPr>
        </p:nvGraphicFramePr>
        <p:xfrm>
          <a:off x="3628659" y="4257188"/>
          <a:ext cx="2833101" cy="588757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515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23428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50681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272535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679103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="" xmlns:a16="http://schemas.microsoft.com/office/drawing/2014/main" id="{554666B6-96CA-DC48-2C13-60FB708D29D4}"/>
              </a:ext>
            </a:extLst>
          </p:cNvPr>
          <p:cNvSpPr txBox="1"/>
          <p:nvPr/>
        </p:nvSpPr>
        <p:spPr>
          <a:xfrm>
            <a:off x="396240" y="356354"/>
            <a:ext cx="22936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/>
              <a:t>hsa-piR-32956</a:t>
            </a:r>
            <a:endParaRPr lang="en-US" b="1" u="sng" dirty="0"/>
          </a:p>
        </p:txBody>
      </p:sp>
      <p:grpSp>
        <p:nvGrpSpPr>
          <p:cNvPr id="7" name="Gruppieren 6">
            <a:extLst>
              <a:ext uri="{FF2B5EF4-FFF2-40B4-BE49-F238E27FC236}">
                <a16:creationId xmlns="" xmlns:a16="http://schemas.microsoft.com/office/drawing/2014/main" id="{14371B78-41BA-9CD0-7C61-79554206056C}"/>
              </a:ext>
            </a:extLst>
          </p:cNvPr>
          <p:cNvGrpSpPr/>
          <p:nvPr/>
        </p:nvGrpSpPr>
        <p:grpSpPr>
          <a:xfrm>
            <a:off x="396240" y="1526163"/>
            <a:ext cx="6217920" cy="4021197"/>
            <a:chOff x="396240" y="1112520"/>
            <a:chExt cx="6370320" cy="3962400"/>
          </a:xfrm>
        </p:grpSpPr>
        <p:sp>
          <p:nvSpPr>
            <p:cNvPr id="3" name="Rechteck 2">
              <a:extLst>
                <a:ext uri="{FF2B5EF4-FFF2-40B4-BE49-F238E27FC236}">
                  <a16:creationId xmlns="" xmlns:a16="http://schemas.microsoft.com/office/drawing/2014/main" id="{859C93DF-F5E1-C9DC-7602-09423B323A67}"/>
                </a:ext>
              </a:extLst>
            </p:cNvPr>
            <p:cNvSpPr/>
            <p:nvPr/>
          </p:nvSpPr>
          <p:spPr>
            <a:xfrm>
              <a:off x="39624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hteck 3">
              <a:extLst>
                <a:ext uri="{FF2B5EF4-FFF2-40B4-BE49-F238E27FC236}">
                  <a16:creationId xmlns="" xmlns:a16="http://schemas.microsoft.com/office/drawing/2014/main" id="{8F2AA0FD-F1A1-37EE-8738-263E63EF2052}"/>
                </a:ext>
              </a:extLst>
            </p:cNvPr>
            <p:cNvSpPr/>
            <p:nvPr/>
          </p:nvSpPr>
          <p:spPr>
            <a:xfrm>
              <a:off x="39624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hteck 4">
              <a:extLst>
                <a:ext uri="{FF2B5EF4-FFF2-40B4-BE49-F238E27FC236}">
                  <a16:creationId xmlns="" xmlns:a16="http://schemas.microsoft.com/office/drawing/2014/main" id="{90F82725-47B9-3635-9719-0AFB07785AD9}"/>
                </a:ext>
              </a:extLst>
            </p:cNvPr>
            <p:cNvSpPr/>
            <p:nvPr/>
          </p:nvSpPr>
          <p:spPr>
            <a:xfrm>
              <a:off x="3581400" y="30937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hteck 5">
              <a:extLst>
                <a:ext uri="{FF2B5EF4-FFF2-40B4-BE49-F238E27FC236}">
                  <a16:creationId xmlns="" xmlns:a16="http://schemas.microsoft.com/office/drawing/2014/main" id="{D336BAE5-F5D9-AEC6-3653-CFC91F32721B}"/>
                </a:ext>
              </a:extLst>
            </p:cNvPr>
            <p:cNvSpPr/>
            <p:nvPr/>
          </p:nvSpPr>
          <p:spPr>
            <a:xfrm>
              <a:off x="3581400" y="1112520"/>
              <a:ext cx="3185160" cy="19812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8" name="Tabelle 8">
            <a:extLst>
              <a:ext uri="{FF2B5EF4-FFF2-40B4-BE49-F238E27FC236}">
                <a16:creationId xmlns="" xmlns:a16="http://schemas.microsoft.com/office/drawing/2014/main" id="{99918761-931A-FFD1-C104-593B65901B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2806843"/>
              </p:ext>
            </p:extLst>
          </p:nvPr>
        </p:nvGraphicFramePr>
        <p:xfrm>
          <a:off x="452182" y="685800"/>
          <a:ext cx="6164580" cy="8534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82290">
                  <a:extLst>
                    <a:ext uri="{9D8B030D-6E8A-4147-A177-3AD203B41FA5}">
                      <a16:colId xmlns="" xmlns:a16="http://schemas.microsoft.com/office/drawing/2014/main" val="2423656147"/>
                    </a:ext>
                  </a:extLst>
                </a:gridCol>
                <a:gridCol w="3082290">
                  <a:extLst>
                    <a:ext uri="{9D8B030D-6E8A-4147-A177-3AD203B41FA5}">
                      <a16:colId xmlns="" xmlns:a16="http://schemas.microsoft.com/office/drawing/2014/main" val="2134097405"/>
                    </a:ext>
                  </a:extLst>
                </a:gridCol>
              </a:tblGrid>
              <a:tr h="282317"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filter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criterion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relative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standard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deviation</a:t>
                      </a:r>
                      <a:endParaRPr lang="de-DE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dirty="0" err="1">
                          <a:solidFill>
                            <a:sysClr val="windowText" lastClr="000000"/>
                          </a:solidFill>
                        </a:rPr>
                        <a:t>aliases</a:t>
                      </a:r>
                      <a:r>
                        <a:rPr lang="de-DE" sz="1100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piRNA-L-232; piRNA-L-409; piR-hsa-8495510 (</a:t>
                      </a:r>
                      <a:r>
                        <a:rPr lang="de-DE" sz="1100" b="0" dirty="0" err="1">
                          <a:solidFill>
                            <a:sysClr val="windowText" lastClr="000000"/>
                          </a:solidFill>
                        </a:rPr>
                        <a:t>piRBase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61978264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mber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of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 </a:t>
                      </a:r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nucleotides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de-DE" sz="1100" b="0" dirty="0">
                          <a:solidFill>
                            <a:sysClr val="windowText" lastClr="000000"/>
                          </a:solidFill>
                        </a:rPr>
                        <a:t>31</a:t>
                      </a:r>
                      <a:endParaRPr lang="en-US" sz="1100" b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100" b="1" dirty="0" err="1">
                          <a:solidFill>
                            <a:sysClr val="windowText" lastClr="000000"/>
                          </a:solidFill>
                        </a:rPr>
                        <a:t>sequence</a:t>
                      </a:r>
                      <a:r>
                        <a:rPr lang="de-DE" sz="1100" b="1" dirty="0">
                          <a:solidFill>
                            <a:sysClr val="windowText" lastClr="000000"/>
                          </a:solidFill>
                        </a:rPr>
                        <a:t>: </a:t>
                      </a:r>
                      <a:r>
                        <a:rPr lang="en-US" sz="1100" dirty="0"/>
                        <a:t>GGCTGGTCCG</a:t>
                      </a:r>
                      <a:r>
                        <a:rPr lang="en-US" sz="1100" b="1" dirty="0"/>
                        <a:t>A</a:t>
                      </a:r>
                      <a:r>
                        <a:rPr lang="en-US" sz="1100" dirty="0"/>
                        <a:t>GTGCAGTGGTGTTTACAACT</a:t>
                      </a:r>
                      <a:endParaRPr lang="en-US" sz="11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091334561"/>
                  </a:ext>
                </a:extLst>
              </a:tr>
            </a:tbl>
          </a:graphicData>
        </a:graphic>
      </p:graphicFrame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37DF6E52-57B7-9248-3141-9C20F2B09E65}"/>
              </a:ext>
            </a:extLst>
          </p:cNvPr>
          <p:cNvSpPr txBox="1"/>
          <p:nvPr/>
        </p:nvSpPr>
        <p:spPr>
          <a:xfrm>
            <a:off x="399049" y="8128292"/>
            <a:ext cx="3254009" cy="145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9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evant publications: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900" dirty="0"/>
              <a:t>Mei, Y., Wang, Y., Kumari, P., Shetty, A. C., Clark, D., Gable, T., ... &amp; Mao, L. (2015). </a:t>
            </a:r>
            <a:r>
              <a:rPr lang="en-US" sz="900" b="1" dirty="0"/>
              <a:t>A </a:t>
            </a:r>
            <a:r>
              <a:rPr lang="en-US" sz="900" b="1" dirty="0" err="1"/>
              <a:t>piRNA</a:t>
            </a:r>
            <a:r>
              <a:rPr lang="en-US" sz="900" b="1" dirty="0"/>
              <a:t>-like small RNA interacts with and modulates p-ERM proteins in human somatic cells</a:t>
            </a:r>
            <a:r>
              <a:rPr lang="en-US" sz="900" dirty="0"/>
              <a:t>. </a:t>
            </a:r>
            <a:r>
              <a:rPr lang="en-US" sz="900" i="1" dirty="0"/>
              <a:t>Nature communications</a:t>
            </a:r>
            <a:r>
              <a:rPr lang="en-US" sz="900" dirty="0"/>
              <a:t>, </a:t>
            </a:r>
            <a:r>
              <a:rPr lang="en-US" sz="900" i="1" dirty="0"/>
              <a:t>6</a:t>
            </a:r>
            <a:r>
              <a:rPr lang="en-US" sz="900" dirty="0"/>
              <a:t>(1), 1-12.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9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iRNA</a:t>
            </a:r>
            <a:r>
              <a:rPr lang="en-US" sz="9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pecific characteristics: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length in between 24-35 nucleotides</a:t>
            </a:r>
          </a:p>
          <a:p>
            <a:pPr marL="171450" indent="-171450">
              <a:buFontTx/>
              <a:buChar char="-"/>
            </a:pP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adenine close to 10</a:t>
            </a:r>
            <a:r>
              <a:rPr lang="en-US" sz="900" baseline="30000" dirty="0">
                <a:latin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900" dirty="0">
                <a:latin typeface="Calibri" panose="020F0502020204030204" pitchFamily="34" charset="0"/>
                <a:cs typeface="Arial" panose="020B0604020202020204" pitchFamily="34" charset="0"/>
              </a:rPr>
              <a:t> nucleotide position</a:t>
            </a:r>
            <a:endParaRPr lang="en-US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="" xmlns:a16="http://schemas.microsoft.com/office/drawing/2014/main" id="{E55F4BA3-A522-A7E9-01B1-A36C675A01A1}"/>
              </a:ext>
            </a:extLst>
          </p:cNvPr>
          <p:cNvSpPr txBox="1"/>
          <p:nvPr/>
        </p:nvSpPr>
        <p:spPr>
          <a:xfrm>
            <a:off x="3695700" y="8128292"/>
            <a:ext cx="2865120" cy="7355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 b="1" dirty="0" err="1"/>
              <a:t>expression</a:t>
            </a:r>
            <a:r>
              <a:rPr lang="de-DE" sz="900" b="1" dirty="0"/>
              <a:t> </a:t>
            </a:r>
            <a:r>
              <a:rPr lang="de-DE" sz="900" b="1" dirty="0" err="1"/>
              <a:t>data</a:t>
            </a:r>
            <a:r>
              <a:rPr lang="de-DE" sz="900" b="1" dirty="0"/>
              <a:t>:</a:t>
            </a:r>
          </a:p>
          <a:p>
            <a:pPr marL="171450" indent="-171450">
              <a:lnSpc>
                <a:spcPct val="107000"/>
              </a:lnSpc>
              <a:spcAft>
                <a:spcPts val="800"/>
              </a:spcAft>
              <a:buFontTx/>
              <a:buChar char="-"/>
            </a:pPr>
            <a:r>
              <a:rPr lang="de-DE" sz="900" dirty="0" err="1"/>
              <a:t>found</a:t>
            </a:r>
            <a:r>
              <a:rPr lang="de-DE" sz="900" dirty="0"/>
              <a:t> in </a:t>
            </a:r>
            <a:r>
              <a:rPr lang="de-DE" sz="900" dirty="0" err="1"/>
              <a:t>lung</a:t>
            </a:r>
            <a:r>
              <a:rPr lang="de-DE" sz="900" dirty="0"/>
              <a:t> </a:t>
            </a:r>
            <a:r>
              <a:rPr lang="en-US" sz="900" dirty="0"/>
              <a:t>bronchial epithelial cells</a:t>
            </a: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de-DE" sz="900" b="1" dirty="0"/>
          </a:p>
        </p:txBody>
      </p:sp>
      <p:graphicFrame>
        <p:nvGraphicFramePr>
          <p:cNvPr id="12" name="Diagramm 11">
            <a:extLst>
              <a:ext uri="{FF2B5EF4-FFF2-40B4-BE49-F238E27FC236}">
                <a16:creationId xmlns="" xmlns:a16="http://schemas.microsoft.com/office/drawing/2014/main" id="{00000000-0008-0000-11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439221"/>
              </p:ext>
            </p:extLst>
          </p:nvPr>
        </p:nvGraphicFramePr>
        <p:xfrm>
          <a:off x="3546158" y="1539240"/>
          <a:ext cx="3014662" cy="19648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Diagramm 12">
            <a:extLst>
              <a:ext uri="{FF2B5EF4-FFF2-40B4-BE49-F238E27FC236}">
                <a16:creationId xmlns="" xmlns:a16="http://schemas.microsoft.com/office/drawing/2014/main" id="{00000000-0008-0000-1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4796091"/>
              </p:ext>
            </p:extLst>
          </p:nvPr>
        </p:nvGraphicFramePr>
        <p:xfrm>
          <a:off x="425512" y="1526163"/>
          <a:ext cx="3067305" cy="19779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Diagramm 13">
            <a:extLst>
              <a:ext uri="{FF2B5EF4-FFF2-40B4-BE49-F238E27FC236}">
                <a16:creationId xmlns="" xmlns:a16="http://schemas.microsoft.com/office/drawing/2014/main" id="{00000000-0008-0000-11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3981825"/>
              </p:ext>
            </p:extLst>
          </p:nvPr>
        </p:nvGraphicFramePr>
        <p:xfrm>
          <a:off x="449580" y="3628200"/>
          <a:ext cx="3014879" cy="1846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Tabelle 14">
            <a:extLst>
              <a:ext uri="{FF2B5EF4-FFF2-40B4-BE49-F238E27FC236}">
                <a16:creationId xmlns="" xmlns:a16="http://schemas.microsoft.com/office/drawing/2014/main" id="{0C62063D-63AC-DAE5-A29D-FB93D2028F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9967597"/>
              </p:ext>
            </p:extLst>
          </p:nvPr>
        </p:nvGraphicFramePr>
        <p:xfrm>
          <a:off x="396240" y="5821681"/>
          <a:ext cx="6217920" cy="2044754"/>
        </p:xfrm>
        <a:graphic>
          <a:graphicData uri="http://schemas.openxmlformats.org/drawingml/2006/table">
            <a:tbl>
              <a:tblPr/>
              <a:tblGrid>
                <a:gridCol w="1554480">
                  <a:extLst>
                    <a:ext uri="{9D8B030D-6E8A-4147-A177-3AD203B41FA5}">
                      <a16:colId xmlns="" xmlns:a16="http://schemas.microsoft.com/office/drawing/2014/main" val="36488044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071109446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1393632253"/>
                    </a:ext>
                  </a:extLst>
                </a:gridCol>
                <a:gridCol w="1554480">
                  <a:extLst>
                    <a:ext uri="{9D8B030D-6E8A-4147-A177-3AD203B41FA5}">
                      <a16:colId xmlns="" xmlns:a16="http://schemas.microsoft.com/office/drawing/2014/main" val="2947114053"/>
                    </a:ext>
                  </a:extLst>
                </a:gridCol>
              </a:tblGrid>
              <a:tr h="1337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0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  <a:r>
                        <a:rPr lang="en-US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c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252049386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720474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68092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27209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221951740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0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44342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00099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24193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52394513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8.4896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7.5943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.4558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134481798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871902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.45653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.218403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95504818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.084847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76728445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30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956835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.09385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09487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779516548"/>
                  </a:ext>
                </a:extLst>
              </a:tr>
              <a:tr h="13971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868124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3843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544759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103377380"/>
                  </a:ext>
                </a:extLst>
              </a:tr>
              <a:tr h="1416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ized_IR0046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53911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380224646"/>
                  </a:ext>
                </a:extLst>
              </a:tr>
              <a:tr h="209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normalized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.12179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.22751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80464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755160986"/>
                  </a:ext>
                </a:extLst>
              </a:tr>
              <a:tr h="2095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 deviation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05699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28940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26824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9988082"/>
                  </a:ext>
                </a:extLst>
              </a:tr>
              <a:tr h="231583">
                <a:tc>
                  <a:txBody>
                    <a:bodyPr/>
                    <a:lstStyle/>
                    <a:p>
                      <a:pPr algn="l" fontAlgn="ctr"/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tive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ndard</a:t>
                      </a:r>
                      <a:r>
                        <a:rPr lang="de-DE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de-DE" sz="9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iation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40757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6006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42127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440550729"/>
                  </a:ext>
                </a:extLst>
              </a:tr>
              <a:tr h="13375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nce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8.96691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9.97542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.72885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78892474"/>
                  </a:ext>
                </a:extLst>
              </a:tr>
            </a:tbl>
          </a:graphicData>
        </a:graphic>
      </p:graphicFrame>
      <p:graphicFrame>
        <p:nvGraphicFramePr>
          <p:cNvPr id="16" name="Tabelle 15">
            <a:extLst>
              <a:ext uri="{FF2B5EF4-FFF2-40B4-BE49-F238E27FC236}">
                <a16:creationId xmlns="" xmlns:a16="http://schemas.microsoft.com/office/drawing/2014/main" id="{E3EF9B02-CE7E-9927-5E77-1D9366BC02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0140740"/>
              </p:ext>
            </p:extLst>
          </p:nvPr>
        </p:nvGraphicFramePr>
        <p:xfrm>
          <a:off x="3628659" y="4257188"/>
          <a:ext cx="2833101" cy="588757"/>
        </p:xfrm>
        <a:graphic>
          <a:graphicData uri="http://schemas.openxmlformats.org/drawingml/2006/table">
            <a:tbl>
              <a:tblPr/>
              <a:tblGrid>
                <a:gridCol w="944367">
                  <a:extLst>
                    <a:ext uri="{9D8B030D-6E8A-4147-A177-3AD203B41FA5}">
                      <a16:colId xmlns="" xmlns:a16="http://schemas.microsoft.com/office/drawing/2014/main" val="418061196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3056255001"/>
                    </a:ext>
                  </a:extLst>
                </a:gridCol>
                <a:gridCol w="944367">
                  <a:extLst>
                    <a:ext uri="{9D8B030D-6E8A-4147-A177-3AD203B41FA5}">
                      <a16:colId xmlns="" xmlns:a16="http://schemas.microsoft.com/office/drawing/2014/main" val="2590981155"/>
                    </a:ext>
                  </a:extLst>
                </a:gridCol>
              </a:tblGrid>
              <a:tr h="4515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rect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T0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fold change</a:t>
                      </a:r>
                    </a:p>
                    <a:p>
                      <a:pPr algn="l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h/direct)</a:t>
                      </a:r>
                    </a:p>
                  </a:txBody>
                  <a:tcPr marL="0" marR="0" marT="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36757767"/>
                  </a:ext>
                </a:extLst>
              </a:tr>
              <a:tr h="10778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227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8002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2774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27143169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00841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95</Words>
  <Application>Microsoft Office PowerPoint</Application>
  <PresentationFormat>A4-Papier (210x297 mm)</PresentationFormat>
  <Paragraphs>1053</Paragraphs>
  <Slides>1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4" baseType="lpstr"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aro Evri</dc:creator>
  <cp:lastModifiedBy>Sportmedizin</cp:lastModifiedBy>
  <cp:revision>37</cp:revision>
  <dcterms:created xsi:type="dcterms:W3CDTF">2022-11-13T10:47:57Z</dcterms:created>
  <dcterms:modified xsi:type="dcterms:W3CDTF">2025-04-19T17:41:52Z</dcterms:modified>
</cp:coreProperties>
</file>